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1" r:id="rId2"/>
    <p:sldId id="262" r:id="rId3"/>
  </p:sldIdLst>
  <p:sldSz cx="6858000" cy="9144000" type="letter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irokazu" initials="H" lastIdx="2" clrIdx="0">
    <p:extLst>
      <p:ext uri="{19B8F6BF-5375-455C-9EA6-DF929625EA0E}">
        <p15:presenceInfo xmlns:p15="http://schemas.microsoft.com/office/powerpoint/2012/main" userId="e75c3cefb454ad37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689" autoAdjust="0"/>
    <p:restoredTop sz="94182" autoAdjust="0"/>
  </p:normalViewPr>
  <p:slideViewPr>
    <p:cSldViewPr snapToGrid="0">
      <p:cViewPr>
        <p:scale>
          <a:sx n="81" d="100"/>
          <a:sy n="81" d="100"/>
        </p:scale>
        <p:origin x="2093" y="-5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08A76B-F87D-45BB-9994-D10DE2997AF8}" type="datetimeFigureOut">
              <a:rPr kumimoji="1" lang="ja-JP" altLang="en-US" smtClean="0"/>
              <a:t>2024/12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6300" y="1243013"/>
            <a:ext cx="251460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450C2A-1C84-472A-884D-6EF1A43AE3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39987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E450C2A-1C84-472A-884D-6EF1A43AE3A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162151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E450C2A-1C84-472A-884D-6EF1A43AE3A4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16215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B63F5-0B69-4530-A726-12DA6C92AF91}" type="datetimeFigureOut">
              <a:rPr kumimoji="1" lang="ja-JP" altLang="en-US" smtClean="0"/>
              <a:t>2024/1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839C1-AB0D-4746-8943-16F5FC0768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82151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B63F5-0B69-4530-A726-12DA6C92AF91}" type="datetimeFigureOut">
              <a:rPr kumimoji="1" lang="ja-JP" altLang="en-US" smtClean="0"/>
              <a:t>2024/1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839C1-AB0D-4746-8943-16F5FC0768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24673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B63F5-0B69-4530-A726-12DA6C92AF91}" type="datetimeFigureOut">
              <a:rPr kumimoji="1" lang="ja-JP" altLang="en-US" smtClean="0"/>
              <a:t>2024/1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839C1-AB0D-4746-8943-16F5FC0768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69727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B63F5-0B69-4530-A726-12DA6C92AF91}" type="datetimeFigureOut">
              <a:rPr kumimoji="1" lang="ja-JP" altLang="en-US" smtClean="0"/>
              <a:t>2024/1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839C1-AB0D-4746-8943-16F5FC0768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17454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B63F5-0B69-4530-A726-12DA6C92AF91}" type="datetimeFigureOut">
              <a:rPr kumimoji="1" lang="ja-JP" altLang="en-US" smtClean="0"/>
              <a:t>2024/1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839C1-AB0D-4746-8943-16F5FC0768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23568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B63F5-0B69-4530-A726-12DA6C92AF91}" type="datetimeFigureOut">
              <a:rPr kumimoji="1" lang="ja-JP" altLang="en-US" smtClean="0"/>
              <a:t>2024/1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839C1-AB0D-4746-8943-16F5FC0768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289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B63F5-0B69-4530-A726-12DA6C92AF91}" type="datetimeFigureOut">
              <a:rPr kumimoji="1" lang="ja-JP" altLang="en-US" smtClean="0"/>
              <a:t>2024/12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839C1-AB0D-4746-8943-16F5FC0768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6914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B63F5-0B69-4530-A726-12DA6C92AF91}" type="datetimeFigureOut">
              <a:rPr kumimoji="1" lang="ja-JP" altLang="en-US" smtClean="0"/>
              <a:t>2024/12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839C1-AB0D-4746-8943-16F5FC0768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37387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B63F5-0B69-4530-A726-12DA6C92AF91}" type="datetimeFigureOut">
              <a:rPr kumimoji="1" lang="ja-JP" altLang="en-US" smtClean="0"/>
              <a:t>2024/12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839C1-AB0D-4746-8943-16F5FC0768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0148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B63F5-0B69-4530-A726-12DA6C92AF91}" type="datetimeFigureOut">
              <a:rPr kumimoji="1" lang="ja-JP" altLang="en-US" smtClean="0"/>
              <a:t>2024/1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839C1-AB0D-4746-8943-16F5FC0768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6594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B63F5-0B69-4530-A726-12DA6C92AF91}" type="datetimeFigureOut">
              <a:rPr kumimoji="1" lang="ja-JP" altLang="en-US" smtClean="0"/>
              <a:t>2024/1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839C1-AB0D-4746-8943-16F5FC0768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41295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9B63F5-0B69-4530-A726-12DA6C92AF91}" type="datetimeFigureOut">
              <a:rPr kumimoji="1" lang="ja-JP" altLang="en-US" smtClean="0"/>
              <a:t>2024/1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2839C1-AB0D-4746-8943-16F5FC0768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3946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Line 123">
            <a:extLst>
              <a:ext uri="{FF2B5EF4-FFF2-40B4-BE49-F238E27FC236}">
                <a16:creationId xmlns:a16="http://schemas.microsoft.com/office/drawing/2014/main" id="{9C87F8D2-C5BB-22D8-A6BD-8A19E5DC38E1}"/>
              </a:ext>
            </a:extLst>
          </p:cNvPr>
          <p:cNvSpPr>
            <a:spLocks noChangeShapeType="1"/>
          </p:cNvSpPr>
          <p:nvPr/>
        </p:nvSpPr>
        <p:spPr bwMode="auto">
          <a:xfrm>
            <a:off x="5993976" y="4719266"/>
            <a:ext cx="39687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dirty="0"/>
          </a:p>
        </p:txBody>
      </p:sp>
      <p:sp>
        <p:nvSpPr>
          <p:cNvPr id="21" name="Line 118">
            <a:extLst>
              <a:ext uri="{FF2B5EF4-FFF2-40B4-BE49-F238E27FC236}">
                <a16:creationId xmlns:a16="http://schemas.microsoft.com/office/drawing/2014/main" id="{98BD5743-4E6D-B064-EE68-3D778FBED5D5}"/>
              </a:ext>
            </a:extLst>
          </p:cNvPr>
          <p:cNvSpPr>
            <a:spLocks noChangeShapeType="1"/>
          </p:cNvSpPr>
          <p:nvPr/>
        </p:nvSpPr>
        <p:spPr bwMode="auto">
          <a:xfrm>
            <a:off x="4174701" y="4790704"/>
            <a:ext cx="1839912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" name="Line 123">
            <a:extLst>
              <a:ext uri="{FF2B5EF4-FFF2-40B4-BE49-F238E27FC236}">
                <a16:creationId xmlns:a16="http://schemas.microsoft.com/office/drawing/2014/main" id="{C063DDD2-1888-49A4-3596-EC2FCDE31023}"/>
              </a:ext>
            </a:extLst>
          </p:cNvPr>
          <p:cNvSpPr>
            <a:spLocks noChangeShapeType="1"/>
          </p:cNvSpPr>
          <p:nvPr/>
        </p:nvSpPr>
        <p:spPr bwMode="auto">
          <a:xfrm>
            <a:off x="5993976" y="4790704"/>
            <a:ext cx="39687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dirty="0"/>
          </a:p>
        </p:txBody>
      </p:sp>
      <p:sp>
        <p:nvSpPr>
          <p:cNvPr id="1249" name="Line 122">
            <a:extLst>
              <a:ext uri="{FF2B5EF4-FFF2-40B4-BE49-F238E27FC236}">
                <a16:creationId xmlns:a16="http://schemas.microsoft.com/office/drawing/2014/main" id="{DC5EFA1F-21A2-8DD4-F464-98C1660396D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584690" y="4374363"/>
            <a:ext cx="0" cy="34925"/>
          </a:xfrm>
          <a:prstGeom prst="line">
            <a:avLst/>
          </a:prstGeom>
          <a:noFill/>
          <a:ln w="635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2" name="Freeform 118">
            <a:extLst>
              <a:ext uri="{FF2B5EF4-FFF2-40B4-BE49-F238E27FC236}">
                <a16:creationId xmlns:a16="http://schemas.microsoft.com/office/drawing/2014/main" id="{0FB87BA6-8D46-CD5D-ACF5-55D58F9B49B3}"/>
              </a:ext>
            </a:extLst>
          </p:cNvPr>
          <p:cNvSpPr>
            <a:spLocks/>
          </p:cNvSpPr>
          <p:nvPr/>
        </p:nvSpPr>
        <p:spPr bwMode="auto">
          <a:xfrm>
            <a:off x="745973" y="4390238"/>
            <a:ext cx="1839913" cy="401638"/>
          </a:xfrm>
          <a:custGeom>
            <a:avLst/>
            <a:gdLst>
              <a:gd name="T0" fmla="*/ 0 w 477"/>
              <a:gd name="T1" fmla="*/ 125 h 125"/>
              <a:gd name="T2" fmla="*/ 75 w 477"/>
              <a:gd name="T3" fmla="*/ 125 h 125"/>
              <a:gd name="T4" fmla="*/ 75 w 477"/>
              <a:gd name="T5" fmla="*/ 83 h 125"/>
              <a:gd name="T6" fmla="*/ 127 w 477"/>
              <a:gd name="T7" fmla="*/ 83 h 125"/>
              <a:gd name="T8" fmla="*/ 127 w 477"/>
              <a:gd name="T9" fmla="*/ 42 h 125"/>
              <a:gd name="T10" fmla="*/ 185 w 477"/>
              <a:gd name="T11" fmla="*/ 42 h 125"/>
              <a:gd name="T12" fmla="*/ 185 w 477"/>
              <a:gd name="T13" fmla="*/ 0 h 125"/>
              <a:gd name="T14" fmla="*/ 477 w 477"/>
              <a:gd name="T15" fmla="*/ 0 h 1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477" h="125">
                <a:moveTo>
                  <a:pt x="0" y="125"/>
                </a:moveTo>
                <a:lnTo>
                  <a:pt x="75" y="125"/>
                </a:lnTo>
                <a:lnTo>
                  <a:pt x="75" y="83"/>
                </a:lnTo>
                <a:lnTo>
                  <a:pt x="127" y="83"/>
                </a:lnTo>
                <a:lnTo>
                  <a:pt x="127" y="42"/>
                </a:lnTo>
                <a:lnTo>
                  <a:pt x="185" y="42"/>
                </a:lnTo>
                <a:lnTo>
                  <a:pt x="185" y="0"/>
                </a:lnTo>
                <a:lnTo>
                  <a:pt x="477" y="0"/>
                </a:lnTo>
              </a:path>
            </a:pathLst>
          </a:cu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6" name="Line 121">
            <a:extLst>
              <a:ext uri="{FF2B5EF4-FFF2-40B4-BE49-F238E27FC236}">
                <a16:creationId xmlns:a16="http://schemas.microsoft.com/office/drawing/2014/main" id="{CEA2F7A3-F94A-BF24-3597-54A0AE14A737}"/>
              </a:ext>
            </a:extLst>
          </p:cNvPr>
          <p:cNvSpPr>
            <a:spLocks noChangeShapeType="1"/>
          </p:cNvSpPr>
          <p:nvPr/>
        </p:nvSpPr>
        <p:spPr bwMode="auto">
          <a:xfrm>
            <a:off x="2565248" y="4390238"/>
            <a:ext cx="39688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8" name="Line 125">
            <a:extLst>
              <a:ext uri="{FF2B5EF4-FFF2-40B4-BE49-F238E27FC236}">
                <a16:creationId xmlns:a16="http://schemas.microsoft.com/office/drawing/2014/main" id="{CE4AD68E-1E04-2264-D5AD-12DF36E6E02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584690" y="4214025"/>
            <a:ext cx="0" cy="31750"/>
          </a:xfrm>
          <a:prstGeom prst="line">
            <a:avLst/>
          </a:prstGeom>
          <a:noFill/>
          <a:ln w="635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0" name="Freeform 38">
            <a:extLst>
              <a:ext uri="{FF2B5EF4-FFF2-40B4-BE49-F238E27FC236}">
                <a16:creationId xmlns:a16="http://schemas.microsoft.com/office/drawing/2014/main" id="{2D47631E-3988-95F8-B77E-2F43C3F14C3C}"/>
              </a:ext>
            </a:extLst>
          </p:cNvPr>
          <p:cNvSpPr>
            <a:spLocks/>
          </p:cNvSpPr>
          <p:nvPr/>
        </p:nvSpPr>
        <p:spPr bwMode="auto">
          <a:xfrm>
            <a:off x="4174197" y="575415"/>
            <a:ext cx="1839913" cy="400050"/>
          </a:xfrm>
          <a:custGeom>
            <a:avLst/>
            <a:gdLst>
              <a:gd name="T0" fmla="*/ 0 w 477"/>
              <a:gd name="T1" fmla="*/ 0 h 124"/>
              <a:gd name="T2" fmla="*/ 75 w 477"/>
              <a:gd name="T3" fmla="*/ 0 h 124"/>
              <a:gd name="T4" fmla="*/ 75 w 477"/>
              <a:gd name="T5" fmla="*/ 41 h 124"/>
              <a:gd name="T6" fmla="*/ 127 w 477"/>
              <a:gd name="T7" fmla="*/ 41 h 124"/>
              <a:gd name="T8" fmla="*/ 127 w 477"/>
              <a:gd name="T9" fmla="*/ 83 h 124"/>
              <a:gd name="T10" fmla="*/ 185 w 477"/>
              <a:gd name="T11" fmla="*/ 83 h 124"/>
              <a:gd name="T12" fmla="*/ 185 w 477"/>
              <a:gd name="T13" fmla="*/ 124 h 124"/>
              <a:gd name="T14" fmla="*/ 477 w 477"/>
              <a:gd name="T15" fmla="*/ 124 h 1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477" h="124">
                <a:moveTo>
                  <a:pt x="0" y="0"/>
                </a:moveTo>
                <a:lnTo>
                  <a:pt x="75" y="0"/>
                </a:lnTo>
                <a:lnTo>
                  <a:pt x="75" y="41"/>
                </a:lnTo>
                <a:lnTo>
                  <a:pt x="127" y="41"/>
                </a:lnTo>
                <a:lnTo>
                  <a:pt x="127" y="83"/>
                </a:lnTo>
                <a:lnTo>
                  <a:pt x="185" y="83"/>
                </a:lnTo>
                <a:lnTo>
                  <a:pt x="185" y="124"/>
                </a:lnTo>
                <a:lnTo>
                  <a:pt x="477" y="124"/>
                </a:lnTo>
              </a:path>
            </a:pathLst>
          </a:cu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7" name="Line 42">
            <a:extLst>
              <a:ext uri="{FF2B5EF4-FFF2-40B4-BE49-F238E27FC236}">
                <a16:creationId xmlns:a16="http://schemas.microsoft.com/office/drawing/2014/main" id="{990B2A61-E696-9987-8EA6-B8E5E9ABD24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014110" y="958003"/>
            <a:ext cx="0" cy="33338"/>
          </a:xfrm>
          <a:prstGeom prst="line">
            <a:avLst/>
          </a:prstGeom>
          <a:noFill/>
          <a:ln w="635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1" name="Line 45">
            <a:extLst>
              <a:ext uri="{FF2B5EF4-FFF2-40B4-BE49-F238E27FC236}">
                <a16:creationId xmlns:a16="http://schemas.microsoft.com/office/drawing/2014/main" id="{33FAB25C-2059-9D6D-C4CF-59DE02A1E6D0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014110" y="1187911"/>
            <a:ext cx="0" cy="34925"/>
          </a:xfrm>
          <a:prstGeom prst="line">
            <a:avLst/>
          </a:prstGeom>
          <a:noFill/>
          <a:ln w="635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1" name="Freeform 44">
            <a:extLst>
              <a:ext uri="{FF2B5EF4-FFF2-40B4-BE49-F238E27FC236}">
                <a16:creationId xmlns:a16="http://schemas.microsoft.com/office/drawing/2014/main" id="{1489AAA2-BD19-6C72-C041-72BC713DAF20}"/>
              </a:ext>
            </a:extLst>
          </p:cNvPr>
          <p:cNvSpPr>
            <a:spLocks/>
          </p:cNvSpPr>
          <p:nvPr/>
        </p:nvSpPr>
        <p:spPr bwMode="auto">
          <a:xfrm>
            <a:off x="738752" y="576296"/>
            <a:ext cx="1839913" cy="563562"/>
          </a:xfrm>
          <a:custGeom>
            <a:avLst/>
            <a:gdLst>
              <a:gd name="T0" fmla="*/ 0 w 477"/>
              <a:gd name="T1" fmla="*/ 0 h 175"/>
              <a:gd name="T2" fmla="*/ 4 w 477"/>
              <a:gd name="T3" fmla="*/ 0 h 175"/>
              <a:gd name="T4" fmla="*/ 4 w 477"/>
              <a:gd name="T5" fmla="*/ 22 h 175"/>
              <a:gd name="T6" fmla="*/ 10 w 477"/>
              <a:gd name="T7" fmla="*/ 22 h 175"/>
              <a:gd name="T8" fmla="*/ 10 w 477"/>
              <a:gd name="T9" fmla="*/ 44 h 175"/>
              <a:gd name="T10" fmla="*/ 21 w 477"/>
              <a:gd name="T11" fmla="*/ 44 h 175"/>
              <a:gd name="T12" fmla="*/ 21 w 477"/>
              <a:gd name="T13" fmla="*/ 65 h 175"/>
              <a:gd name="T14" fmla="*/ 43 w 477"/>
              <a:gd name="T15" fmla="*/ 65 h 175"/>
              <a:gd name="T16" fmla="*/ 43 w 477"/>
              <a:gd name="T17" fmla="*/ 87 h 175"/>
              <a:gd name="T18" fmla="*/ 126 w 477"/>
              <a:gd name="T19" fmla="*/ 87 h 175"/>
              <a:gd name="T20" fmla="*/ 126 w 477"/>
              <a:gd name="T21" fmla="*/ 109 h 175"/>
              <a:gd name="T22" fmla="*/ 128 w 477"/>
              <a:gd name="T23" fmla="*/ 109 h 175"/>
              <a:gd name="T24" fmla="*/ 128 w 477"/>
              <a:gd name="T25" fmla="*/ 131 h 175"/>
              <a:gd name="T26" fmla="*/ 145 w 477"/>
              <a:gd name="T27" fmla="*/ 131 h 175"/>
              <a:gd name="T28" fmla="*/ 145 w 477"/>
              <a:gd name="T29" fmla="*/ 153 h 175"/>
              <a:gd name="T30" fmla="*/ 152 w 477"/>
              <a:gd name="T31" fmla="*/ 153 h 175"/>
              <a:gd name="T32" fmla="*/ 152 w 477"/>
              <a:gd name="T33" fmla="*/ 175 h 175"/>
              <a:gd name="T34" fmla="*/ 477 w 477"/>
              <a:gd name="T35" fmla="*/ 175 h 1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477" h="175">
                <a:moveTo>
                  <a:pt x="0" y="0"/>
                </a:moveTo>
                <a:lnTo>
                  <a:pt x="4" y="0"/>
                </a:lnTo>
                <a:lnTo>
                  <a:pt x="4" y="22"/>
                </a:lnTo>
                <a:lnTo>
                  <a:pt x="10" y="22"/>
                </a:lnTo>
                <a:lnTo>
                  <a:pt x="10" y="44"/>
                </a:lnTo>
                <a:lnTo>
                  <a:pt x="21" y="44"/>
                </a:lnTo>
                <a:lnTo>
                  <a:pt x="21" y="65"/>
                </a:lnTo>
                <a:lnTo>
                  <a:pt x="43" y="65"/>
                </a:lnTo>
                <a:lnTo>
                  <a:pt x="43" y="87"/>
                </a:lnTo>
                <a:lnTo>
                  <a:pt x="126" y="87"/>
                </a:lnTo>
                <a:lnTo>
                  <a:pt x="126" y="109"/>
                </a:lnTo>
                <a:lnTo>
                  <a:pt x="128" y="109"/>
                </a:lnTo>
                <a:lnTo>
                  <a:pt x="128" y="131"/>
                </a:lnTo>
                <a:lnTo>
                  <a:pt x="145" y="131"/>
                </a:lnTo>
                <a:lnTo>
                  <a:pt x="145" y="153"/>
                </a:lnTo>
                <a:lnTo>
                  <a:pt x="152" y="153"/>
                </a:lnTo>
                <a:lnTo>
                  <a:pt x="152" y="175"/>
                </a:lnTo>
                <a:lnTo>
                  <a:pt x="477" y="175"/>
                </a:lnTo>
              </a:path>
            </a:pathLst>
          </a:custGeom>
          <a:noFill/>
          <a:ln w="12700" cap="rnd">
            <a:solidFill>
              <a:schemeClr val="tx1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6" name="Line 47">
            <a:extLst>
              <a:ext uri="{FF2B5EF4-FFF2-40B4-BE49-F238E27FC236}">
                <a16:creationId xmlns:a16="http://schemas.microsoft.com/office/drawing/2014/main" id="{80CD48AE-3233-6AC8-8448-014FCE78E74C}"/>
              </a:ext>
            </a:extLst>
          </p:cNvPr>
          <p:cNvSpPr>
            <a:spLocks noChangeShapeType="1"/>
          </p:cNvSpPr>
          <p:nvPr/>
        </p:nvSpPr>
        <p:spPr bwMode="auto">
          <a:xfrm>
            <a:off x="2558027" y="1139858"/>
            <a:ext cx="39688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52" name="Line 42">
            <a:extLst>
              <a:ext uri="{FF2B5EF4-FFF2-40B4-BE49-F238E27FC236}">
                <a16:creationId xmlns:a16="http://schemas.microsoft.com/office/drawing/2014/main" id="{D0F7A0F2-B90C-034F-B3C2-71532CACA46D}"/>
              </a:ext>
            </a:extLst>
          </p:cNvPr>
          <p:cNvSpPr>
            <a:spLocks noChangeShapeType="1"/>
          </p:cNvSpPr>
          <p:nvPr/>
        </p:nvSpPr>
        <p:spPr bwMode="auto">
          <a:xfrm>
            <a:off x="2558027" y="576296"/>
            <a:ext cx="39688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51" name="Line 37">
            <a:extLst>
              <a:ext uri="{FF2B5EF4-FFF2-40B4-BE49-F238E27FC236}">
                <a16:creationId xmlns:a16="http://schemas.microsoft.com/office/drawing/2014/main" id="{857D8577-E6D1-8AA8-B1D3-C5C6EFE93423}"/>
              </a:ext>
            </a:extLst>
          </p:cNvPr>
          <p:cNvSpPr>
            <a:spLocks noChangeShapeType="1"/>
          </p:cNvSpPr>
          <p:nvPr/>
        </p:nvSpPr>
        <p:spPr bwMode="auto">
          <a:xfrm>
            <a:off x="738752" y="576296"/>
            <a:ext cx="1839913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" name="Line 124">
            <a:extLst>
              <a:ext uri="{FF2B5EF4-FFF2-40B4-BE49-F238E27FC236}">
                <a16:creationId xmlns:a16="http://schemas.microsoft.com/office/drawing/2014/main" id="{6465F705-E656-91BD-6734-F00DC66E5B8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014974" y="4773611"/>
            <a:ext cx="0" cy="31750"/>
          </a:xfrm>
          <a:prstGeom prst="line">
            <a:avLst/>
          </a:prstGeom>
          <a:noFill/>
          <a:ln w="635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0" name="Freeform 113">
            <a:extLst>
              <a:ext uri="{FF2B5EF4-FFF2-40B4-BE49-F238E27FC236}">
                <a16:creationId xmlns:a16="http://schemas.microsoft.com/office/drawing/2014/main" id="{2A612B2A-2369-C40C-4229-E5A90552EA96}"/>
              </a:ext>
            </a:extLst>
          </p:cNvPr>
          <p:cNvSpPr>
            <a:spLocks/>
          </p:cNvSpPr>
          <p:nvPr/>
        </p:nvSpPr>
        <p:spPr bwMode="auto">
          <a:xfrm>
            <a:off x="4174701" y="4719266"/>
            <a:ext cx="1839912" cy="71438"/>
          </a:xfrm>
          <a:custGeom>
            <a:avLst/>
            <a:gdLst>
              <a:gd name="T0" fmla="*/ 0 w 477"/>
              <a:gd name="T1" fmla="*/ 22 h 22"/>
              <a:gd name="T2" fmla="*/ 43 w 477"/>
              <a:gd name="T3" fmla="*/ 22 h 22"/>
              <a:gd name="T4" fmla="*/ 43 w 477"/>
              <a:gd name="T5" fmla="*/ 0 h 22"/>
              <a:gd name="T6" fmla="*/ 477 w 477"/>
              <a:gd name="T7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477" h="22">
                <a:moveTo>
                  <a:pt x="0" y="22"/>
                </a:moveTo>
                <a:lnTo>
                  <a:pt x="43" y="22"/>
                </a:lnTo>
                <a:lnTo>
                  <a:pt x="43" y="0"/>
                </a:lnTo>
                <a:lnTo>
                  <a:pt x="477" y="0"/>
                </a:lnTo>
              </a:path>
            </a:pathLst>
          </a:custGeom>
          <a:noFill/>
          <a:ln w="12700" cap="rnd">
            <a:solidFill>
              <a:schemeClr val="tx1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" name="Line 117">
            <a:extLst>
              <a:ext uri="{FF2B5EF4-FFF2-40B4-BE49-F238E27FC236}">
                <a16:creationId xmlns:a16="http://schemas.microsoft.com/office/drawing/2014/main" id="{92CB4A40-0477-5269-26FE-92A2705FE95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014614" y="4703391"/>
            <a:ext cx="0" cy="31750"/>
          </a:xfrm>
          <a:prstGeom prst="line">
            <a:avLst/>
          </a:prstGeom>
          <a:noFill/>
          <a:ln w="635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" name="Line 120">
            <a:extLst>
              <a:ext uri="{FF2B5EF4-FFF2-40B4-BE49-F238E27FC236}">
                <a16:creationId xmlns:a16="http://schemas.microsoft.com/office/drawing/2014/main" id="{F4977E34-BFC5-F1DD-F539-DDFA4D7DAC8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014489" y="4774829"/>
            <a:ext cx="0" cy="31750"/>
          </a:xfrm>
          <a:prstGeom prst="line">
            <a:avLst/>
          </a:prstGeom>
          <a:noFill/>
          <a:ln w="635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" name="Line 122">
            <a:extLst>
              <a:ext uri="{FF2B5EF4-FFF2-40B4-BE49-F238E27FC236}">
                <a16:creationId xmlns:a16="http://schemas.microsoft.com/office/drawing/2014/main" id="{3DBB464D-D4A1-C1DF-ABA6-AFCE6B81207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940001" y="4774829"/>
            <a:ext cx="0" cy="31750"/>
          </a:xfrm>
          <a:prstGeom prst="line">
            <a:avLst/>
          </a:prstGeom>
          <a:noFill/>
          <a:ln w="635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" name="Line 115">
            <a:extLst>
              <a:ext uri="{FF2B5EF4-FFF2-40B4-BE49-F238E27FC236}">
                <a16:creationId xmlns:a16="http://schemas.microsoft.com/office/drawing/2014/main" id="{08A8D11A-35A1-36F4-D70C-A0871E15FC43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589164" y="4703391"/>
            <a:ext cx="0" cy="31750"/>
          </a:xfrm>
          <a:prstGeom prst="line">
            <a:avLst/>
          </a:prstGeom>
          <a:noFill/>
          <a:ln w="635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9" name="Line 41">
            <a:extLst>
              <a:ext uri="{FF2B5EF4-FFF2-40B4-BE49-F238E27FC236}">
                <a16:creationId xmlns:a16="http://schemas.microsoft.com/office/drawing/2014/main" id="{B1D6897A-BDE9-3B1C-0267-9A804B518A4C}"/>
              </a:ext>
            </a:extLst>
          </p:cNvPr>
          <p:cNvSpPr>
            <a:spLocks noChangeShapeType="1"/>
          </p:cNvSpPr>
          <p:nvPr/>
        </p:nvSpPr>
        <p:spPr bwMode="auto">
          <a:xfrm>
            <a:off x="5995060" y="975160"/>
            <a:ext cx="39688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8" name="Line 48">
            <a:extLst>
              <a:ext uri="{FF2B5EF4-FFF2-40B4-BE49-F238E27FC236}">
                <a16:creationId xmlns:a16="http://schemas.microsoft.com/office/drawing/2014/main" id="{2FC80B99-6060-E684-ACCF-C867A06DF91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576284" y="1123983"/>
            <a:ext cx="0" cy="31750"/>
          </a:xfrm>
          <a:prstGeom prst="line">
            <a:avLst/>
          </a:prstGeom>
          <a:noFill/>
          <a:ln w="635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7" name="Line 43">
            <a:extLst>
              <a:ext uri="{FF2B5EF4-FFF2-40B4-BE49-F238E27FC236}">
                <a16:creationId xmlns:a16="http://schemas.microsoft.com/office/drawing/2014/main" id="{74359CB9-F27B-0486-A174-33DB9475A4E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576284" y="560421"/>
            <a:ext cx="0" cy="33337"/>
          </a:xfrm>
          <a:prstGeom prst="line">
            <a:avLst/>
          </a:prstGeom>
          <a:noFill/>
          <a:ln w="635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55" name="AutoShape 3">
            <a:extLst>
              <a:ext uri="{FF2B5EF4-FFF2-40B4-BE49-F238E27FC236}">
                <a16:creationId xmlns:a16="http://schemas.microsoft.com/office/drawing/2014/main" id="{05E275BB-320A-3E5C-41B2-797EBA0EB81C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-3086100" y="168275"/>
            <a:ext cx="3240088" cy="2700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5BEFCE4-5463-F527-EF9F-3ED00E2026E1}"/>
              </a:ext>
            </a:extLst>
          </p:cNvPr>
          <p:cNvSpPr txBox="1"/>
          <p:nvPr/>
        </p:nvSpPr>
        <p:spPr>
          <a:xfrm>
            <a:off x="312428" y="441003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790E2FF-FBED-BA79-DA7C-EF5A7179F916}"/>
              </a:ext>
            </a:extLst>
          </p:cNvPr>
          <p:cNvSpPr txBox="1"/>
          <p:nvPr/>
        </p:nvSpPr>
        <p:spPr>
          <a:xfrm>
            <a:off x="312428" y="707678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B280444-C880-05B4-660E-9C18D98EE6F2}"/>
              </a:ext>
            </a:extLst>
          </p:cNvPr>
          <p:cNvSpPr txBox="1"/>
          <p:nvPr/>
        </p:nvSpPr>
        <p:spPr>
          <a:xfrm>
            <a:off x="312428" y="974353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33058D0-91BD-A748-1556-41D8C2A4BFA8}"/>
              </a:ext>
            </a:extLst>
          </p:cNvPr>
          <p:cNvSpPr txBox="1"/>
          <p:nvPr/>
        </p:nvSpPr>
        <p:spPr>
          <a:xfrm>
            <a:off x="312428" y="1241028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143E9B3-F2E9-8FB2-ED60-EB63CA22AD56}"/>
              </a:ext>
            </a:extLst>
          </p:cNvPr>
          <p:cNvSpPr txBox="1"/>
          <p:nvPr/>
        </p:nvSpPr>
        <p:spPr>
          <a:xfrm>
            <a:off x="312428" y="1507703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2CEC2F7-3D2D-FFE6-C3F5-045CAA299528}"/>
              </a:ext>
            </a:extLst>
          </p:cNvPr>
          <p:cNvSpPr txBox="1"/>
          <p:nvPr/>
        </p:nvSpPr>
        <p:spPr>
          <a:xfrm>
            <a:off x="312428" y="1774378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3" name="テキスト ボックス 362"/>
          <p:cNvSpPr txBox="1">
            <a:spLocks noChangeAspect="1"/>
          </p:cNvSpPr>
          <p:nvPr/>
        </p:nvSpPr>
        <p:spPr>
          <a:xfrm>
            <a:off x="-1934" y="72862"/>
            <a:ext cx="360000" cy="360000"/>
          </a:xfrm>
          <a:prstGeom prst="rect">
            <a:avLst/>
          </a:prstGeom>
          <a:noFill/>
          <a:ln w="3175">
            <a:noFill/>
          </a:ln>
        </p:spPr>
        <p:txBody>
          <a:bodyPr wrap="none" lIns="54000" tIns="54000" rIns="54000" bIns="54000" rtlCol="0" anchor="ctr" anchorCtr="1">
            <a:no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5" name="テキスト ボックス 364"/>
          <p:cNvSpPr txBox="1">
            <a:spLocks noChangeAspect="1"/>
          </p:cNvSpPr>
          <p:nvPr/>
        </p:nvSpPr>
        <p:spPr>
          <a:xfrm>
            <a:off x="3430422" y="72862"/>
            <a:ext cx="360000" cy="360000"/>
          </a:xfrm>
          <a:prstGeom prst="rect">
            <a:avLst/>
          </a:prstGeom>
          <a:noFill/>
          <a:ln w="3175">
            <a:noFill/>
          </a:ln>
        </p:spPr>
        <p:txBody>
          <a:bodyPr wrap="none" lIns="54000" tIns="54000" rIns="54000" bIns="54000" rtlCol="0" anchor="ctr" anchorCtr="1">
            <a:no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2" name="テキスト ボックス 261">
            <a:extLst>
              <a:ext uri="{FF2B5EF4-FFF2-40B4-BE49-F238E27FC236}">
                <a16:creationId xmlns:a16="http://schemas.microsoft.com/office/drawing/2014/main" id="{F7E8E904-B5DA-49B6-AAC8-113ED2209214}"/>
              </a:ext>
            </a:extLst>
          </p:cNvPr>
          <p:cNvSpPr txBox="1">
            <a:spLocks noChangeAspect="1"/>
          </p:cNvSpPr>
          <p:nvPr/>
        </p:nvSpPr>
        <p:spPr>
          <a:xfrm>
            <a:off x="447" y="2952766"/>
            <a:ext cx="360000" cy="360000"/>
          </a:xfrm>
          <a:prstGeom prst="rect">
            <a:avLst/>
          </a:prstGeom>
          <a:noFill/>
          <a:ln w="3175">
            <a:noFill/>
          </a:ln>
        </p:spPr>
        <p:txBody>
          <a:bodyPr wrap="none" lIns="54000" tIns="54000" rIns="54000" bIns="54000" rtlCol="0" anchor="ctr" anchorCtr="1">
            <a:no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3" name="テキスト ボックス 262">
            <a:extLst>
              <a:ext uri="{FF2B5EF4-FFF2-40B4-BE49-F238E27FC236}">
                <a16:creationId xmlns:a16="http://schemas.microsoft.com/office/drawing/2014/main" id="{95D394EE-1319-4016-A7D3-E7559043B438}"/>
              </a:ext>
            </a:extLst>
          </p:cNvPr>
          <p:cNvSpPr txBox="1">
            <a:spLocks noChangeAspect="1"/>
          </p:cNvSpPr>
          <p:nvPr/>
        </p:nvSpPr>
        <p:spPr>
          <a:xfrm>
            <a:off x="3428041" y="2952766"/>
            <a:ext cx="360000" cy="360000"/>
          </a:xfrm>
          <a:prstGeom prst="rect">
            <a:avLst/>
          </a:prstGeom>
          <a:noFill/>
          <a:ln w="3175">
            <a:noFill/>
          </a:ln>
        </p:spPr>
        <p:txBody>
          <a:bodyPr wrap="none" lIns="54000" tIns="54000" rIns="54000" bIns="54000" rtlCol="0" anchor="ctr" anchorCtr="1">
            <a:no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AutoShape 3">
            <a:extLst>
              <a:ext uri="{FF2B5EF4-FFF2-40B4-BE49-F238E27FC236}">
                <a16:creationId xmlns:a16="http://schemas.microsoft.com/office/drawing/2014/main" id="{22B23E7B-2987-4969-80BD-305B6D9F2F26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804498" y="6710657"/>
            <a:ext cx="2519362" cy="2519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9" name="Rectangle 339">
            <a:extLst>
              <a:ext uri="{FF2B5EF4-FFF2-40B4-BE49-F238E27FC236}">
                <a16:creationId xmlns:a16="http://schemas.microsoft.com/office/drawing/2014/main" id="{D0BD88A3-BC31-826D-A9FD-053282E574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9909" y="2013873"/>
            <a:ext cx="7694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0" name="Rectangle 340">
            <a:extLst>
              <a:ext uri="{FF2B5EF4-FFF2-40B4-BE49-F238E27FC236}">
                <a16:creationId xmlns:a16="http://schemas.microsoft.com/office/drawing/2014/main" id="{F18D5D07-AEAC-001B-A7FB-53673521D9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62192" y="2013873"/>
            <a:ext cx="7694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1" name="Rectangle 341">
            <a:extLst>
              <a:ext uri="{FF2B5EF4-FFF2-40B4-BE49-F238E27FC236}">
                <a16:creationId xmlns:a16="http://schemas.microsoft.com/office/drawing/2014/main" id="{C293B72A-1273-BE06-0C6D-ACE55FFC86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22094" y="2013873"/>
            <a:ext cx="7694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2" name="Rectangle 342">
            <a:extLst>
              <a:ext uri="{FF2B5EF4-FFF2-40B4-BE49-F238E27FC236}">
                <a16:creationId xmlns:a16="http://schemas.microsoft.com/office/drawing/2014/main" id="{5B2D0049-369C-3D93-7089-C580014201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89139" y="2013873"/>
            <a:ext cx="7694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3" name="Rectangle 343">
            <a:extLst>
              <a:ext uri="{FF2B5EF4-FFF2-40B4-BE49-F238E27FC236}">
                <a16:creationId xmlns:a16="http://schemas.microsoft.com/office/drawing/2014/main" id="{9D962CD8-1EDF-2E78-F8C6-15E7CB81B8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49039" y="2013873"/>
            <a:ext cx="7694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4" name="Rectangle 344">
            <a:extLst>
              <a:ext uri="{FF2B5EF4-FFF2-40B4-BE49-F238E27FC236}">
                <a16:creationId xmlns:a16="http://schemas.microsoft.com/office/drawing/2014/main" id="{752187E6-2F38-3B1B-213C-63A37C8994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13700" y="2013873"/>
            <a:ext cx="7694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5" name="Rectangle 345">
            <a:extLst>
              <a:ext uri="{FF2B5EF4-FFF2-40B4-BE49-F238E27FC236}">
                <a16:creationId xmlns:a16="http://schemas.microsoft.com/office/drawing/2014/main" id="{C41E7E46-97F1-7950-5866-B833265F8F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75982" y="2013873"/>
            <a:ext cx="7694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6" name="Rectangle 346">
            <a:extLst>
              <a:ext uri="{FF2B5EF4-FFF2-40B4-BE49-F238E27FC236}">
                <a16:creationId xmlns:a16="http://schemas.microsoft.com/office/drawing/2014/main" id="{D0C92B17-E605-057F-1C10-F7BFE74391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40655" y="2013873"/>
            <a:ext cx="7694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4" name="Rectangle 150">
            <a:extLst>
              <a:ext uri="{FF2B5EF4-FFF2-40B4-BE49-F238E27FC236}">
                <a16:creationId xmlns:a16="http://schemas.microsoft.com/office/drawing/2014/main" id="{F89B8549-50A3-35FC-F103-B87F5C0DBC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2476" y="2197609"/>
            <a:ext cx="1380827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Year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s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after allo-HSCT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" name="Rectangle 151">
            <a:extLst>
              <a:ext uri="{FF2B5EF4-FFF2-40B4-BE49-F238E27FC236}">
                <a16:creationId xmlns:a16="http://schemas.microsoft.com/office/drawing/2014/main" id="{B68010EA-F97F-04FA-6054-6F7FF700A80A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218012" y="1160921"/>
            <a:ext cx="998671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Overall survival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0" name="Rectangle 339">
            <a:extLst>
              <a:ext uri="{FF2B5EF4-FFF2-40B4-BE49-F238E27FC236}">
                <a16:creationId xmlns:a16="http://schemas.microsoft.com/office/drawing/2014/main" id="{E335E1F0-2A8A-1C48-B708-F9AD76D3D8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9837" y="2518283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ctangle 340">
            <a:extLst>
              <a:ext uri="{FF2B5EF4-FFF2-40B4-BE49-F238E27FC236}">
                <a16:creationId xmlns:a16="http://schemas.microsoft.com/office/drawing/2014/main" id="{77DE346D-2D2C-1AE7-8F5F-D1CD3530AE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2046" y="2518283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ctangle 341">
            <a:extLst>
              <a:ext uri="{FF2B5EF4-FFF2-40B4-BE49-F238E27FC236}">
                <a16:creationId xmlns:a16="http://schemas.microsoft.com/office/drawing/2014/main" id="{16220C09-8537-01F1-2479-B33DF00CFF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03593" y="2518283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342">
            <a:extLst>
              <a:ext uri="{FF2B5EF4-FFF2-40B4-BE49-F238E27FC236}">
                <a16:creationId xmlns:a16="http://schemas.microsoft.com/office/drawing/2014/main" id="{474D1B21-2201-B055-FFAB-6F6D5DD8D8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67284" y="2518283"/>
            <a:ext cx="11541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343">
            <a:extLst>
              <a:ext uri="{FF2B5EF4-FFF2-40B4-BE49-F238E27FC236}">
                <a16:creationId xmlns:a16="http://schemas.microsoft.com/office/drawing/2014/main" id="{C548FFC6-5526-6DA2-F216-4297078443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59600" y="2518283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344">
            <a:extLst>
              <a:ext uri="{FF2B5EF4-FFF2-40B4-BE49-F238E27FC236}">
                <a16:creationId xmlns:a16="http://schemas.microsoft.com/office/drawing/2014/main" id="{3492E344-61EF-06B3-A23A-2D9BA7DF43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24467" y="2518283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345">
            <a:extLst>
              <a:ext uri="{FF2B5EF4-FFF2-40B4-BE49-F238E27FC236}">
                <a16:creationId xmlns:a16="http://schemas.microsoft.com/office/drawing/2014/main" id="{9F7478CB-6763-C2E9-1FF9-A55505E863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86657" y="2518283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346">
            <a:extLst>
              <a:ext uri="{FF2B5EF4-FFF2-40B4-BE49-F238E27FC236}">
                <a16:creationId xmlns:a16="http://schemas.microsoft.com/office/drawing/2014/main" id="{4C0D0145-ECFB-146B-867B-4CD1574D5E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50227" y="2518283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339">
            <a:extLst>
              <a:ext uri="{FF2B5EF4-FFF2-40B4-BE49-F238E27FC236}">
                <a16:creationId xmlns:a16="http://schemas.microsoft.com/office/drawing/2014/main" id="{E82B930B-1055-B01A-819C-BADF61DBC1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2428" y="2381946"/>
            <a:ext cx="692497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9" name="Rectangle 339">
            <a:extLst>
              <a:ext uri="{FF2B5EF4-FFF2-40B4-BE49-F238E27FC236}">
                <a16:creationId xmlns:a16="http://schemas.microsoft.com/office/drawing/2014/main" id="{853B9741-9FF1-6589-6C9C-22AC4754C3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8204" y="2518283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0" name="Rectangle 340">
            <a:extLst>
              <a:ext uri="{FF2B5EF4-FFF2-40B4-BE49-F238E27FC236}">
                <a16:creationId xmlns:a16="http://schemas.microsoft.com/office/drawing/2014/main" id="{DF061EA3-303A-1DAC-60C8-A4AB1A0585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65249" y="2518283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1" name="Rectangle 341">
            <a:extLst>
              <a:ext uri="{FF2B5EF4-FFF2-40B4-BE49-F238E27FC236}">
                <a16:creationId xmlns:a16="http://schemas.microsoft.com/office/drawing/2014/main" id="{D4311CF3-DBC8-233C-9F65-5E811ECE04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1148" y="2518283"/>
            <a:ext cx="57708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2" name="Rectangle 342">
            <a:extLst>
              <a:ext uri="{FF2B5EF4-FFF2-40B4-BE49-F238E27FC236}">
                <a16:creationId xmlns:a16="http://schemas.microsoft.com/office/drawing/2014/main" id="{7A491ECD-BB12-F6EB-D258-2A00E090AC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28193" y="2518283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3" name="Rectangle 343">
            <a:extLst>
              <a:ext uri="{FF2B5EF4-FFF2-40B4-BE49-F238E27FC236}">
                <a16:creationId xmlns:a16="http://schemas.microsoft.com/office/drawing/2014/main" id="{1B4E7984-2456-356C-7A78-288FED10FA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95238" y="2518283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4" name="Rectangle 344">
            <a:extLst>
              <a:ext uri="{FF2B5EF4-FFF2-40B4-BE49-F238E27FC236}">
                <a16:creationId xmlns:a16="http://schemas.microsoft.com/office/drawing/2014/main" id="{409B0CA6-8647-2BC2-9FF8-F9556A5804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62283" y="2518283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5" name="Rectangle 345">
            <a:extLst>
              <a:ext uri="{FF2B5EF4-FFF2-40B4-BE49-F238E27FC236}">
                <a16:creationId xmlns:a16="http://schemas.microsoft.com/office/drawing/2014/main" id="{E9DBE9BD-5C2A-0565-4F7D-D5A9CE26DE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29328" y="2518283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6" name="Rectangle 346">
            <a:extLst>
              <a:ext uri="{FF2B5EF4-FFF2-40B4-BE49-F238E27FC236}">
                <a16:creationId xmlns:a16="http://schemas.microsoft.com/office/drawing/2014/main" id="{161C6603-ACE6-E253-E851-9496351DD3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96376" y="2518283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7" name="Rectangle 339">
            <a:extLst>
              <a:ext uri="{FF2B5EF4-FFF2-40B4-BE49-F238E27FC236}">
                <a16:creationId xmlns:a16="http://schemas.microsoft.com/office/drawing/2014/main" id="{970DA748-5952-4E41-4AE3-098088088E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50297" y="2381946"/>
            <a:ext cx="692497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8" name="Rectangle 339">
            <a:extLst>
              <a:ext uri="{FF2B5EF4-FFF2-40B4-BE49-F238E27FC236}">
                <a16:creationId xmlns:a16="http://schemas.microsoft.com/office/drawing/2014/main" id="{301AA559-C0ED-C627-AD61-F522FA0034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6303" y="2013873"/>
            <a:ext cx="7694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9" name="Rectangle 340">
            <a:extLst>
              <a:ext uri="{FF2B5EF4-FFF2-40B4-BE49-F238E27FC236}">
                <a16:creationId xmlns:a16="http://schemas.microsoft.com/office/drawing/2014/main" id="{5F42693C-726C-D69E-717B-1410B020C6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99266" y="2013873"/>
            <a:ext cx="7694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0" name="Rectangle 341">
            <a:extLst>
              <a:ext uri="{FF2B5EF4-FFF2-40B4-BE49-F238E27FC236}">
                <a16:creationId xmlns:a16="http://schemas.microsoft.com/office/drawing/2014/main" id="{F0F1157D-86AE-E29C-9915-7A61BE3AC1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2229" y="2013873"/>
            <a:ext cx="7694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1" name="Rectangle 342">
            <a:extLst>
              <a:ext uri="{FF2B5EF4-FFF2-40B4-BE49-F238E27FC236}">
                <a16:creationId xmlns:a16="http://schemas.microsoft.com/office/drawing/2014/main" id="{A418D8D0-141A-1AAC-D2D4-E057DC8751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25192" y="2013873"/>
            <a:ext cx="7694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7" name="Rectangle 343">
            <a:extLst>
              <a:ext uri="{FF2B5EF4-FFF2-40B4-BE49-F238E27FC236}">
                <a16:creationId xmlns:a16="http://schemas.microsoft.com/office/drawing/2014/main" id="{406AB5CD-0623-FE71-3C3D-E54301F363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88155" y="2013873"/>
            <a:ext cx="7694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8" name="Rectangle 344">
            <a:extLst>
              <a:ext uri="{FF2B5EF4-FFF2-40B4-BE49-F238E27FC236}">
                <a16:creationId xmlns:a16="http://schemas.microsoft.com/office/drawing/2014/main" id="{CFFC649F-E8F3-1768-53E6-1F5B19373F6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51118" y="2013873"/>
            <a:ext cx="7694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0" name="Rectangle 345">
            <a:extLst>
              <a:ext uri="{FF2B5EF4-FFF2-40B4-BE49-F238E27FC236}">
                <a16:creationId xmlns:a16="http://schemas.microsoft.com/office/drawing/2014/main" id="{4AB970D6-BB9D-4954-6CB1-12ABC94507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14081" y="2013873"/>
            <a:ext cx="7694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1" name="Rectangle 346">
            <a:extLst>
              <a:ext uri="{FF2B5EF4-FFF2-40B4-BE49-F238E27FC236}">
                <a16:creationId xmlns:a16="http://schemas.microsoft.com/office/drawing/2014/main" id="{6FB0F844-911C-AABB-BACC-38C9711271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77046" y="2013873"/>
            <a:ext cx="7694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1" name="Rectangle 150">
            <a:extLst>
              <a:ext uri="{FF2B5EF4-FFF2-40B4-BE49-F238E27FC236}">
                <a16:creationId xmlns:a16="http://schemas.microsoft.com/office/drawing/2014/main" id="{EDDF0B11-413C-8D35-DF64-B7FE8DC23A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06961" y="2197608"/>
            <a:ext cx="1380827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Year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s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after allo-HSCT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27" name="テキスト ボックス 426">
            <a:extLst>
              <a:ext uri="{FF2B5EF4-FFF2-40B4-BE49-F238E27FC236}">
                <a16:creationId xmlns:a16="http://schemas.microsoft.com/office/drawing/2014/main" id="{AC5ABED0-FF53-51CC-CA52-B0D0B0BB1677}"/>
              </a:ext>
            </a:extLst>
          </p:cNvPr>
          <p:cNvSpPr txBox="1"/>
          <p:nvPr/>
        </p:nvSpPr>
        <p:spPr>
          <a:xfrm>
            <a:off x="3750297" y="444826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8" name="テキスト ボックス 427">
            <a:extLst>
              <a:ext uri="{FF2B5EF4-FFF2-40B4-BE49-F238E27FC236}">
                <a16:creationId xmlns:a16="http://schemas.microsoft.com/office/drawing/2014/main" id="{6731C49F-BEC7-8FA7-6D3B-5A7A3862BBFC}"/>
              </a:ext>
            </a:extLst>
          </p:cNvPr>
          <p:cNvSpPr txBox="1"/>
          <p:nvPr/>
        </p:nvSpPr>
        <p:spPr>
          <a:xfrm>
            <a:off x="3750297" y="711500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9" name="テキスト ボックス 428">
            <a:extLst>
              <a:ext uri="{FF2B5EF4-FFF2-40B4-BE49-F238E27FC236}">
                <a16:creationId xmlns:a16="http://schemas.microsoft.com/office/drawing/2014/main" id="{5FDE1A62-1E56-F8D0-746C-182C6091D59D}"/>
              </a:ext>
            </a:extLst>
          </p:cNvPr>
          <p:cNvSpPr txBox="1"/>
          <p:nvPr/>
        </p:nvSpPr>
        <p:spPr>
          <a:xfrm>
            <a:off x="3750297" y="978174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0" name="テキスト ボックス 429">
            <a:extLst>
              <a:ext uri="{FF2B5EF4-FFF2-40B4-BE49-F238E27FC236}">
                <a16:creationId xmlns:a16="http://schemas.microsoft.com/office/drawing/2014/main" id="{410C7EC4-4DEA-7965-E70B-DC68D8A411EB}"/>
              </a:ext>
            </a:extLst>
          </p:cNvPr>
          <p:cNvSpPr txBox="1"/>
          <p:nvPr/>
        </p:nvSpPr>
        <p:spPr>
          <a:xfrm>
            <a:off x="3750297" y="1244848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1" name="テキスト ボックス 430">
            <a:extLst>
              <a:ext uri="{FF2B5EF4-FFF2-40B4-BE49-F238E27FC236}">
                <a16:creationId xmlns:a16="http://schemas.microsoft.com/office/drawing/2014/main" id="{CD8E7D0A-2295-5549-6C27-32D281094BFF}"/>
              </a:ext>
            </a:extLst>
          </p:cNvPr>
          <p:cNvSpPr txBox="1"/>
          <p:nvPr/>
        </p:nvSpPr>
        <p:spPr>
          <a:xfrm>
            <a:off x="3750297" y="1511522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2" name="テキスト ボックス 431">
            <a:extLst>
              <a:ext uri="{FF2B5EF4-FFF2-40B4-BE49-F238E27FC236}">
                <a16:creationId xmlns:a16="http://schemas.microsoft.com/office/drawing/2014/main" id="{881DDE2C-C3DA-1740-D863-8BE71B83829D}"/>
              </a:ext>
            </a:extLst>
          </p:cNvPr>
          <p:cNvSpPr txBox="1"/>
          <p:nvPr/>
        </p:nvSpPr>
        <p:spPr>
          <a:xfrm>
            <a:off x="3750297" y="1778196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3" name="Rectangle 151">
            <a:extLst>
              <a:ext uri="{FF2B5EF4-FFF2-40B4-BE49-F238E27FC236}">
                <a16:creationId xmlns:a16="http://schemas.microsoft.com/office/drawing/2014/main" id="{24C577B2-37D5-3C78-D095-B5D34C6D8703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061702" y="1157041"/>
            <a:ext cx="1316066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algn="ctr"/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Relapse-free survival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079" name="Rectangle 339">
            <a:extLst>
              <a:ext uri="{FF2B5EF4-FFF2-40B4-BE49-F238E27FC236}">
                <a16:creationId xmlns:a16="http://schemas.microsoft.com/office/drawing/2014/main" id="{17E55301-0F6E-DB81-8420-DE80C017A3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9837" y="2657264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0" name="Rectangle 340">
            <a:extLst>
              <a:ext uri="{FF2B5EF4-FFF2-40B4-BE49-F238E27FC236}">
                <a16:creationId xmlns:a16="http://schemas.microsoft.com/office/drawing/2014/main" id="{7548204E-A938-9BF7-9D48-B2B8F9C9F0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2046" y="2657264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1" name="Rectangle 341">
            <a:extLst>
              <a:ext uri="{FF2B5EF4-FFF2-40B4-BE49-F238E27FC236}">
                <a16:creationId xmlns:a16="http://schemas.microsoft.com/office/drawing/2014/main" id="{6D19F3B9-F385-7B96-7030-61F14875F4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03593" y="2657264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2" name="Rectangle 342">
            <a:extLst>
              <a:ext uri="{FF2B5EF4-FFF2-40B4-BE49-F238E27FC236}">
                <a16:creationId xmlns:a16="http://schemas.microsoft.com/office/drawing/2014/main" id="{078AEEC8-18F0-EE04-FD65-D28114C213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67284" y="2657264"/>
            <a:ext cx="11541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3" name="Rectangle 343">
            <a:extLst>
              <a:ext uri="{FF2B5EF4-FFF2-40B4-BE49-F238E27FC236}">
                <a16:creationId xmlns:a16="http://schemas.microsoft.com/office/drawing/2014/main" id="{8261D9E8-D3EA-1166-C06E-2C53953EF7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30746" y="2657264"/>
            <a:ext cx="11541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4" name="Rectangle 344">
            <a:extLst>
              <a:ext uri="{FF2B5EF4-FFF2-40B4-BE49-F238E27FC236}">
                <a16:creationId xmlns:a16="http://schemas.microsoft.com/office/drawing/2014/main" id="{2A7B3B46-8038-E60E-4D28-237858E1E1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95613" y="2657264"/>
            <a:ext cx="11541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5" name="Rectangle 345">
            <a:extLst>
              <a:ext uri="{FF2B5EF4-FFF2-40B4-BE49-F238E27FC236}">
                <a16:creationId xmlns:a16="http://schemas.microsoft.com/office/drawing/2014/main" id="{C3CD2B61-9F67-C315-DE3F-3820624FB9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57803" y="2657264"/>
            <a:ext cx="11541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6" name="Rectangle 346">
            <a:extLst>
              <a:ext uri="{FF2B5EF4-FFF2-40B4-BE49-F238E27FC236}">
                <a16:creationId xmlns:a16="http://schemas.microsoft.com/office/drawing/2014/main" id="{D2127E8E-94BF-8667-191E-3F31C336F4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21373" y="2657264"/>
            <a:ext cx="11541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5" name="Rectangle 339">
            <a:extLst>
              <a:ext uri="{FF2B5EF4-FFF2-40B4-BE49-F238E27FC236}">
                <a16:creationId xmlns:a16="http://schemas.microsoft.com/office/drawing/2014/main" id="{AA9EA559-4F66-BD44-648D-7F6C52A15C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9224" y="2657264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6" name="Rectangle 340">
            <a:extLst>
              <a:ext uri="{FF2B5EF4-FFF2-40B4-BE49-F238E27FC236}">
                <a16:creationId xmlns:a16="http://schemas.microsoft.com/office/drawing/2014/main" id="{A3AB6A16-BD02-294D-D39B-3897E6CD58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66269" y="2657264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7" name="Rectangle 341">
            <a:extLst>
              <a:ext uri="{FF2B5EF4-FFF2-40B4-BE49-F238E27FC236}">
                <a16:creationId xmlns:a16="http://schemas.microsoft.com/office/drawing/2014/main" id="{79AC4236-80BE-66F0-476F-B678469A1B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33314" y="2657264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8" name="Rectangle 342">
            <a:extLst>
              <a:ext uri="{FF2B5EF4-FFF2-40B4-BE49-F238E27FC236}">
                <a16:creationId xmlns:a16="http://schemas.microsoft.com/office/drawing/2014/main" id="{1EBEA07A-46E8-EEC5-8A10-EC3BFB45D2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00359" y="2657264"/>
            <a:ext cx="11541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9" name="Rectangle 343">
            <a:extLst>
              <a:ext uri="{FF2B5EF4-FFF2-40B4-BE49-F238E27FC236}">
                <a16:creationId xmlns:a16="http://schemas.microsoft.com/office/drawing/2014/main" id="{47157B21-7B54-1BDB-4362-AE41A3D87E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67404" y="2657264"/>
            <a:ext cx="11541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0" name="Rectangle 344">
            <a:extLst>
              <a:ext uri="{FF2B5EF4-FFF2-40B4-BE49-F238E27FC236}">
                <a16:creationId xmlns:a16="http://schemas.microsoft.com/office/drawing/2014/main" id="{32124FD0-7C95-E6B3-7430-CB8638C67C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34449" y="2657264"/>
            <a:ext cx="11541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1" name="Rectangle 345">
            <a:extLst>
              <a:ext uri="{FF2B5EF4-FFF2-40B4-BE49-F238E27FC236}">
                <a16:creationId xmlns:a16="http://schemas.microsoft.com/office/drawing/2014/main" id="{E3093555-F608-2AD6-AD2D-750243C91E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01494" y="2657264"/>
            <a:ext cx="11541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2" name="Rectangle 346">
            <a:extLst>
              <a:ext uri="{FF2B5EF4-FFF2-40B4-BE49-F238E27FC236}">
                <a16:creationId xmlns:a16="http://schemas.microsoft.com/office/drawing/2014/main" id="{49BC8BB2-9D89-6F7F-D2DA-696A5947E4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68542" y="2657264"/>
            <a:ext cx="11541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0" name="テキスト ボックス 1349">
            <a:extLst>
              <a:ext uri="{FF2B5EF4-FFF2-40B4-BE49-F238E27FC236}">
                <a16:creationId xmlns:a16="http://schemas.microsoft.com/office/drawing/2014/main" id="{C74A9A9F-E6A9-9BE3-15A6-D961CC96A3CF}"/>
              </a:ext>
            </a:extLst>
          </p:cNvPr>
          <p:cNvSpPr txBox="1"/>
          <p:nvPr/>
        </p:nvSpPr>
        <p:spPr>
          <a:xfrm>
            <a:off x="315956" y="3321335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1" name="テキスト ボックス 1350">
            <a:extLst>
              <a:ext uri="{FF2B5EF4-FFF2-40B4-BE49-F238E27FC236}">
                <a16:creationId xmlns:a16="http://schemas.microsoft.com/office/drawing/2014/main" id="{F2332411-4B29-4890-C0A4-E66393EB354E}"/>
              </a:ext>
            </a:extLst>
          </p:cNvPr>
          <p:cNvSpPr txBox="1"/>
          <p:nvPr/>
        </p:nvSpPr>
        <p:spPr>
          <a:xfrm>
            <a:off x="315956" y="3588486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2" name="テキスト ボックス 1351">
            <a:extLst>
              <a:ext uri="{FF2B5EF4-FFF2-40B4-BE49-F238E27FC236}">
                <a16:creationId xmlns:a16="http://schemas.microsoft.com/office/drawing/2014/main" id="{5E01AC44-4B62-BCF1-1D51-84ED8D4C4278}"/>
              </a:ext>
            </a:extLst>
          </p:cNvPr>
          <p:cNvSpPr txBox="1"/>
          <p:nvPr/>
        </p:nvSpPr>
        <p:spPr>
          <a:xfrm>
            <a:off x="315956" y="3855637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3" name="テキスト ボックス 1352">
            <a:extLst>
              <a:ext uri="{FF2B5EF4-FFF2-40B4-BE49-F238E27FC236}">
                <a16:creationId xmlns:a16="http://schemas.microsoft.com/office/drawing/2014/main" id="{65B1AE4A-B92A-8CEF-C23F-D866D9FF2BA6}"/>
              </a:ext>
            </a:extLst>
          </p:cNvPr>
          <p:cNvSpPr txBox="1"/>
          <p:nvPr/>
        </p:nvSpPr>
        <p:spPr>
          <a:xfrm>
            <a:off x="315956" y="4122788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4" name="テキスト ボックス 1353">
            <a:extLst>
              <a:ext uri="{FF2B5EF4-FFF2-40B4-BE49-F238E27FC236}">
                <a16:creationId xmlns:a16="http://schemas.microsoft.com/office/drawing/2014/main" id="{06BC438A-C3B7-05DB-4B2B-C82B41D44A2C}"/>
              </a:ext>
            </a:extLst>
          </p:cNvPr>
          <p:cNvSpPr txBox="1"/>
          <p:nvPr/>
        </p:nvSpPr>
        <p:spPr>
          <a:xfrm>
            <a:off x="315956" y="4389939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5" name="テキスト ボックス 1354">
            <a:extLst>
              <a:ext uri="{FF2B5EF4-FFF2-40B4-BE49-F238E27FC236}">
                <a16:creationId xmlns:a16="http://schemas.microsoft.com/office/drawing/2014/main" id="{BE80D0D0-4C08-8387-88E7-B8F5F4E83084}"/>
              </a:ext>
            </a:extLst>
          </p:cNvPr>
          <p:cNvSpPr txBox="1"/>
          <p:nvPr/>
        </p:nvSpPr>
        <p:spPr>
          <a:xfrm>
            <a:off x="315956" y="4657091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6" name="Rectangle 151">
            <a:extLst>
              <a:ext uri="{FF2B5EF4-FFF2-40B4-BE49-F238E27FC236}">
                <a16:creationId xmlns:a16="http://schemas.microsoft.com/office/drawing/2014/main" id="{D1A95E23-B7D9-5256-CEEA-85E5F8120805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275394" y="4035350"/>
            <a:ext cx="1120500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R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elapse incidence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357" name="Rectangle 339">
            <a:extLst>
              <a:ext uri="{FF2B5EF4-FFF2-40B4-BE49-F238E27FC236}">
                <a16:creationId xmlns:a16="http://schemas.microsoft.com/office/drawing/2014/main" id="{EE0DC2AC-43B5-8956-4BA6-91A671DA1C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3365" y="5403821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8" name="Rectangle 340">
            <a:extLst>
              <a:ext uri="{FF2B5EF4-FFF2-40B4-BE49-F238E27FC236}">
                <a16:creationId xmlns:a16="http://schemas.microsoft.com/office/drawing/2014/main" id="{50C13AB8-C883-B462-DCEE-658A986AA1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6442" y="5403821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9" name="Rectangle 341">
            <a:extLst>
              <a:ext uri="{FF2B5EF4-FFF2-40B4-BE49-F238E27FC236}">
                <a16:creationId xmlns:a16="http://schemas.microsoft.com/office/drawing/2014/main" id="{A0F00359-AF8D-8AA4-0958-3D5CF13B8D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38373" y="5403821"/>
            <a:ext cx="57708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0" name="Rectangle 342">
            <a:extLst>
              <a:ext uri="{FF2B5EF4-FFF2-40B4-BE49-F238E27FC236}">
                <a16:creationId xmlns:a16="http://schemas.microsoft.com/office/drawing/2014/main" id="{8B2C142E-55F4-3775-346B-702DF09D23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01450" y="5403821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1" name="Rectangle 343">
            <a:extLst>
              <a:ext uri="{FF2B5EF4-FFF2-40B4-BE49-F238E27FC236}">
                <a16:creationId xmlns:a16="http://schemas.microsoft.com/office/drawing/2014/main" id="{D2A9602F-AA52-5AAC-38ED-5FCAD44E29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64527" y="5403821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2" name="Rectangle 344">
            <a:extLst>
              <a:ext uri="{FF2B5EF4-FFF2-40B4-BE49-F238E27FC236}">
                <a16:creationId xmlns:a16="http://schemas.microsoft.com/office/drawing/2014/main" id="{205AD7E1-B6C8-C90A-1B7D-9C17C8B4FB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27604" y="5403821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3" name="Rectangle 339">
            <a:extLst>
              <a:ext uri="{FF2B5EF4-FFF2-40B4-BE49-F238E27FC236}">
                <a16:creationId xmlns:a16="http://schemas.microsoft.com/office/drawing/2014/main" id="{2465640C-5319-82C9-41DB-F639D464CC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5956" y="5263601"/>
            <a:ext cx="692497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4" name="Rectangle 339">
            <a:extLst>
              <a:ext uri="{FF2B5EF4-FFF2-40B4-BE49-F238E27FC236}">
                <a16:creationId xmlns:a16="http://schemas.microsoft.com/office/drawing/2014/main" id="{0E841A15-2A2D-9053-03F9-01E95326F3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3365" y="5541420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5" name="Rectangle 340">
            <a:extLst>
              <a:ext uri="{FF2B5EF4-FFF2-40B4-BE49-F238E27FC236}">
                <a16:creationId xmlns:a16="http://schemas.microsoft.com/office/drawing/2014/main" id="{1240A2A9-DAA7-453A-C549-3C6AAE3756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6442" y="5541420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6" name="Rectangle 341">
            <a:extLst>
              <a:ext uri="{FF2B5EF4-FFF2-40B4-BE49-F238E27FC236}">
                <a16:creationId xmlns:a16="http://schemas.microsoft.com/office/drawing/2014/main" id="{83570F2B-991C-78C9-BC44-5B8ADB6B44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09519" y="5541420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7" name="Rectangle 342">
            <a:extLst>
              <a:ext uri="{FF2B5EF4-FFF2-40B4-BE49-F238E27FC236}">
                <a16:creationId xmlns:a16="http://schemas.microsoft.com/office/drawing/2014/main" id="{3985FFC6-8734-9F4B-A6EE-2C6B388740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72596" y="5541420"/>
            <a:ext cx="11541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8" name="Rectangle 343">
            <a:extLst>
              <a:ext uri="{FF2B5EF4-FFF2-40B4-BE49-F238E27FC236}">
                <a16:creationId xmlns:a16="http://schemas.microsoft.com/office/drawing/2014/main" id="{791B3D78-169D-ACBB-B3F4-705A78BB08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35673" y="5541420"/>
            <a:ext cx="11541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9" name="Rectangle 344">
            <a:extLst>
              <a:ext uri="{FF2B5EF4-FFF2-40B4-BE49-F238E27FC236}">
                <a16:creationId xmlns:a16="http://schemas.microsoft.com/office/drawing/2014/main" id="{647FD7CD-AD27-56CD-E96B-FD4A77B3F3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98750" y="5541420"/>
            <a:ext cx="11541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0" name="Rectangle 343">
            <a:extLst>
              <a:ext uri="{FF2B5EF4-FFF2-40B4-BE49-F238E27FC236}">
                <a16:creationId xmlns:a16="http://schemas.microsoft.com/office/drawing/2014/main" id="{C8039FA2-DFB4-1E50-B05C-77182BC958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90681" y="5403821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1" name="Rectangle 344">
            <a:extLst>
              <a:ext uri="{FF2B5EF4-FFF2-40B4-BE49-F238E27FC236}">
                <a16:creationId xmlns:a16="http://schemas.microsoft.com/office/drawing/2014/main" id="{A7B19ABE-069A-AF73-3AC7-FEF08A96F0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53755" y="5403821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2" name="Rectangle 343">
            <a:extLst>
              <a:ext uri="{FF2B5EF4-FFF2-40B4-BE49-F238E27FC236}">
                <a16:creationId xmlns:a16="http://schemas.microsoft.com/office/drawing/2014/main" id="{0B856764-02DE-30AB-6F87-D314DD449B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61827" y="5541420"/>
            <a:ext cx="11541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3" name="Rectangle 344">
            <a:extLst>
              <a:ext uri="{FF2B5EF4-FFF2-40B4-BE49-F238E27FC236}">
                <a16:creationId xmlns:a16="http://schemas.microsoft.com/office/drawing/2014/main" id="{3D9AF50B-D29B-4F62-A544-DCD2A1D45F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24901" y="5541420"/>
            <a:ext cx="11541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0" name="テキスト ボックス 369">
            <a:extLst>
              <a:ext uri="{FF2B5EF4-FFF2-40B4-BE49-F238E27FC236}">
                <a16:creationId xmlns:a16="http://schemas.microsoft.com/office/drawing/2014/main" id="{8D407C6F-F9CB-FD62-5B22-1C32AA9780C2}"/>
              </a:ext>
            </a:extLst>
          </p:cNvPr>
          <p:cNvSpPr txBox="1"/>
          <p:nvPr/>
        </p:nvSpPr>
        <p:spPr>
          <a:xfrm>
            <a:off x="3747907" y="3321335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1" name="テキスト ボックス 370">
            <a:extLst>
              <a:ext uri="{FF2B5EF4-FFF2-40B4-BE49-F238E27FC236}">
                <a16:creationId xmlns:a16="http://schemas.microsoft.com/office/drawing/2014/main" id="{293A776E-A093-B900-6E8E-24FE8CE42CF9}"/>
              </a:ext>
            </a:extLst>
          </p:cNvPr>
          <p:cNvSpPr txBox="1"/>
          <p:nvPr/>
        </p:nvSpPr>
        <p:spPr>
          <a:xfrm>
            <a:off x="3747907" y="3588486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2" name="テキスト ボックス 371">
            <a:extLst>
              <a:ext uri="{FF2B5EF4-FFF2-40B4-BE49-F238E27FC236}">
                <a16:creationId xmlns:a16="http://schemas.microsoft.com/office/drawing/2014/main" id="{763C7965-C2F8-F108-5F77-70D577F4C713}"/>
              </a:ext>
            </a:extLst>
          </p:cNvPr>
          <p:cNvSpPr txBox="1"/>
          <p:nvPr/>
        </p:nvSpPr>
        <p:spPr>
          <a:xfrm>
            <a:off x="3747907" y="3855637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3" name="テキスト ボックス 372">
            <a:extLst>
              <a:ext uri="{FF2B5EF4-FFF2-40B4-BE49-F238E27FC236}">
                <a16:creationId xmlns:a16="http://schemas.microsoft.com/office/drawing/2014/main" id="{1B0340F6-B347-A572-88D8-6480604FF568}"/>
              </a:ext>
            </a:extLst>
          </p:cNvPr>
          <p:cNvSpPr txBox="1"/>
          <p:nvPr/>
        </p:nvSpPr>
        <p:spPr>
          <a:xfrm>
            <a:off x="3747907" y="4122788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4" name="テキスト ボックス 373">
            <a:extLst>
              <a:ext uri="{FF2B5EF4-FFF2-40B4-BE49-F238E27FC236}">
                <a16:creationId xmlns:a16="http://schemas.microsoft.com/office/drawing/2014/main" id="{2FD98D39-DE3C-7F29-8606-421D4E4995FB}"/>
              </a:ext>
            </a:extLst>
          </p:cNvPr>
          <p:cNvSpPr txBox="1"/>
          <p:nvPr/>
        </p:nvSpPr>
        <p:spPr>
          <a:xfrm>
            <a:off x="3747907" y="4389939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5" name="テキスト ボックス 374">
            <a:extLst>
              <a:ext uri="{FF2B5EF4-FFF2-40B4-BE49-F238E27FC236}">
                <a16:creationId xmlns:a16="http://schemas.microsoft.com/office/drawing/2014/main" id="{4B347E1C-9A71-EBC2-4FC0-84AAE916FF3F}"/>
              </a:ext>
            </a:extLst>
          </p:cNvPr>
          <p:cNvSpPr txBox="1"/>
          <p:nvPr/>
        </p:nvSpPr>
        <p:spPr>
          <a:xfrm>
            <a:off x="3747907" y="4657091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6" name="Rectangle 151">
            <a:extLst>
              <a:ext uri="{FF2B5EF4-FFF2-40B4-BE49-F238E27FC236}">
                <a16:creationId xmlns:a16="http://schemas.microsoft.com/office/drawing/2014/main" id="{3174BB53-F9DE-13FF-3DE8-295374149E6D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542616" y="4038867"/>
            <a:ext cx="349455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NRM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77" name="Rectangle 339">
            <a:extLst>
              <a:ext uri="{FF2B5EF4-FFF2-40B4-BE49-F238E27FC236}">
                <a16:creationId xmlns:a16="http://schemas.microsoft.com/office/drawing/2014/main" id="{421C0FFA-07BC-6A59-C363-6F7F58D90D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5936" y="5403821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8" name="Rectangle 340">
            <a:extLst>
              <a:ext uri="{FF2B5EF4-FFF2-40B4-BE49-F238E27FC236}">
                <a16:creationId xmlns:a16="http://schemas.microsoft.com/office/drawing/2014/main" id="{8B10BD38-89B9-9AAF-3F2B-D32203F987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78927" y="5403821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9" name="Rectangle 341">
            <a:extLst>
              <a:ext uri="{FF2B5EF4-FFF2-40B4-BE49-F238E27FC236}">
                <a16:creationId xmlns:a16="http://schemas.microsoft.com/office/drawing/2014/main" id="{6A02E9EB-1F2B-3C2E-AA87-5D532E1649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41918" y="5403821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0" name="Rectangle 342">
            <a:extLst>
              <a:ext uri="{FF2B5EF4-FFF2-40B4-BE49-F238E27FC236}">
                <a16:creationId xmlns:a16="http://schemas.microsoft.com/office/drawing/2014/main" id="{2B8D1A0E-7D72-4D76-F50E-6920BD3732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04909" y="5403821"/>
            <a:ext cx="11541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1" name="Rectangle 343">
            <a:extLst>
              <a:ext uri="{FF2B5EF4-FFF2-40B4-BE49-F238E27FC236}">
                <a16:creationId xmlns:a16="http://schemas.microsoft.com/office/drawing/2014/main" id="{57C18CBB-91F2-22D8-71A5-A8A621CEDC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96754" y="5403821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2" name="Rectangle 344">
            <a:extLst>
              <a:ext uri="{FF2B5EF4-FFF2-40B4-BE49-F238E27FC236}">
                <a16:creationId xmlns:a16="http://schemas.microsoft.com/office/drawing/2014/main" id="{76E03262-1794-3109-C1E7-978BD8EDC0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59745" y="5403821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3" name="Rectangle 339">
            <a:extLst>
              <a:ext uri="{FF2B5EF4-FFF2-40B4-BE49-F238E27FC236}">
                <a16:creationId xmlns:a16="http://schemas.microsoft.com/office/drawing/2014/main" id="{72902183-7F4D-6E55-5BA4-CDDD89A58B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47907" y="5263601"/>
            <a:ext cx="692497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4" name="Rectangle 339">
            <a:extLst>
              <a:ext uri="{FF2B5EF4-FFF2-40B4-BE49-F238E27FC236}">
                <a16:creationId xmlns:a16="http://schemas.microsoft.com/office/drawing/2014/main" id="{0C6DE4B3-1DB9-1AAD-9F26-63309A0AD4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5936" y="5541420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5" name="Rectangle 340">
            <a:extLst>
              <a:ext uri="{FF2B5EF4-FFF2-40B4-BE49-F238E27FC236}">
                <a16:creationId xmlns:a16="http://schemas.microsoft.com/office/drawing/2014/main" id="{97C81CD7-B11A-553F-A9C4-0AC821802C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78927" y="5541420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6" name="Rectangle 341">
            <a:extLst>
              <a:ext uri="{FF2B5EF4-FFF2-40B4-BE49-F238E27FC236}">
                <a16:creationId xmlns:a16="http://schemas.microsoft.com/office/drawing/2014/main" id="{6396D746-C61F-497C-1006-1AAADEBB9B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41918" y="5541420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7" name="Rectangle 342">
            <a:extLst>
              <a:ext uri="{FF2B5EF4-FFF2-40B4-BE49-F238E27FC236}">
                <a16:creationId xmlns:a16="http://schemas.microsoft.com/office/drawing/2014/main" id="{F8DD9349-FE72-F64F-E533-4BBFA54B62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04909" y="5541420"/>
            <a:ext cx="11541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8" name="Rectangle 343">
            <a:extLst>
              <a:ext uri="{FF2B5EF4-FFF2-40B4-BE49-F238E27FC236}">
                <a16:creationId xmlns:a16="http://schemas.microsoft.com/office/drawing/2014/main" id="{39682F5E-C5A5-54A4-306A-49F73C6DE8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67900" y="5541420"/>
            <a:ext cx="11541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9" name="Rectangle 344">
            <a:extLst>
              <a:ext uri="{FF2B5EF4-FFF2-40B4-BE49-F238E27FC236}">
                <a16:creationId xmlns:a16="http://schemas.microsoft.com/office/drawing/2014/main" id="{CB7131E4-76AB-2320-F13A-87919B104C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30891" y="5541420"/>
            <a:ext cx="11541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0" name="Rectangle 343">
            <a:extLst>
              <a:ext uri="{FF2B5EF4-FFF2-40B4-BE49-F238E27FC236}">
                <a16:creationId xmlns:a16="http://schemas.microsoft.com/office/drawing/2014/main" id="{12920979-30A1-0047-8BDB-EBB1AE6A2D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22736" y="5403821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1" name="Rectangle 344">
            <a:extLst>
              <a:ext uri="{FF2B5EF4-FFF2-40B4-BE49-F238E27FC236}">
                <a16:creationId xmlns:a16="http://schemas.microsoft.com/office/drawing/2014/main" id="{89826283-E181-81D0-19FD-60A2B4E2DD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85724" y="5403821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2" name="Rectangle 343">
            <a:extLst>
              <a:ext uri="{FF2B5EF4-FFF2-40B4-BE49-F238E27FC236}">
                <a16:creationId xmlns:a16="http://schemas.microsoft.com/office/drawing/2014/main" id="{CCDF7E35-EEB7-4032-BD93-F69A2D6EA9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93882" y="5541420"/>
            <a:ext cx="11541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3" name="Rectangle 344">
            <a:extLst>
              <a:ext uri="{FF2B5EF4-FFF2-40B4-BE49-F238E27FC236}">
                <a16:creationId xmlns:a16="http://schemas.microsoft.com/office/drawing/2014/main" id="{E80C8C26-CE43-F5C4-1BC1-A2D0CAD43A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56870" y="5541420"/>
            <a:ext cx="115416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4" name="Rectangle 339">
            <a:extLst>
              <a:ext uri="{FF2B5EF4-FFF2-40B4-BE49-F238E27FC236}">
                <a16:creationId xmlns:a16="http://schemas.microsoft.com/office/drawing/2014/main" id="{72B07E5C-A8F4-838D-8ED8-ED6C580ABA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3437" y="4893121"/>
            <a:ext cx="7694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5" name="Rectangle 340">
            <a:extLst>
              <a:ext uri="{FF2B5EF4-FFF2-40B4-BE49-F238E27FC236}">
                <a16:creationId xmlns:a16="http://schemas.microsoft.com/office/drawing/2014/main" id="{E2D04540-CC4C-A691-BD16-47EEEDACD7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66401" y="4893121"/>
            <a:ext cx="7694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6" name="Rectangle 341">
            <a:extLst>
              <a:ext uri="{FF2B5EF4-FFF2-40B4-BE49-F238E27FC236}">
                <a16:creationId xmlns:a16="http://schemas.microsoft.com/office/drawing/2014/main" id="{C7FD8E27-94C4-BD15-2E09-8B3C6FAE98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29365" y="4893121"/>
            <a:ext cx="7694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7" name="Rectangle 342">
            <a:extLst>
              <a:ext uri="{FF2B5EF4-FFF2-40B4-BE49-F238E27FC236}">
                <a16:creationId xmlns:a16="http://schemas.microsoft.com/office/drawing/2014/main" id="{F16B1D98-6553-B3DF-98F8-399E382AE1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2329" y="4893121"/>
            <a:ext cx="7694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9" name="Rectangle 343">
            <a:extLst>
              <a:ext uri="{FF2B5EF4-FFF2-40B4-BE49-F238E27FC236}">
                <a16:creationId xmlns:a16="http://schemas.microsoft.com/office/drawing/2014/main" id="{602F3E46-4A23-5E58-C20F-92EA3BFB42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55293" y="4893121"/>
            <a:ext cx="7694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2" name="Rectangle 344">
            <a:extLst>
              <a:ext uri="{FF2B5EF4-FFF2-40B4-BE49-F238E27FC236}">
                <a16:creationId xmlns:a16="http://schemas.microsoft.com/office/drawing/2014/main" id="{0711052A-4544-9552-8B6F-A9B59EC703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18257" y="4893121"/>
            <a:ext cx="7694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3" name="Rectangle 345">
            <a:extLst>
              <a:ext uri="{FF2B5EF4-FFF2-40B4-BE49-F238E27FC236}">
                <a16:creationId xmlns:a16="http://schemas.microsoft.com/office/drawing/2014/main" id="{315C4A4C-6781-75C3-913C-95D93CC682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81221" y="4893121"/>
            <a:ext cx="7694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4" name="Rectangle 346">
            <a:extLst>
              <a:ext uri="{FF2B5EF4-FFF2-40B4-BE49-F238E27FC236}">
                <a16:creationId xmlns:a16="http://schemas.microsoft.com/office/drawing/2014/main" id="{14BA981C-F891-B174-F8E8-D7788C776A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44183" y="4893121"/>
            <a:ext cx="7694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5" name="Rectangle 150">
            <a:extLst>
              <a:ext uri="{FF2B5EF4-FFF2-40B4-BE49-F238E27FC236}">
                <a16:creationId xmlns:a16="http://schemas.microsoft.com/office/drawing/2014/main" id="{3CB6CAE5-8AC7-85A3-1393-F9568385E7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8389" y="5076857"/>
            <a:ext cx="1380827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Year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s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after allo-HSCT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25" name="Rectangle 339">
            <a:extLst>
              <a:ext uri="{FF2B5EF4-FFF2-40B4-BE49-F238E27FC236}">
                <a16:creationId xmlns:a16="http://schemas.microsoft.com/office/drawing/2014/main" id="{EFBED591-4BE9-32C7-F406-7410B88CD8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3913" y="4893121"/>
            <a:ext cx="7694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6" name="Rectangle 340">
            <a:extLst>
              <a:ext uri="{FF2B5EF4-FFF2-40B4-BE49-F238E27FC236}">
                <a16:creationId xmlns:a16="http://schemas.microsoft.com/office/drawing/2014/main" id="{41D1ABBB-F026-16DD-C268-74868F2402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96876" y="4893121"/>
            <a:ext cx="7694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4" name="Rectangle 341">
            <a:extLst>
              <a:ext uri="{FF2B5EF4-FFF2-40B4-BE49-F238E27FC236}">
                <a16:creationId xmlns:a16="http://schemas.microsoft.com/office/drawing/2014/main" id="{B55C9B9D-7038-B323-DAA2-7D5B214D9E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9839" y="4893121"/>
            <a:ext cx="7694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5" name="Rectangle 342">
            <a:extLst>
              <a:ext uri="{FF2B5EF4-FFF2-40B4-BE49-F238E27FC236}">
                <a16:creationId xmlns:a16="http://schemas.microsoft.com/office/drawing/2014/main" id="{C0D110C1-667A-5E7F-F61B-191C9E5B4F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22802" y="4893121"/>
            <a:ext cx="7694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6" name="Rectangle 343">
            <a:extLst>
              <a:ext uri="{FF2B5EF4-FFF2-40B4-BE49-F238E27FC236}">
                <a16:creationId xmlns:a16="http://schemas.microsoft.com/office/drawing/2014/main" id="{6D901D74-2399-EAA4-1289-757C3193FF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85765" y="4893121"/>
            <a:ext cx="7694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7" name="Rectangle 344">
            <a:extLst>
              <a:ext uri="{FF2B5EF4-FFF2-40B4-BE49-F238E27FC236}">
                <a16:creationId xmlns:a16="http://schemas.microsoft.com/office/drawing/2014/main" id="{1A5A9E34-0E4A-055B-EB3B-7F35CC4660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48728" y="4893121"/>
            <a:ext cx="7694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8" name="Rectangle 345">
            <a:extLst>
              <a:ext uri="{FF2B5EF4-FFF2-40B4-BE49-F238E27FC236}">
                <a16:creationId xmlns:a16="http://schemas.microsoft.com/office/drawing/2014/main" id="{C6CC0A1A-465E-4623-EC2A-C799AD4A0F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11691" y="4893121"/>
            <a:ext cx="7694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9" name="Rectangle 346">
            <a:extLst>
              <a:ext uri="{FF2B5EF4-FFF2-40B4-BE49-F238E27FC236}">
                <a16:creationId xmlns:a16="http://schemas.microsoft.com/office/drawing/2014/main" id="{6BA78DFC-A64A-6BAF-243D-0684D37A6B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74656" y="4893121"/>
            <a:ext cx="7694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0" name="Rectangle 150">
            <a:extLst>
              <a:ext uri="{FF2B5EF4-FFF2-40B4-BE49-F238E27FC236}">
                <a16:creationId xmlns:a16="http://schemas.microsoft.com/office/drawing/2014/main" id="{754CEE23-CDB2-5689-D717-4E2FC5F989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99809" y="5076857"/>
            <a:ext cx="1380827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Year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s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after allo-HSCT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0" name="Line 153">
            <a:extLst>
              <a:ext uri="{FF2B5EF4-FFF2-40B4-BE49-F238E27FC236}">
                <a16:creationId xmlns:a16="http://schemas.microsoft.com/office/drawing/2014/main" id="{7F9F6C02-A90E-BB56-4F3A-9CC207620385}"/>
              </a:ext>
            </a:extLst>
          </p:cNvPr>
          <p:cNvSpPr>
            <a:spLocks noChangeShapeType="1"/>
          </p:cNvSpPr>
          <p:nvPr/>
        </p:nvSpPr>
        <p:spPr bwMode="auto">
          <a:xfrm>
            <a:off x="1584381" y="1691582"/>
            <a:ext cx="18000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1" name="Line 154">
            <a:extLst>
              <a:ext uri="{FF2B5EF4-FFF2-40B4-BE49-F238E27FC236}">
                <a16:creationId xmlns:a16="http://schemas.microsoft.com/office/drawing/2014/main" id="{E73D88DA-EC54-E3EB-56D8-6630083694B2}"/>
              </a:ext>
            </a:extLst>
          </p:cNvPr>
          <p:cNvSpPr>
            <a:spLocks noChangeShapeType="1"/>
          </p:cNvSpPr>
          <p:nvPr/>
        </p:nvSpPr>
        <p:spPr bwMode="auto">
          <a:xfrm>
            <a:off x="1584381" y="1825711"/>
            <a:ext cx="18000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2" name="Rectangle 339">
            <a:extLst>
              <a:ext uri="{FF2B5EF4-FFF2-40B4-BE49-F238E27FC236}">
                <a16:creationId xmlns:a16="http://schemas.microsoft.com/office/drawing/2014/main" id="{008693F0-5DEA-5F95-3302-327B74B389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30086" y="1621320"/>
            <a:ext cx="153888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R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Rectangle 339">
            <a:extLst>
              <a:ext uri="{FF2B5EF4-FFF2-40B4-BE49-F238E27FC236}">
                <a16:creationId xmlns:a16="http://schemas.microsoft.com/office/drawing/2014/main" id="{8693D05A-F270-B785-D583-C25716723F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30086" y="1759428"/>
            <a:ext cx="391133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on-CR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Line 153">
            <a:extLst>
              <a:ext uri="{FF2B5EF4-FFF2-40B4-BE49-F238E27FC236}">
                <a16:creationId xmlns:a16="http://schemas.microsoft.com/office/drawing/2014/main" id="{E4E6E65A-DEF8-730D-A699-D03EA6C01838}"/>
              </a:ext>
            </a:extLst>
          </p:cNvPr>
          <p:cNvSpPr>
            <a:spLocks noChangeShapeType="1"/>
          </p:cNvSpPr>
          <p:nvPr/>
        </p:nvSpPr>
        <p:spPr bwMode="auto">
          <a:xfrm>
            <a:off x="5182504" y="1691110"/>
            <a:ext cx="18000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" name="Line 154">
            <a:extLst>
              <a:ext uri="{FF2B5EF4-FFF2-40B4-BE49-F238E27FC236}">
                <a16:creationId xmlns:a16="http://schemas.microsoft.com/office/drawing/2014/main" id="{E0E0841A-DA9A-4EEC-558C-32DAC0B22E5B}"/>
              </a:ext>
            </a:extLst>
          </p:cNvPr>
          <p:cNvSpPr>
            <a:spLocks noChangeShapeType="1"/>
          </p:cNvSpPr>
          <p:nvPr/>
        </p:nvSpPr>
        <p:spPr bwMode="auto">
          <a:xfrm>
            <a:off x="5182504" y="1825239"/>
            <a:ext cx="18000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" name="Rectangle 339">
            <a:extLst>
              <a:ext uri="{FF2B5EF4-FFF2-40B4-BE49-F238E27FC236}">
                <a16:creationId xmlns:a16="http://schemas.microsoft.com/office/drawing/2014/main" id="{20F4C510-4E93-B75B-4EC3-E318987257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28209" y="1620848"/>
            <a:ext cx="153888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Rectangle 339">
            <a:extLst>
              <a:ext uri="{FF2B5EF4-FFF2-40B4-BE49-F238E27FC236}">
                <a16:creationId xmlns:a16="http://schemas.microsoft.com/office/drawing/2014/main" id="{0F2C2FC1-FB1A-9E55-CDBA-C1AC97F31E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28209" y="1758956"/>
            <a:ext cx="391133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on-CR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Line 153">
            <a:extLst>
              <a:ext uri="{FF2B5EF4-FFF2-40B4-BE49-F238E27FC236}">
                <a16:creationId xmlns:a16="http://schemas.microsoft.com/office/drawing/2014/main" id="{E9DE399C-FDCD-EE7A-1E40-B1400123A763}"/>
              </a:ext>
            </a:extLst>
          </p:cNvPr>
          <p:cNvSpPr>
            <a:spLocks noChangeShapeType="1"/>
          </p:cNvSpPr>
          <p:nvPr/>
        </p:nvSpPr>
        <p:spPr bwMode="auto">
          <a:xfrm>
            <a:off x="1583250" y="3774713"/>
            <a:ext cx="18000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" name="Line 154">
            <a:extLst>
              <a:ext uri="{FF2B5EF4-FFF2-40B4-BE49-F238E27FC236}">
                <a16:creationId xmlns:a16="http://schemas.microsoft.com/office/drawing/2014/main" id="{6CE36EEA-0213-42DC-1AAE-F2A87F94763B}"/>
              </a:ext>
            </a:extLst>
          </p:cNvPr>
          <p:cNvSpPr>
            <a:spLocks noChangeShapeType="1"/>
          </p:cNvSpPr>
          <p:nvPr/>
        </p:nvSpPr>
        <p:spPr bwMode="auto">
          <a:xfrm>
            <a:off x="1583250" y="3911223"/>
            <a:ext cx="18000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" name="Rectangle 339">
            <a:extLst>
              <a:ext uri="{FF2B5EF4-FFF2-40B4-BE49-F238E27FC236}">
                <a16:creationId xmlns:a16="http://schemas.microsoft.com/office/drawing/2014/main" id="{20032B6F-708D-51B8-46CC-A10E7A320D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28955" y="3704451"/>
            <a:ext cx="153888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R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Rectangle 339">
            <a:extLst>
              <a:ext uri="{FF2B5EF4-FFF2-40B4-BE49-F238E27FC236}">
                <a16:creationId xmlns:a16="http://schemas.microsoft.com/office/drawing/2014/main" id="{BA079CBA-71F1-7B76-BB07-29567AE7CF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28955" y="3844940"/>
            <a:ext cx="391133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n-CR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Line 153">
            <a:extLst>
              <a:ext uri="{FF2B5EF4-FFF2-40B4-BE49-F238E27FC236}">
                <a16:creationId xmlns:a16="http://schemas.microsoft.com/office/drawing/2014/main" id="{28667CF6-7C28-BA45-2B11-E363BAC030C0}"/>
              </a:ext>
            </a:extLst>
          </p:cNvPr>
          <p:cNvSpPr>
            <a:spLocks noChangeShapeType="1"/>
          </p:cNvSpPr>
          <p:nvPr/>
        </p:nvSpPr>
        <p:spPr bwMode="auto">
          <a:xfrm>
            <a:off x="5182751" y="3774713"/>
            <a:ext cx="18000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6" name="Line 154">
            <a:extLst>
              <a:ext uri="{FF2B5EF4-FFF2-40B4-BE49-F238E27FC236}">
                <a16:creationId xmlns:a16="http://schemas.microsoft.com/office/drawing/2014/main" id="{D6456BE9-B527-02C8-5EAC-32185E4FA747}"/>
              </a:ext>
            </a:extLst>
          </p:cNvPr>
          <p:cNvSpPr>
            <a:spLocks noChangeShapeType="1"/>
          </p:cNvSpPr>
          <p:nvPr/>
        </p:nvSpPr>
        <p:spPr bwMode="auto">
          <a:xfrm>
            <a:off x="5182751" y="3911223"/>
            <a:ext cx="18000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8" name="Rectangle 339">
            <a:extLst>
              <a:ext uri="{FF2B5EF4-FFF2-40B4-BE49-F238E27FC236}">
                <a16:creationId xmlns:a16="http://schemas.microsoft.com/office/drawing/2014/main" id="{1D85B13C-84CC-8A9A-2FA1-291048F437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28456" y="3704451"/>
            <a:ext cx="153888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9" name="Rectangle 339">
            <a:extLst>
              <a:ext uri="{FF2B5EF4-FFF2-40B4-BE49-F238E27FC236}">
                <a16:creationId xmlns:a16="http://schemas.microsoft.com/office/drawing/2014/main" id="{DED9CA52-FB28-8437-5DF2-08A1D9115B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28456" y="3844940"/>
            <a:ext cx="391133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on-CR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Rectangle 150">
            <a:extLst>
              <a:ext uri="{FF2B5EF4-FFF2-40B4-BE49-F238E27FC236}">
                <a16:creationId xmlns:a16="http://schemas.microsoft.com/office/drawing/2014/main" id="{1312E6A4-F4FB-B1E6-B52D-3E81644190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66412" y="313896"/>
            <a:ext cx="195566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OS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7" name="Rectangle 150">
            <a:extLst>
              <a:ext uri="{FF2B5EF4-FFF2-40B4-BE49-F238E27FC236}">
                <a16:creationId xmlns:a16="http://schemas.microsoft.com/office/drawing/2014/main" id="{7F7CF104-ED3A-6537-C0B1-40A48A71D0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57868" y="313896"/>
            <a:ext cx="272510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RFS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8" name="Rectangle 150">
            <a:extLst>
              <a:ext uri="{FF2B5EF4-FFF2-40B4-BE49-F238E27FC236}">
                <a16:creationId xmlns:a16="http://schemas.microsoft.com/office/drawing/2014/main" id="{58C15E10-D1AA-E456-6BA2-03391928D7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19738" y="3357361"/>
            <a:ext cx="488915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Relapse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9" name="Rectangle 150">
            <a:extLst>
              <a:ext uri="{FF2B5EF4-FFF2-40B4-BE49-F238E27FC236}">
                <a16:creationId xmlns:a16="http://schemas.microsoft.com/office/drawing/2014/main" id="{934331C4-C209-D86C-EDF5-34530C8763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18111" y="3357638"/>
            <a:ext cx="349455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NRM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54" name="Group 4">
            <a:extLst>
              <a:ext uri="{FF2B5EF4-FFF2-40B4-BE49-F238E27FC236}">
                <a16:creationId xmlns:a16="http://schemas.microsoft.com/office/drawing/2014/main" id="{23867829-50A0-4BA9-BBB3-FB85B9A4BD38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626641" y="523360"/>
            <a:ext cx="2025650" cy="1471613"/>
            <a:chOff x="-1684" y="264"/>
            <a:chExt cx="1276" cy="927"/>
          </a:xfrm>
        </p:grpSpPr>
        <p:sp>
          <p:nvSpPr>
            <p:cNvPr id="1380" name="Line 5">
              <a:extLst>
                <a:ext uri="{FF2B5EF4-FFF2-40B4-BE49-F238E27FC236}">
                  <a16:creationId xmlns:a16="http://schemas.microsoft.com/office/drawing/2014/main" id="{0BC46415-1A8B-CD1E-BF32-97A7AE03FD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613" y="1173"/>
              <a:ext cx="1159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1" name="Line 6">
              <a:extLst>
                <a:ext uri="{FF2B5EF4-FFF2-40B4-BE49-F238E27FC236}">
                  <a16:creationId xmlns:a16="http://schemas.microsoft.com/office/drawing/2014/main" id="{539D0408-BF94-2159-6E58-844AB64C0A7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613" y="1173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2" name="Line 7">
              <a:extLst>
                <a:ext uri="{FF2B5EF4-FFF2-40B4-BE49-F238E27FC236}">
                  <a16:creationId xmlns:a16="http://schemas.microsoft.com/office/drawing/2014/main" id="{85F3BF1F-4485-29D1-107B-AAC91BEE97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448" y="1173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0" name="Line 8">
              <a:extLst>
                <a:ext uri="{FF2B5EF4-FFF2-40B4-BE49-F238E27FC236}">
                  <a16:creationId xmlns:a16="http://schemas.microsoft.com/office/drawing/2014/main" id="{730CD04B-87A3-A424-E3F2-6851E7F111F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283" y="1173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1" name="Line 9">
              <a:extLst>
                <a:ext uri="{FF2B5EF4-FFF2-40B4-BE49-F238E27FC236}">
                  <a16:creationId xmlns:a16="http://schemas.microsoft.com/office/drawing/2014/main" id="{3CCCB927-636D-8B4D-C686-F6FDF6C6CB9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118" y="1173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2" name="Line 10">
              <a:extLst>
                <a:ext uri="{FF2B5EF4-FFF2-40B4-BE49-F238E27FC236}">
                  <a16:creationId xmlns:a16="http://schemas.microsoft.com/office/drawing/2014/main" id="{08E21B21-8F6C-EE16-E174-BE21EE88B52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953" y="1173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3" name="Line 11">
              <a:extLst>
                <a:ext uri="{FF2B5EF4-FFF2-40B4-BE49-F238E27FC236}">
                  <a16:creationId xmlns:a16="http://schemas.microsoft.com/office/drawing/2014/main" id="{1BCC9F45-83FA-B154-6B11-B346BBDE1D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785" y="1173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4" name="Line 12">
              <a:extLst>
                <a:ext uri="{FF2B5EF4-FFF2-40B4-BE49-F238E27FC236}">
                  <a16:creationId xmlns:a16="http://schemas.microsoft.com/office/drawing/2014/main" id="{6DD14F9A-79A4-80DF-FD3C-B3EC0428D2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620" y="1173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5" name="Line 13">
              <a:extLst>
                <a:ext uri="{FF2B5EF4-FFF2-40B4-BE49-F238E27FC236}">
                  <a16:creationId xmlns:a16="http://schemas.microsoft.com/office/drawing/2014/main" id="{C51040EC-385D-29E2-436A-6285BBAE4A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454" y="1173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7" name="Line 22">
              <a:extLst>
                <a:ext uri="{FF2B5EF4-FFF2-40B4-BE49-F238E27FC236}">
                  <a16:creationId xmlns:a16="http://schemas.microsoft.com/office/drawing/2014/main" id="{FC79DC2F-2ACB-A97A-9FA2-78048696B39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660" y="298"/>
              <a:ext cx="0" cy="84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8" name="Line 23">
              <a:extLst>
                <a:ext uri="{FF2B5EF4-FFF2-40B4-BE49-F238E27FC236}">
                  <a16:creationId xmlns:a16="http://schemas.microsoft.com/office/drawing/2014/main" id="{CD891E2B-7C99-4D98-D85E-85EEC8F4281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684" y="1139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9" name="Line 24">
              <a:extLst>
                <a:ext uri="{FF2B5EF4-FFF2-40B4-BE49-F238E27FC236}">
                  <a16:creationId xmlns:a16="http://schemas.microsoft.com/office/drawing/2014/main" id="{11A3B835-7EE7-16E8-60AC-F98A941D42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684" y="971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0" name="Line 25">
              <a:extLst>
                <a:ext uri="{FF2B5EF4-FFF2-40B4-BE49-F238E27FC236}">
                  <a16:creationId xmlns:a16="http://schemas.microsoft.com/office/drawing/2014/main" id="{11002D07-DF10-A77C-04F0-A1C530430C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684" y="803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1" name="Line 26">
              <a:extLst>
                <a:ext uri="{FF2B5EF4-FFF2-40B4-BE49-F238E27FC236}">
                  <a16:creationId xmlns:a16="http://schemas.microsoft.com/office/drawing/2014/main" id="{6E84923F-5CE7-8817-FEB5-2847A2D64C7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684" y="635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2" name="Line 27">
              <a:extLst>
                <a:ext uri="{FF2B5EF4-FFF2-40B4-BE49-F238E27FC236}">
                  <a16:creationId xmlns:a16="http://schemas.microsoft.com/office/drawing/2014/main" id="{0C76E263-661B-491A-E964-C37177BF45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684" y="467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3" name="Line 28">
              <a:extLst>
                <a:ext uri="{FF2B5EF4-FFF2-40B4-BE49-F238E27FC236}">
                  <a16:creationId xmlns:a16="http://schemas.microsoft.com/office/drawing/2014/main" id="{586B119B-626F-896C-4720-448C4C8DD0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684" y="298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5" name="Freeform 35">
              <a:extLst>
                <a:ext uri="{FF2B5EF4-FFF2-40B4-BE49-F238E27FC236}">
                  <a16:creationId xmlns:a16="http://schemas.microsoft.com/office/drawing/2014/main" id="{76E00221-DE81-FB25-3007-EFA0683C7B8A}"/>
                </a:ext>
              </a:extLst>
            </p:cNvPr>
            <p:cNvSpPr>
              <a:spLocks/>
            </p:cNvSpPr>
            <p:nvPr/>
          </p:nvSpPr>
          <p:spPr bwMode="auto">
            <a:xfrm>
              <a:off x="-1660" y="264"/>
              <a:ext cx="1252" cy="909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451" name="Group 184">
            <a:extLst>
              <a:ext uri="{FF2B5EF4-FFF2-40B4-BE49-F238E27FC236}">
                <a16:creationId xmlns:a16="http://schemas.microsoft.com/office/drawing/2014/main" id="{50092A8D-DAF9-C014-83A5-E2549391B70F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633183" y="3401476"/>
            <a:ext cx="2025650" cy="1471613"/>
            <a:chOff x="-1700" y="2150"/>
            <a:chExt cx="1276" cy="927"/>
          </a:xfrm>
        </p:grpSpPr>
        <p:sp>
          <p:nvSpPr>
            <p:cNvPr id="1455" name="Line 185">
              <a:extLst>
                <a:ext uri="{FF2B5EF4-FFF2-40B4-BE49-F238E27FC236}">
                  <a16:creationId xmlns:a16="http://schemas.microsoft.com/office/drawing/2014/main" id="{FEC3EF0C-A47D-1639-9BAA-D6464BC0D2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629" y="3059"/>
              <a:ext cx="1159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56" name="Line 186">
              <a:extLst>
                <a:ext uri="{FF2B5EF4-FFF2-40B4-BE49-F238E27FC236}">
                  <a16:creationId xmlns:a16="http://schemas.microsoft.com/office/drawing/2014/main" id="{BD787522-3645-80B5-92BB-21E6E906E78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629" y="3059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57" name="Line 187">
              <a:extLst>
                <a:ext uri="{FF2B5EF4-FFF2-40B4-BE49-F238E27FC236}">
                  <a16:creationId xmlns:a16="http://schemas.microsoft.com/office/drawing/2014/main" id="{4A98C090-FECD-A4A2-A09E-0D81C73F0C9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464" y="3059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58" name="Line 188">
              <a:extLst>
                <a:ext uri="{FF2B5EF4-FFF2-40B4-BE49-F238E27FC236}">
                  <a16:creationId xmlns:a16="http://schemas.microsoft.com/office/drawing/2014/main" id="{BCF20AAE-E649-96FE-8D3C-743FEEB3717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299" y="3059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59" name="Line 189">
              <a:extLst>
                <a:ext uri="{FF2B5EF4-FFF2-40B4-BE49-F238E27FC236}">
                  <a16:creationId xmlns:a16="http://schemas.microsoft.com/office/drawing/2014/main" id="{AA189717-221C-4620-9526-0900F0CCCE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134" y="3059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0" name="Line 190">
              <a:extLst>
                <a:ext uri="{FF2B5EF4-FFF2-40B4-BE49-F238E27FC236}">
                  <a16:creationId xmlns:a16="http://schemas.microsoft.com/office/drawing/2014/main" id="{8D802993-BFE9-479F-0488-5E7B940A5CF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969" y="3059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1" name="Line 191">
              <a:extLst>
                <a:ext uri="{FF2B5EF4-FFF2-40B4-BE49-F238E27FC236}">
                  <a16:creationId xmlns:a16="http://schemas.microsoft.com/office/drawing/2014/main" id="{542B4E19-1943-3D2A-62E2-FEDC0EC132B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801" y="3059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2" name="Line 192">
              <a:extLst>
                <a:ext uri="{FF2B5EF4-FFF2-40B4-BE49-F238E27FC236}">
                  <a16:creationId xmlns:a16="http://schemas.microsoft.com/office/drawing/2014/main" id="{7EFE30D4-D087-E058-B701-8E5B883097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636" y="3059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3" name="Line 193">
              <a:extLst>
                <a:ext uri="{FF2B5EF4-FFF2-40B4-BE49-F238E27FC236}">
                  <a16:creationId xmlns:a16="http://schemas.microsoft.com/office/drawing/2014/main" id="{D22B4E4B-6086-11AA-8371-4C856A9D06D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470" y="3059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4" name="Line 202">
              <a:extLst>
                <a:ext uri="{FF2B5EF4-FFF2-40B4-BE49-F238E27FC236}">
                  <a16:creationId xmlns:a16="http://schemas.microsoft.com/office/drawing/2014/main" id="{D5BEF26C-CB90-9801-CF28-6D33DF9B56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676" y="2184"/>
              <a:ext cx="0" cy="84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5" name="Line 203">
              <a:extLst>
                <a:ext uri="{FF2B5EF4-FFF2-40B4-BE49-F238E27FC236}">
                  <a16:creationId xmlns:a16="http://schemas.microsoft.com/office/drawing/2014/main" id="{10229A3C-8202-CBBF-3199-7D29FD1A18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700" y="3025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6" name="Line 204">
              <a:extLst>
                <a:ext uri="{FF2B5EF4-FFF2-40B4-BE49-F238E27FC236}">
                  <a16:creationId xmlns:a16="http://schemas.microsoft.com/office/drawing/2014/main" id="{800AD249-4FC3-DC84-173A-3E620AB9F07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700" y="2857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7" name="Line 205">
              <a:extLst>
                <a:ext uri="{FF2B5EF4-FFF2-40B4-BE49-F238E27FC236}">
                  <a16:creationId xmlns:a16="http://schemas.microsoft.com/office/drawing/2014/main" id="{9E302C6B-7C3E-DCA5-2690-A4CBF57FA9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700" y="2689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8" name="Line 206">
              <a:extLst>
                <a:ext uri="{FF2B5EF4-FFF2-40B4-BE49-F238E27FC236}">
                  <a16:creationId xmlns:a16="http://schemas.microsoft.com/office/drawing/2014/main" id="{C6A95BD1-57DC-F559-02A6-723E96329B6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700" y="2521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9" name="Line 207">
              <a:extLst>
                <a:ext uri="{FF2B5EF4-FFF2-40B4-BE49-F238E27FC236}">
                  <a16:creationId xmlns:a16="http://schemas.microsoft.com/office/drawing/2014/main" id="{88A965C8-C88F-7EB8-F23E-39E0C717B57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700" y="2353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70" name="Line 208">
              <a:extLst>
                <a:ext uri="{FF2B5EF4-FFF2-40B4-BE49-F238E27FC236}">
                  <a16:creationId xmlns:a16="http://schemas.microsoft.com/office/drawing/2014/main" id="{F172904C-EAD6-05B9-C1FD-376B51A92D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700" y="2184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71" name="Freeform 215">
              <a:extLst>
                <a:ext uri="{FF2B5EF4-FFF2-40B4-BE49-F238E27FC236}">
                  <a16:creationId xmlns:a16="http://schemas.microsoft.com/office/drawing/2014/main" id="{A4453FFB-24CC-0720-F8CD-E6FAA771334A}"/>
                </a:ext>
              </a:extLst>
            </p:cNvPr>
            <p:cNvSpPr>
              <a:spLocks/>
            </p:cNvSpPr>
            <p:nvPr/>
          </p:nvSpPr>
          <p:spPr bwMode="auto">
            <a:xfrm>
              <a:off x="-1676" y="2150"/>
              <a:ext cx="1252" cy="909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273" name="Group 98">
            <a:extLst>
              <a:ext uri="{FF2B5EF4-FFF2-40B4-BE49-F238E27FC236}">
                <a16:creationId xmlns:a16="http://schemas.microsoft.com/office/drawing/2014/main" id="{DE5506A3-05DA-1CC0-E5A9-EF42F5EFCF51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649837" y="271153"/>
            <a:ext cx="3240088" cy="2700338"/>
            <a:chOff x="4522" y="214"/>
            <a:chExt cx="2041" cy="1701"/>
          </a:xfrm>
        </p:grpSpPr>
        <p:sp>
          <p:nvSpPr>
            <p:cNvPr id="279" name="AutoShape 97">
              <a:extLst>
                <a:ext uri="{FF2B5EF4-FFF2-40B4-BE49-F238E27FC236}">
                  <a16:creationId xmlns:a16="http://schemas.microsoft.com/office/drawing/2014/main" id="{26135D52-BB0F-1E28-8EBA-011C25009232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4522" y="214"/>
              <a:ext cx="2041" cy="17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8" name="Line 99">
              <a:extLst>
                <a:ext uri="{FF2B5EF4-FFF2-40B4-BE49-F238E27FC236}">
                  <a16:creationId xmlns:a16="http://schemas.microsoft.com/office/drawing/2014/main" id="{DEECC63C-841E-EFCC-B197-01A460E92C2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53" y="1281"/>
              <a:ext cx="1159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0" name="Line 100">
              <a:extLst>
                <a:ext uri="{FF2B5EF4-FFF2-40B4-BE49-F238E27FC236}">
                  <a16:creationId xmlns:a16="http://schemas.microsoft.com/office/drawing/2014/main" id="{D5F06BEA-E6BD-796D-83D7-CDB978ABD9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53" y="1281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2" name="Line 101">
              <a:extLst>
                <a:ext uri="{FF2B5EF4-FFF2-40B4-BE49-F238E27FC236}">
                  <a16:creationId xmlns:a16="http://schemas.microsoft.com/office/drawing/2014/main" id="{88CC48CA-F254-8D99-9D29-02A04F324F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18" y="1281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4" name="Line 102">
              <a:extLst>
                <a:ext uri="{FF2B5EF4-FFF2-40B4-BE49-F238E27FC236}">
                  <a16:creationId xmlns:a16="http://schemas.microsoft.com/office/drawing/2014/main" id="{A7836E10-C59E-455A-9C14-FC7F45D19E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83" y="1281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5" name="Line 103">
              <a:extLst>
                <a:ext uri="{FF2B5EF4-FFF2-40B4-BE49-F238E27FC236}">
                  <a16:creationId xmlns:a16="http://schemas.microsoft.com/office/drawing/2014/main" id="{D7C33461-B4C4-70BA-77D4-BE70D04568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48" y="1281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6" name="Line 104">
              <a:extLst>
                <a:ext uri="{FF2B5EF4-FFF2-40B4-BE49-F238E27FC236}">
                  <a16:creationId xmlns:a16="http://schemas.microsoft.com/office/drawing/2014/main" id="{65B9155D-50B1-00FA-F57D-6BB429BB15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13" y="1281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7" name="Line 105">
              <a:extLst>
                <a:ext uri="{FF2B5EF4-FFF2-40B4-BE49-F238E27FC236}">
                  <a16:creationId xmlns:a16="http://schemas.microsoft.com/office/drawing/2014/main" id="{1BACFC4B-0B8F-D8B6-77E2-DFFB1644F4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81" y="1281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8" name="Line 106">
              <a:extLst>
                <a:ext uri="{FF2B5EF4-FFF2-40B4-BE49-F238E27FC236}">
                  <a16:creationId xmlns:a16="http://schemas.microsoft.com/office/drawing/2014/main" id="{76DA5F8A-FCDE-75B2-A5AA-68370002455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46" y="1281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9" name="Line 107">
              <a:extLst>
                <a:ext uri="{FF2B5EF4-FFF2-40B4-BE49-F238E27FC236}">
                  <a16:creationId xmlns:a16="http://schemas.microsoft.com/office/drawing/2014/main" id="{8FFD5E94-FD0A-1162-86F0-EE8D003CDE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12" y="1281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0" name="Line 116">
              <a:extLst>
                <a:ext uri="{FF2B5EF4-FFF2-40B4-BE49-F238E27FC236}">
                  <a16:creationId xmlns:a16="http://schemas.microsoft.com/office/drawing/2014/main" id="{FC3253C2-DAEB-9879-C664-19B2AAAA8F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06" y="406"/>
              <a:ext cx="0" cy="84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1" name="Line 117">
              <a:extLst>
                <a:ext uri="{FF2B5EF4-FFF2-40B4-BE49-F238E27FC236}">
                  <a16:creationId xmlns:a16="http://schemas.microsoft.com/office/drawing/2014/main" id="{A4EEFE98-1877-D35D-6614-7D8BF5EF40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782" y="1247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2" name="Line 118">
              <a:extLst>
                <a:ext uri="{FF2B5EF4-FFF2-40B4-BE49-F238E27FC236}">
                  <a16:creationId xmlns:a16="http://schemas.microsoft.com/office/drawing/2014/main" id="{2D7B4AE4-DC98-6EAB-C7EE-3315F9A013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782" y="1079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3" name="Line 119">
              <a:extLst>
                <a:ext uri="{FF2B5EF4-FFF2-40B4-BE49-F238E27FC236}">
                  <a16:creationId xmlns:a16="http://schemas.microsoft.com/office/drawing/2014/main" id="{F07FD288-8C20-5F36-C30C-7C419A6B0B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782" y="911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4" name="Line 120">
              <a:extLst>
                <a:ext uri="{FF2B5EF4-FFF2-40B4-BE49-F238E27FC236}">
                  <a16:creationId xmlns:a16="http://schemas.microsoft.com/office/drawing/2014/main" id="{00A24C18-38E6-50D5-B84D-B8B25E820A1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782" y="743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5" name="Line 121">
              <a:extLst>
                <a:ext uri="{FF2B5EF4-FFF2-40B4-BE49-F238E27FC236}">
                  <a16:creationId xmlns:a16="http://schemas.microsoft.com/office/drawing/2014/main" id="{9E720445-061A-D417-EB7E-16E07CF32F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782" y="575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6" name="Line 122">
              <a:extLst>
                <a:ext uri="{FF2B5EF4-FFF2-40B4-BE49-F238E27FC236}">
                  <a16:creationId xmlns:a16="http://schemas.microsoft.com/office/drawing/2014/main" id="{E19C2468-1ED6-B6E7-EC12-2AF44BFF325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782" y="406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7" name="Freeform 129">
              <a:extLst>
                <a:ext uri="{FF2B5EF4-FFF2-40B4-BE49-F238E27FC236}">
                  <a16:creationId xmlns:a16="http://schemas.microsoft.com/office/drawing/2014/main" id="{E2BB6408-7C01-532A-3ED0-AE859929E91D}"/>
                </a:ext>
              </a:extLst>
            </p:cNvPr>
            <p:cNvSpPr>
              <a:spLocks/>
            </p:cNvSpPr>
            <p:nvPr/>
          </p:nvSpPr>
          <p:spPr bwMode="auto">
            <a:xfrm>
              <a:off x="4806" y="372"/>
              <a:ext cx="1252" cy="909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415" name="Group 300">
            <a:extLst>
              <a:ext uri="{FF2B5EF4-FFF2-40B4-BE49-F238E27FC236}">
                <a16:creationId xmlns:a16="http://schemas.microsoft.com/office/drawing/2014/main" id="{3C858216-B184-AA79-BFAC-D060924943C4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4059226" y="3402165"/>
            <a:ext cx="2025650" cy="1471612"/>
            <a:chOff x="4820" y="2241"/>
            <a:chExt cx="1276" cy="927"/>
          </a:xfrm>
        </p:grpSpPr>
        <p:sp>
          <p:nvSpPr>
            <p:cNvPr id="1291" name="Line 301">
              <a:extLst>
                <a:ext uri="{FF2B5EF4-FFF2-40B4-BE49-F238E27FC236}">
                  <a16:creationId xmlns:a16="http://schemas.microsoft.com/office/drawing/2014/main" id="{FFDD552B-A3E9-4242-3A6E-ACE770DF48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91" y="3150"/>
              <a:ext cx="1159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4" name="Line 302">
              <a:extLst>
                <a:ext uri="{FF2B5EF4-FFF2-40B4-BE49-F238E27FC236}">
                  <a16:creationId xmlns:a16="http://schemas.microsoft.com/office/drawing/2014/main" id="{D45D62CF-83E3-9DCE-7BCE-49F0929A335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91" y="3150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6" name="Line 303">
              <a:extLst>
                <a:ext uri="{FF2B5EF4-FFF2-40B4-BE49-F238E27FC236}">
                  <a16:creationId xmlns:a16="http://schemas.microsoft.com/office/drawing/2014/main" id="{B071EFCB-9A7B-7092-009A-8A0F8DE9467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56" y="3150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7" name="Line 304">
              <a:extLst>
                <a:ext uri="{FF2B5EF4-FFF2-40B4-BE49-F238E27FC236}">
                  <a16:creationId xmlns:a16="http://schemas.microsoft.com/office/drawing/2014/main" id="{F67D2B66-CDB9-8411-236E-5422998FB63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21" y="3150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8" name="Line 305">
              <a:extLst>
                <a:ext uri="{FF2B5EF4-FFF2-40B4-BE49-F238E27FC236}">
                  <a16:creationId xmlns:a16="http://schemas.microsoft.com/office/drawing/2014/main" id="{AC5F796E-9259-92C8-FCF0-50FE333C39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86" y="3150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9" name="Line 306">
              <a:extLst>
                <a:ext uri="{FF2B5EF4-FFF2-40B4-BE49-F238E27FC236}">
                  <a16:creationId xmlns:a16="http://schemas.microsoft.com/office/drawing/2014/main" id="{711DF043-02DB-E999-2F56-304DE034A76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51" y="3150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0" name="Line 307">
              <a:extLst>
                <a:ext uri="{FF2B5EF4-FFF2-40B4-BE49-F238E27FC236}">
                  <a16:creationId xmlns:a16="http://schemas.microsoft.com/office/drawing/2014/main" id="{C70F4884-E8DD-0815-55EB-EB5CF59E01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19" y="3150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8" name="Line 308">
              <a:extLst>
                <a:ext uri="{FF2B5EF4-FFF2-40B4-BE49-F238E27FC236}">
                  <a16:creationId xmlns:a16="http://schemas.microsoft.com/office/drawing/2014/main" id="{8D9D1339-EB44-1445-A973-2C60D632DE3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84" y="3150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9" name="Line 309">
              <a:extLst>
                <a:ext uri="{FF2B5EF4-FFF2-40B4-BE49-F238E27FC236}">
                  <a16:creationId xmlns:a16="http://schemas.microsoft.com/office/drawing/2014/main" id="{3CBA510F-FCFE-F42D-55F5-1902F1C002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50" y="3150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0" name="Line 318">
              <a:extLst>
                <a:ext uri="{FF2B5EF4-FFF2-40B4-BE49-F238E27FC236}">
                  <a16:creationId xmlns:a16="http://schemas.microsoft.com/office/drawing/2014/main" id="{F8574CB0-696A-D1C9-B16D-3BAA54EF3F5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44" y="2275"/>
              <a:ext cx="0" cy="84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1" name="Line 319">
              <a:extLst>
                <a:ext uri="{FF2B5EF4-FFF2-40B4-BE49-F238E27FC236}">
                  <a16:creationId xmlns:a16="http://schemas.microsoft.com/office/drawing/2014/main" id="{B056E33E-8AE7-34E9-F131-11843BD6FC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20" y="3116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2" name="Line 320">
              <a:extLst>
                <a:ext uri="{FF2B5EF4-FFF2-40B4-BE49-F238E27FC236}">
                  <a16:creationId xmlns:a16="http://schemas.microsoft.com/office/drawing/2014/main" id="{7617013F-37A0-075F-A625-B43EF812C5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20" y="2948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3" name="Line 321">
              <a:extLst>
                <a:ext uri="{FF2B5EF4-FFF2-40B4-BE49-F238E27FC236}">
                  <a16:creationId xmlns:a16="http://schemas.microsoft.com/office/drawing/2014/main" id="{93AFF5F9-D035-F39E-051D-59F9787F46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20" y="2780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5" name="Line 322">
              <a:extLst>
                <a:ext uri="{FF2B5EF4-FFF2-40B4-BE49-F238E27FC236}">
                  <a16:creationId xmlns:a16="http://schemas.microsoft.com/office/drawing/2014/main" id="{CC76D603-6DE5-F071-C852-3830DC55394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20" y="2612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6" name="Line 323">
              <a:extLst>
                <a:ext uri="{FF2B5EF4-FFF2-40B4-BE49-F238E27FC236}">
                  <a16:creationId xmlns:a16="http://schemas.microsoft.com/office/drawing/2014/main" id="{91B989AD-6B2C-FD7C-97EB-A02EA925EC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20" y="2444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0" name="Line 324">
              <a:extLst>
                <a:ext uri="{FF2B5EF4-FFF2-40B4-BE49-F238E27FC236}">
                  <a16:creationId xmlns:a16="http://schemas.microsoft.com/office/drawing/2014/main" id="{956ED6FA-6352-D976-1C7B-31FEC20326F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820" y="2275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3" name="Freeform 331">
              <a:extLst>
                <a:ext uri="{FF2B5EF4-FFF2-40B4-BE49-F238E27FC236}">
                  <a16:creationId xmlns:a16="http://schemas.microsoft.com/office/drawing/2014/main" id="{0CAA1BBA-8FDD-4562-F34A-DD88ED2991E9}"/>
                </a:ext>
              </a:extLst>
            </p:cNvPr>
            <p:cNvSpPr>
              <a:spLocks/>
            </p:cNvSpPr>
            <p:nvPr/>
          </p:nvSpPr>
          <p:spPr bwMode="auto">
            <a:xfrm>
              <a:off x="4844" y="2241"/>
              <a:ext cx="1252" cy="909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1497" name="Line 153">
            <a:extLst>
              <a:ext uri="{FF2B5EF4-FFF2-40B4-BE49-F238E27FC236}">
                <a16:creationId xmlns:a16="http://schemas.microsoft.com/office/drawing/2014/main" id="{1D1986C2-7140-E4BD-A809-DE82DCE838DC}"/>
              </a:ext>
            </a:extLst>
          </p:cNvPr>
          <p:cNvSpPr>
            <a:spLocks noChangeShapeType="1"/>
          </p:cNvSpPr>
          <p:nvPr/>
        </p:nvSpPr>
        <p:spPr bwMode="auto">
          <a:xfrm>
            <a:off x="432355" y="2587786"/>
            <a:ext cx="18000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8" name="Line 154">
            <a:extLst>
              <a:ext uri="{FF2B5EF4-FFF2-40B4-BE49-F238E27FC236}">
                <a16:creationId xmlns:a16="http://schemas.microsoft.com/office/drawing/2014/main" id="{F22940F5-B633-31FA-FBDB-0E5196C425A1}"/>
              </a:ext>
            </a:extLst>
          </p:cNvPr>
          <p:cNvSpPr>
            <a:spLocks noChangeShapeType="1"/>
          </p:cNvSpPr>
          <p:nvPr/>
        </p:nvSpPr>
        <p:spPr bwMode="auto">
          <a:xfrm>
            <a:off x="432355" y="2721915"/>
            <a:ext cx="18000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9" name="Line 153">
            <a:extLst>
              <a:ext uri="{FF2B5EF4-FFF2-40B4-BE49-F238E27FC236}">
                <a16:creationId xmlns:a16="http://schemas.microsoft.com/office/drawing/2014/main" id="{2F6E97BD-39D3-B59D-1BFE-8BFFEECB0E3E}"/>
              </a:ext>
            </a:extLst>
          </p:cNvPr>
          <p:cNvSpPr>
            <a:spLocks noChangeShapeType="1"/>
          </p:cNvSpPr>
          <p:nvPr/>
        </p:nvSpPr>
        <p:spPr bwMode="auto">
          <a:xfrm>
            <a:off x="432355" y="5471778"/>
            <a:ext cx="18000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00" name="Line 154">
            <a:extLst>
              <a:ext uri="{FF2B5EF4-FFF2-40B4-BE49-F238E27FC236}">
                <a16:creationId xmlns:a16="http://schemas.microsoft.com/office/drawing/2014/main" id="{B5AD7F37-2D62-665D-BD37-2A8C73E5D989}"/>
              </a:ext>
            </a:extLst>
          </p:cNvPr>
          <p:cNvSpPr>
            <a:spLocks noChangeShapeType="1"/>
          </p:cNvSpPr>
          <p:nvPr/>
        </p:nvSpPr>
        <p:spPr bwMode="auto">
          <a:xfrm>
            <a:off x="432355" y="5605907"/>
            <a:ext cx="18000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01" name="Line 153">
            <a:extLst>
              <a:ext uri="{FF2B5EF4-FFF2-40B4-BE49-F238E27FC236}">
                <a16:creationId xmlns:a16="http://schemas.microsoft.com/office/drawing/2014/main" id="{13A49990-1424-F192-2D03-1C80295E3AF4}"/>
              </a:ext>
            </a:extLst>
          </p:cNvPr>
          <p:cNvSpPr>
            <a:spLocks noChangeShapeType="1"/>
          </p:cNvSpPr>
          <p:nvPr/>
        </p:nvSpPr>
        <p:spPr bwMode="auto">
          <a:xfrm>
            <a:off x="3823718" y="2587786"/>
            <a:ext cx="18000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02" name="Line 154">
            <a:extLst>
              <a:ext uri="{FF2B5EF4-FFF2-40B4-BE49-F238E27FC236}">
                <a16:creationId xmlns:a16="http://schemas.microsoft.com/office/drawing/2014/main" id="{4FF7B27E-7458-EBF9-265F-1AA41C73EA4C}"/>
              </a:ext>
            </a:extLst>
          </p:cNvPr>
          <p:cNvSpPr>
            <a:spLocks noChangeShapeType="1"/>
          </p:cNvSpPr>
          <p:nvPr/>
        </p:nvSpPr>
        <p:spPr bwMode="auto">
          <a:xfrm>
            <a:off x="3823718" y="2721915"/>
            <a:ext cx="18000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03" name="Line 153">
            <a:extLst>
              <a:ext uri="{FF2B5EF4-FFF2-40B4-BE49-F238E27FC236}">
                <a16:creationId xmlns:a16="http://schemas.microsoft.com/office/drawing/2014/main" id="{58418F31-88FD-8027-1034-C7A6D835F029}"/>
              </a:ext>
            </a:extLst>
          </p:cNvPr>
          <p:cNvSpPr>
            <a:spLocks noChangeShapeType="1"/>
          </p:cNvSpPr>
          <p:nvPr/>
        </p:nvSpPr>
        <p:spPr bwMode="auto">
          <a:xfrm>
            <a:off x="3823718" y="5471778"/>
            <a:ext cx="18000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04" name="Line 154">
            <a:extLst>
              <a:ext uri="{FF2B5EF4-FFF2-40B4-BE49-F238E27FC236}">
                <a16:creationId xmlns:a16="http://schemas.microsoft.com/office/drawing/2014/main" id="{F838FF78-56E8-86C6-C6E2-D0C217E70021}"/>
              </a:ext>
            </a:extLst>
          </p:cNvPr>
          <p:cNvSpPr>
            <a:spLocks noChangeShapeType="1"/>
          </p:cNvSpPr>
          <p:nvPr/>
        </p:nvSpPr>
        <p:spPr bwMode="auto">
          <a:xfrm>
            <a:off x="3823718" y="5605907"/>
            <a:ext cx="18000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4" name="Line 41">
            <a:extLst>
              <a:ext uri="{FF2B5EF4-FFF2-40B4-BE49-F238E27FC236}">
                <a16:creationId xmlns:a16="http://schemas.microsoft.com/office/drawing/2014/main" id="{E064AF73-865D-EDAD-BBC1-770716F3752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504052" y="560421"/>
            <a:ext cx="0" cy="33337"/>
          </a:xfrm>
          <a:prstGeom prst="line">
            <a:avLst/>
          </a:prstGeom>
          <a:noFill/>
          <a:ln w="635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5" name="Line 46">
            <a:extLst>
              <a:ext uri="{FF2B5EF4-FFF2-40B4-BE49-F238E27FC236}">
                <a16:creationId xmlns:a16="http://schemas.microsoft.com/office/drawing/2014/main" id="{066FA078-C3B2-360F-4F77-881A1E18B44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153214" y="1123983"/>
            <a:ext cx="0" cy="31750"/>
          </a:xfrm>
          <a:prstGeom prst="line">
            <a:avLst/>
          </a:prstGeom>
          <a:noFill/>
          <a:ln w="635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5" name="Line 39">
            <a:extLst>
              <a:ext uri="{FF2B5EF4-FFF2-40B4-BE49-F238E27FC236}">
                <a16:creationId xmlns:a16="http://schemas.microsoft.com/office/drawing/2014/main" id="{B9AA0CA1-5296-8304-55FA-5F5FD14FD5E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578539" y="560421"/>
            <a:ext cx="0" cy="33337"/>
          </a:xfrm>
          <a:prstGeom prst="line">
            <a:avLst/>
          </a:prstGeom>
          <a:noFill/>
          <a:ln w="635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5" name="Line 40">
            <a:extLst>
              <a:ext uri="{FF2B5EF4-FFF2-40B4-BE49-F238E27FC236}">
                <a16:creationId xmlns:a16="http://schemas.microsoft.com/office/drawing/2014/main" id="{FB89A095-5D17-82D0-C2E6-B484E91574D0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015572" y="958003"/>
            <a:ext cx="0" cy="33338"/>
          </a:xfrm>
          <a:prstGeom prst="line">
            <a:avLst/>
          </a:prstGeom>
          <a:noFill/>
          <a:ln w="635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6" name="Freeform 43">
            <a:extLst>
              <a:ext uri="{FF2B5EF4-FFF2-40B4-BE49-F238E27FC236}">
                <a16:creationId xmlns:a16="http://schemas.microsoft.com/office/drawing/2014/main" id="{B516B38C-3DB4-CFF5-A795-559CD259977F}"/>
              </a:ext>
            </a:extLst>
          </p:cNvPr>
          <p:cNvSpPr>
            <a:spLocks/>
          </p:cNvSpPr>
          <p:nvPr/>
        </p:nvSpPr>
        <p:spPr bwMode="auto">
          <a:xfrm>
            <a:off x="4174197" y="575415"/>
            <a:ext cx="1839913" cy="630238"/>
          </a:xfrm>
          <a:custGeom>
            <a:avLst/>
            <a:gdLst>
              <a:gd name="T0" fmla="*/ 0 w 477"/>
              <a:gd name="T1" fmla="*/ 0 h 196"/>
              <a:gd name="T2" fmla="*/ 1 w 477"/>
              <a:gd name="T3" fmla="*/ 0 h 196"/>
              <a:gd name="T4" fmla="*/ 1 w 477"/>
              <a:gd name="T5" fmla="*/ 22 h 196"/>
              <a:gd name="T6" fmla="*/ 2 w 477"/>
              <a:gd name="T7" fmla="*/ 22 h 196"/>
              <a:gd name="T8" fmla="*/ 2 w 477"/>
              <a:gd name="T9" fmla="*/ 44 h 196"/>
              <a:gd name="T10" fmla="*/ 8 w 477"/>
              <a:gd name="T11" fmla="*/ 44 h 196"/>
              <a:gd name="T12" fmla="*/ 8 w 477"/>
              <a:gd name="T13" fmla="*/ 65 h 196"/>
              <a:gd name="T14" fmla="*/ 17 w 477"/>
              <a:gd name="T15" fmla="*/ 65 h 196"/>
              <a:gd name="T16" fmla="*/ 17 w 477"/>
              <a:gd name="T17" fmla="*/ 87 h 196"/>
              <a:gd name="T18" fmla="*/ 17 w 477"/>
              <a:gd name="T19" fmla="*/ 87 h 196"/>
              <a:gd name="T20" fmla="*/ 17 w 477"/>
              <a:gd name="T21" fmla="*/ 109 h 196"/>
              <a:gd name="T22" fmla="*/ 38 w 477"/>
              <a:gd name="T23" fmla="*/ 109 h 196"/>
              <a:gd name="T24" fmla="*/ 38 w 477"/>
              <a:gd name="T25" fmla="*/ 131 h 196"/>
              <a:gd name="T26" fmla="*/ 43 w 477"/>
              <a:gd name="T27" fmla="*/ 131 h 196"/>
              <a:gd name="T28" fmla="*/ 43 w 477"/>
              <a:gd name="T29" fmla="*/ 153 h 196"/>
              <a:gd name="T30" fmla="*/ 46 w 477"/>
              <a:gd name="T31" fmla="*/ 153 h 196"/>
              <a:gd name="T32" fmla="*/ 46 w 477"/>
              <a:gd name="T33" fmla="*/ 175 h 196"/>
              <a:gd name="T34" fmla="*/ 67 w 477"/>
              <a:gd name="T35" fmla="*/ 175 h 196"/>
              <a:gd name="T36" fmla="*/ 67 w 477"/>
              <a:gd name="T37" fmla="*/ 196 h 196"/>
              <a:gd name="T38" fmla="*/ 477 w 477"/>
              <a:gd name="T39" fmla="*/ 196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477" h="196">
                <a:moveTo>
                  <a:pt x="0" y="0"/>
                </a:moveTo>
                <a:lnTo>
                  <a:pt x="1" y="0"/>
                </a:lnTo>
                <a:lnTo>
                  <a:pt x="1" y="22"/>
                </a:lnTo>
                <a:lnTo>
                  <a:pt x="2" y="22"/>
                </a:lnTo>
                <a:lnTo>
                  <a:pt x="2" y="44"/>
                </a:lnTo>
                <a:lnTo>
                  <a:pt x="8" y="44"/>
                </a:lnTo>
                <a:lnTo>
                  <a:pt x="8" y="65"/>
                </a:lnTo>
                <a:lnTo>
                  <a:pt x="17" y="65"/>
                </a:lnTo>
                <a:lnTo>
                  <a:pt x="17" y="87"/>
                </a:lnTo>
                <a:lnTo>
                  <a:pt x="17" y="87"/>
                </a:lnTo>
                <a:lnTo>
                  <a:pt x="17" y="109"/>
                </a:lnTo>
                <a:lnTo>
                  <a:pt x="38" y="109"/>
                </a:lnTo>
                <a:lnTo>
                  <a:pt x="38" y="131"/>
                </a:lnTo>
                <a:lnTo>
                  <a:pt x="43" y="131"/>
                </a:lnTo>
                <a:lnTo>
                  <a:pt x="43" y="153"/>
                </a:lnTo>
                <a:lnTo>
                  <a:pt x="46" y="153"/>
                </a:lnTo>
                <a:lnTo>
                  <a:pt x="46" y="175"/>
                </a:lnTo>
                <a:lnTo>
                  <a:pt x="67" y="175"/>
                </a:lnTo>
                <a:lnTo>
                  <a:pt x="67" y="196"/>
                </a:lnTo>
                <a:lnTo>
                  <a:pt x="477" y="196"/>
                </a:lnTo>
              </a:path>
            </a:pathLst>
          </a:custGeom>
          <a:noFill/>
          <a:ln w="12700" cap="rnd">
            <a:solidFill>
              <a:schemeClr val="tx1"/>
            </a:solidFill>
            <a:prstDash val="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8" name="Line 44">
            <a:extLst>
              <a:ext uri="{FF2B5EF4-FFF2-40B4-BE49-F238E27FC236}">
                <a16:creationId xmlns:a16="http://schemas.microsoft.com/office/drawing/2014/main" id="{1CA7BFCA-89CC-7EC8-2212-75F01E2E2346}"/>
              </a:ext>
            </a:extLst>
          </p:cNvPr>
          <p:cNvSpPr>
            <a:spLocks noChangeShapeType="1"/>
          </p:cNvSpPr>
          <p:nvPr/>
        </p:nvSpPr>
        <p:spPr bwMode="auto">
          <a:xfrm>
            <a:off x="5995060" y="1205653"/>
            <a:ext cx="39688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3" name="Freeform 123">
            <a:extLst>
              <a:ext uri="{FF2B5EF4-FFF2-40B4-BE49-F238E27FC236}">
                <a16:creationId xmlns:a16="http://schemas.microsoft.com/office/drawing/2014/main" id="{95A0BE0C-0463-BFD7-65E0-D33F76223D22}"/>
              </a:ext>
            </a:extLst>
          </p:cNvPr>
          <p:cNvSpPr>
            <a:spLocks/>
          </p:cNvSpPr>
          <p:nvPr/>
        </p:nvSpPr>
        <p:spPr bwMode="auto">
          <a:xfrm>
            <a:off x="745973" y="4229900"/>
            <a:ext cx="1839913" cy="561975"/>
          </a:xfrm>
          <a:custGeom>
            <a:avLst/>
            <a:gdLst>
              <a:gd name="T0" fmla="*/ 0 w 477"/>
              <a:gd name="T1" fmla="*/ 175 h 175"/>
              <a:gd name="T2" fmla="*/ 1 w 477"/>
              <a:gd name="T3" fmla="*/ 175 h 175"/>
              <a:gd name="T4" fmla="*/ 1 w 477"/>
              <a:gd name="T5" fmla="*/ 153 h 175"/>
              <a:gd name="T6" fmla="*/ 2 w 477"/>
              <a:gd name="T7" fmla="*/ 153 h 175"/>
              <a:gd name="T8" fmla="*/ 2 w 477"/>
              <a:gd name="T9" fmla="*/ 131 h 175"/>
              <a:gd name="T10" fmla="*/ 8 w 477"/>
              <a:gd name="T11" fmla="*/ 131 h 175"/>
              <a:gd name="T12" fmla="*/ 8 w 477"/>
              <a:gd name="T13" fmla="*/ 109 h 175"/>
              <a:gd name="T14" fmla="*/ 17 w 477"/>
              <a:gd name="T15" fmla="*/ 109 h 175"/>
              <a:gd name="T16" fmla="*/ 17 w 477"/>
              <a:gd name="T17" fmla="*/ 88 h 175"/>
              <a:gd name="T18" fmla="*/ 17 w 477"/>
              <a:gd name="T19" fmla="*/ 88 h 175"/>
              <a:gd name="T20" fmla="*/ 17 w 477"/>
              <a:gd name="T21" fmla="*/ 66 h 175"/>
              <a:gd name="T22" fmla="*/ 38 w 477"/>
              <a:gd name="T23" fmla="*/ 66 h 175"/>
              <a:gd name="T24" fmla="*/ 38 w 477"/>
              <a:gd name="T25" fmla="*/ 44 h 175"/>
              <a:gd name="T26" fmla="*/ 46 w 477"/>
              <a:gd name="T27" fmla="*/ 44 h 175"/>
              <a:gd name="T28" fmla="*/ 46 w 477"/>
              <a:gd name="T29" fmla="*/ 22 h 175"/>
              <a:gd name="T30" fmla="*/ 67 w 477"/>
              <a:gd name="T31" fmla="*/ 22 h 175"/>
              <a:gd name="T32" fmla="*/ 67 w 477"/>
              <a:gd name="T33" fmla="*/ 0 h 175"/>
              <a:gd name="T34" fmla="*/ 477 w 477"/>
              <a:gd name="T35" fmla="*/ 0 h 1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477" h="175">
                <a:moveTo>
                  <a:pt x="0" y="175"/>
                </a:moveTo>
                <a:lnTo>
                  <a:pt x="1" y="175"/>
                </a:lnTo>
                <a:lnTo>
                  <a:pt x="1" y="153"/>
                </a:lnTo>
                <a:lnTo>
                  <a:pt x="2" y="153"/>
                </a:lnTo>
                <a:lnTo>
                  <a:pt x="2" y="131"/>
                </a:lnTo>
                <a:lnTo>
                  <a:pt x="8" y="131"/>
                </a:lnTo>
                <a:lnTo>
                  <a:pt x="8" y="109"/>
                </a:lnTo>
                <a:lnTo>
                  <a:pt x="17" y="109"/>
                </a:lnTo>
                <a:lnTo>
                  <a:pt x="17" y="88"/>
                </a:lnTo>
                <a:lnTo>
                  <a:pt x="17" y="88"/>
                </a:lnTo>
                <a:lnTo>
                  <a:pt x="17" y="66"/>
                </a:lnTo>
                <a:lnTo>
                  <a:pt x="38" y="66"/>
                </a:lnTo>
                <a:lnTo>
                  <a:pt x="38" y="44"/>
                </a:lnTo>
                <a:lnTo>
                  <a:pt x="46" y="44"/>
                </a:lnTo>
                <a:lnTo>
                  <a:pt x="46" y="22"/>
                </a:lnTo>
                <a:lnTo>
                  <a:pt x="67" y="22"/>
                </a:lnTo>
                <a:lnTo>
                  <a:pt x="67" y="0"/>
                </a:lnTo>
                <a:lnTo>
                  <a:pt x="477" y="0"/>
                </a:lnTo>
              </a:path>
            </a:pathLst>
          </a:custGeom>
          <a:noFill/>
          <a:ln w="12700" cap="rnd">
            <a:solidFill>
              <a:schemeClr val="tx1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5" name="Line 120">
            <a:extLst>
              <a:ext uri="{FF2B5EF4-FFF2-40B4-BE49-F238E27FC236}">
                <a16:creationId xmlns:a16="http://schemas.microsoft.com/office/drawing/2014/main" id="{2344761C-EC20-186B-7D5E-65924BDCF49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595003" y="4374363"/>
            <a:ext cx="0" cy="34925"/>
          </a:xfrm>
          <a:prstGeom prst="line">
            <a:avLst/>
          </a:prstGeom>
          <a:noFill/>
          <a:ln w="635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7" name="Line 124">
            <a:extLst>
              <a:ext uri="{FF2B5EF4-FFF2-40B4-BE49-F238E27FC236}">
                <a16:creationId xmlns:a16="http://schemas.microsoft.com/office/drawing/2014/main" id="{B8FC96D4-9ADC-DB5D-6C89-551B90CAC8F3}"/>
              </a:ext>
            </a:extLst>
          </p:cNvPr>
          <p:cNvSpPr>
            <a:spLocks noChangeShapeType="1"/>
          </p:cNvSpPr>
          <p:nvPr/>
        </p:nvSpPr>
        <p:spPr bwMode="auto">
          <a:xfrm>
            <a:off x="2565248" y="4229900"/>
            <a:ext cx="39688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353D197-E75D-346A-EFB6-164A1EA6871E}"/>
              </a:ext>
            </a:extLst>
          </p:cNvPr>
          <p:cNvSpPr txBox="1"/>
          <p:nvPr/>
        </p:nvSpPr>
        <p:spPr>
          <a:xfrm>
            <a:off x="556715" y="6734910"/>
            <a:ext cx="574570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ja-JP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l figure 1. Outcomes according to disease status in myeloid malignancy group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l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) Probability of overall survival (OS). (b) Probability of relapse-free survival (RFS). (c) Cumulative incidence of relapse. (d) Cumulative incidence of non-relapse mortality (NRM). CR, complete remission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79522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9" name="Group 64">
            <a:extLst>
              <a:ext uri="{FF2B5EF4-FFF2-40B4-BE49-F238E27FC236}">
                <a16:creationId xmlns:a16="http://schemas.microsoft.com/office/drawing/2014/main" id="{17D29A9A-FBA6-F823-CA99-D76B1A3408D3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43910" y="3153056"/>
            <a:ext cx="3240088" cy="2700337"/>
            <a:chOff x="-1896" y="1967"/>
            <a:chExt cx="2041" cy="1701"/>
          </a:xfrm>
        </p:grpSpPr>
        <p:sp>
          <p:nvSpPr>
            <p:cNvPr id="340" name="AutoShape 63">
              <a:extLst>
                <a:ext uri="{FF2B5EF4-FFF2-40B4-BE49-F238E27FC236}">
                  <a16:creationId xmlns:a16="http://schemas.microsoft.com/office/drawing/2014/main" id="{1EB4EA47-2623-C6E7-7B68-DD1CBB81B1DF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-1896" y="1967"/>
              <a:ext cx="2041" cy="17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1" name="Line 65">
              <a:extLst>
                <a:ext uri="{FF2B5EF4-FFF2-40B4-BE49-F238E27FC236}">
                  <a16:creationId xmlns:a16="http://schemas.microsoft.com/office/drawing/2014/main" id="{D4531AA6-0B25-B2A2-49CC-50DF36A2C33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565" y="3034"/>
              <a:ext cx="1159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2" name="Line 66">
              <a:extLst>
                <a:ext uri="{FF2B5EF4-FFF2-40B4-BE49-F238E27FC236}">
                  <a16:creationId xmlns:a16="http://schemas.microsoft.com/office/drawing/2014/main" id="{868E5A6F-EAC9-C9FF-6D58-1E9074AE65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565" y="3034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3" name="Line 67">
              <a:extLst>
                <a:ext uri="{FF2B5EF4-FFF2-40B4-BE49-F238E27FC236}">
                  <a16:creationId xmlns:a16="http://schemas.microsoft.com/office/drawing/2014/main" id="{E1139325-ECD1-C925-0018-58A8EA27AD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276" y="3034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4" name="Line 68">
              <a:extLst>
                <a:ext uri="{FF2B5EF4-FFF2-40B4-BE49-F238E27FC236}">
                  <a16:creationId xmlns:a16="http://schemas.microsoft.com/office/drawing/2014/main" id="{9A65CD6B-3F37-AE33-2B60-C82D3CBAF9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987" y="3034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5" name="Line 69">
              <a:extLst>
                <a:ext uri="{FF2B5EF4-FFF2-40B4-BE49-F238E27FC236}">
                  <a16:creationId xmlns:a16="http://schemas.microsoft.com/office/drawing/2014/main" id="{20DF6A39-DA25-12BA-1A00-862438099FA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696" y="3034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6" name="Line 70">
              <a:extLst>
                <a:ext uri="{FF2B5EF4-FFF2-40B4-BE49-F238E27FC236}">
                  <a16:creationId xmlns:a16="http://schemas.microsoft.com/office/drawing/2014/main" id="{AA7071F2-7991-DBD8-A512-854DCB9B19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406" y="3034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7" name="Line 76">
              <a:extLst>
                <a:ext uri="{FF2B5EF4-FFF2-40B4-BE49-F238E27FC236}">
                  <a16:creationId xmlns:a16="http://schemas.microsoft.com/office/drawing/2014/main" id="{0D7EA07C-40DA-68DE-1BFE-72E045C112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612" y="2159"/>
              <a:ext cx="0" cy="84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8" name="Line 77">
              <a:extLst>
                <a:ext uri="{FF2B5EF4-FFF2-40B4-BE49-F238E27FC236}">
                  <a16:creationId xmlns:a16="http://schemas.microsoft.com/office/drawing/2014/main" id="{EA18D580-3F52-4E91-1EEE-B5E1B55AD9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636" y="3000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9" name="Line 78">
              <a:extLst>
                <a:ext uri="{FF2B5EF4-FFF2-40B4-BE49-F238E27FC236}">
                  <a16:creationId xmlns:a16="http://schemas.microsoft.com/office/drawing/2014/main" id="{B3DD7702-5CAB-617B-349B-D04BA747BD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636" y="2832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0" name="Line 79">
              <a:extLst>
                <a:ext uri="{FF2B5EF4-FFF2-40B4-BE49-F238E27FC236}">
                  <a16:creationId xmlns:a16="http://schemas.microsoft.com/office/drawing/2014/main" id="{6FAAA1AC-BA5F-82B0-D25D-91518CE68F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636" y="2664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1" name="Line 80">
              <a:extLst>
                <a:ext uri="{FF2B5EF4-FFF2-40B4-BE49-F238E27FC236}">
                  <a16:creationId xmlns:a16="http://schemas.microsoft.com/office/drawing/2014/main" id="{01289E35-80F0-7C92-A630-AFF5585A3F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636" y="2496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2" name="Line 81">
              <a:extLst>
                <a:ext uri="{FF2B5EF4-FFF2-40B4-BE49-F238E27FC236}">
                  <a16:creationId xmlns:a16="http://schemas.microsoft.com/office/drawing/2014/main" id="{AC961FFE-D373-41BE-FA28-810B549AE18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636" y="2328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3" name="Line 82">
              <a:extLst>
                <a:ext uri="{FF2B5EF4-FFF2-40B4-BE49-F238E27FC236}">
                  <a16:creationId xmlns:a16="http://schemas.microsoft.com/office/drawing/2014/main" id="{670FD8EF-45E1-9A97-DB6A-44E0B39220E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636" y="2159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4" name="Freeform 89">
              <a:extLst>
                <a:ext uri="{FF2B5EF4-FFF2-40B4-BE49-F238E27FC236}">
                  <a16:creationId xmlns:a16="http://schemas.microsoft.com/office/drawing/2014/main" id="{A7FD2ABE-1767-1886-8143-8192252521D3}"/>
                </a:ext>
              </a:extLst>
            </p:cNvPr>
            <p:cNvSpPr>
              <a:spLocks/>
            </p:cNvSpPr>
            <p:nvPr/>
          </p:nvSpPr>
          <p:spPr bwMode="auto">
            <a:xfrm>
              <a:off x="-1612" y="2125"/>
              <a:ext cx="1252" cy="909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5" name="Freeform 92">
              <a:extLst>
                <a:ext uri="{FF2B5EF4-FFF2-40B4-BE49-F238E27FC236}">
                  <a16:creationId xmlns:a16="http://schemas.microsoft.com/office/drawing/2014/main" id="{5397B0C6-E705-7AE6-4CC4-96FF1667DB7A}"/>
                </a:ext>
              </a:extLst>
            </p:cNvPr>
            <p:cNvSpPr>
              <a:spLocks/>
            </p:cNvSpPr>
            <p:nvPr/>
          </p:nvSpPr>
          <p:spPr bwMode="auto">
            <a:xfrm>
              <a:off x="-1565" y="2159"/>
              <a:ext cx="782" cy="841"/>
            </a:xfrm>
            <a:custGeom>
              <a:avLst/>
              <a:gdLst>
                <a:gd name="T0" fmla="*/ 0 w 322"/>
                <a:gd name="T1" fmla="*/ 415 h 415"/>
                <a:gd name="T2" fmla="*/ 53 w 322"/>
                <a:gd name="T3" fmla="*/ 415 h 415"/>
                <a:gd name="T4" fmla="*/ 53 w 322"/>
                <a:gd name="T5" fmla="*/ 403 h 415"/>
                <a:gd name="T6" fmla="*/ 65 w 322"/>
                <a:gd name="T7" fmla="*/ 403 h 415"/>
                <a:gd name="T8" fmla="*/ 65 w 322"/>
                <a:gd name="T9" fmla="*/ 391 h 415"/>
                <a:gd name="T10" fmla="*/ 77 w 322"/>
                <a:gd name="T11" fmla="*/ 391 h 415"/>
                <a:gd name="T12" fmla="*/ 77 w 322"/>
                <a:gd name="T13" fmla="*/ 354 h 415"/>
                <a:gd name="T14" fmla="*/ 83 w 322"/>
                <a:gd name="T15" fmla="*/ 354 h 415"/>
                <a:gd name="T16" fmla="*/ 83 w 322"/>
                <a:gd name="T17" fmla="*/ 342 h 415"/>
                <a:gd name="T18" fmla="*/ 89 w 322"/>
                <a:gd name="T19" fmla="*/ 342 h 415"/>
                <a:gd name="T20" fmla="*/ 89 w 322"/>
                <a:gd name="T21" fmla="*/ 317 h 415"/>
                <a:gd name="T22" fmla="*/ 95 w 322"/>
                <a:gd name="T23" fmla="*/ 317 h 415"/>
                <a:gd name="T24" fmla="*/ 95 w 322"/>
                <a:gd name="T25" fmla="*/ 305 h 415"/>
                <a:gd name="T26" fmla="*/ 101 w 322"/>
                <a:gd name="T27" fmla="*/ 305 h 415"/>
                <a:gd name="T28" fmla="*/ 101 w 322"/>
                <a:gd name="T29" fmla="*/ 281 h 415"/>
                <a:gd name="T30" fmla="*/ 113 w 322"/>
                <a:gd name="T31" fmla="*/ 281 h 415"/>
                <a:gd name="T32" fmla="*/ 113 w 322"/>
                <a:gd name="T33" fmla="*/ 256 h 415"/>
                <a:gd name="T34" fmla="*/ 119 w 322"/>
                <a:gd name="T35" fmla="*/ 256 h 415"/>
                <a:gd name="T36" fmla="*/ 119 w 322"/>
                <a:gd name="T37" fmla="*/ 244 h 415"/>
                <a:gd name="T38" fmla="*/ 125 w 322"/>
                <a:gd name="T39" fmla="*/ 244 h 415"/>
                <a:gd name="T40" fmla="*/ 125 w 322"/>
                <a:gd name="T41" fmla="*/ 232 h 415"/>
                <a:gd name="T42" fmla="*/ 131 w 322"/>
                <a:gd name="T43" fmla="*/ 232 h 415"/>
                <a:gd name="T44" fmla="*/ 131 w 322"/>
                <a:gd name="T45" fmla="*/ 195 h 415"/>
                <a:gd name="T46" fmla="*/ 137 w 322"/>
                <a:gd name="T47" fmla="*/ 195 h 415"/>
                <a:gd name="T48" fmla="*/ 137 w 322"/>
                <a:gd name="T49" fmla="*/ 183 h 415"/>
                <a:gd name="T50" fmla="*/ 143 w 322"/>
                <a:gd name="T51" fmla="*/ 183 h 415"/>
                <a:gd name="T52" fmla="*/ 143 w 322"/>
                <a:gd name="T53" fmla="*/ 171 h 415"/>
                <a:gd name="T54" fmla="*/ 155 w 322"/>
                <a:gd name="T55" fmla="*/ 171 h 415"/>
                <a:gd name="T56" fmla="*/ 155 w 322"/>
                <a:gd name="T57" fmla="*/ 159 h 415"/>
                <a:gd name="T58" fmla="*/ 161 w 322"/>
                <a:gd name="T59" fmla="*/ 159 h 415"/>
                <a:gd name="T60" fmla="*/ 161 w 322"/>
                <a:gd name="T61" fmla="*/ 134 h 415"/>
                <a:gd name="T62" fmla="*/ 167 w 322"/>
                <a:gd name="T63" fmla="*/ 134 h 415"/>
                <a:gd name="T64" fmla="*/ 167 w 322"/>
                <a:gd name="T65" fmla="*/ 122 h 415"/>
                <a:gd name="T66" fmla="*/ 173 w 322"/>
                <a:gd name="T67" fmla="*/ 122 h 415"/>
                <a:gd name="T68" fmla="*/ 173 w 322"/>
                <a:gd name="T69" fmla="*/ 98 h 415"/>
                <a:gd name="T70" fmla="*/ 185 w 322"/>
                <a:gd name="T71" fmla="*/ 98 h 415"/>
                <a:gd name="T72" fmla="*/ 185 w 322"/>
                <a:gd name="T73" fmla="*/ 85 h 415"/>
                <a:gd name="T74" fmla="*/ 203 w 322"/>
                <a:gd name="T75" fmla="*/ 85 h 415"/>
                <a:gd name="T76" fmla="*/ 203 w 322"/>
                <a:gd name="T77" fmla="*/ 61 h 415"/>
                <a:gd name="T78" fmla="*/ 209 w 322"/>
                <a:gd name="T79" fmla="*/ 61 h 415"/>
                <a:gd name="T80" fmla="*/ 209 w 322"/>
                <a:gd name="T81" fmla="*/ 49 h 415"/>
                <a:gd name="T82" fmla="*/ 238 w 322"/>
                <a:gd name="T83" fmla="*/ 49 h 415"/>
                <a:gd name="T84" fmla="*/ 238 w 322"/>
                <a:gd name="T85" fmla="*/ 36 h 415"/>
                <a:gd name="T86" fmla="*/ 244 w 322"/>
                <a:gd name="T87" fmla="*/ 36 h 415"/>
                <a:gd name="T88" fmla="*/ 244 w 322"/>
                <a:gd name="T89" fmla="*/ 12 h 415"/>
                <a:gd name="T90" fmla="*/ 322 w 322"/>
                <a:gd name="T91" fmla="*/ 12 h 415"/>
                <a:gd name="T92" fmla="*/ 322 w 322"/>
                <a:gd name="T93" fmla="*/ 0 h 4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</a:cxnLst>
              <a:rect l="0" t="0" r="r" b="b"/>
              <a:pathLst>
                <a:path w="322" h="415">
                  <a:moveTo>
                    <a:pt x="0" y="415"/>
                  </a:moveTo>
                  <a:lnTo>
                    <a:pt x="53" y="415"/>
                  </a:lnTo>
                  <a:lnTo>
                    <a:pt x="53" y="403"/>
                  </a:lnTo>
                  <a:lnTo>
                    <a:pt x="65" y="403"/>
                  </a:lnTo>
                  <a:lnTo>
                    <a:pt x="65" y="391"/>
                  </a:lnTo>
                  <a:lnTo>
                    <a:pt x="77" y="391"/>
                  </a:lnTo>
                  <a:lnTo>
                    <a:pt x="77" y="354"/>
                  </a:lnTo>
                  <a:lnTo>
                    <a:pt x="83" y="354"/>
                  </a:lnTo>
                  <a:lnTo>
                    <a:pt x="83" y="342"/>
                  </a:lnTo>
                  <a:lnTo>
                    <a:pt x="89" y="342"/>
                  </a:lnTo>
                  <a:lnTo>
                    <a:pt x="89" y="317"/>
                  </a:lnTo>
                  <a:lnTo>
                    <a:pt x="95" y="317"/>
                  </a:lnTo>
                  <a:lnTo>
                    <a:pt x="95" y="305"/>
                  </a:lnTo>
                  <a:lnTo>
                    <a:pt x="101" y="305"/>
                  </a:lnTo>
                  <a:lnTo>
                    <a:pt x="101" y="281"/>
                  </a:lnTo>
                  <a:lnTo>
                    <a:pt x="113" y="281"/>
                  </a:lnTo>
                  <a:lnTo>
                    <a:pt x="113" y="256"/>
                  </a:lnTo>
                  <a:lnTo>
                    <a:pt x="119" y="256"/>
                  </a:lnTo>
                  <a:lnTo>
                    <a:pt x="119" y="244"/>
                  </a:lnTo>
                  <a:lnTo>
                    <a:pt x="125" y="244"/>
                  </a:lnTo>
                  <a:lnTo>
                    <a:pt x="125" y="232"/>
                  </a:lnTo>
                  <a:lnTo>
                    <a:pt x="131" y="232"/>
                  </a:lnTo>
                  <a:lnTo>
                    <a:pt x="131" y="195"/>
                  </a:lnTo>
                  <a:lnTo>
                    <a:pt x="137" y="195"/>
                  </a:lnTo>
                  <a:lnTo>
                    <a:pt x="137" y="183"/>
                  </a:lnTo>
                  <a:lnTo>
                    <a:pt x="143" y="183"/>
                  </a:lnTo>
                  <a:lnTo>
                    <a:pt x="143" y="171"/>
                  </a:lnTo>
                  <a:lnTo>
                    <a:pt x="155" y="171"/>
                  </a:lnTo>
                  <a:lnTo>
                    <a:pt x="155" y="159"/>
                  </a:lnTo>
                  <a:lnTo>
                    <a:pt x="161" y="159"/>
                  </a:lnTo>
                  <a:lnTo>
                    <a:pt x="161" y="134"/>
                  </a:lnTo>
                  <a:lnTo>
                    <a:pt x="167" y="134"/>
                  </a:lnTo>
                  <a:lnTo>
                    <a:pt x="167" y="122"/>
                  </a:lnTo>
                  <a:lnTo>
                    <a:pt x="173" y="122"/>
                  </a:lnTo>
                  <a:lnTo>
                    <a:pt x="173" y="98"/>
                  </a:lnTo>
                  <a:lnTo>
                    <a:pt x="185" y="98"/>
                  </a:lnTo>
                  <a:lnTo>
                    <a:pt x="185" y="85"/>
                  </a:lnTo>
                  <a:lnTo>
                    <a:pt x="203" y="85"/>
                  </a:lnTo>
                  <a:lnTo>
                    <a:pt x="203" y="61"/>
                  </a:lnTo>
                  <a:lnTo>
                    <a:pt x="209" y="61"/>
                  </a:lnTo>
                  <a:lnTo>
                    <a:pt x="209" y="49"/>
                  </a:lnTo>
                  <a:lnTo>
                    <a:pt x="238" y="49"/>
                  </a:lnTo>
                  <a:lnTo>
                    <a:pt x="238" y="36"/>
                  </a:lnTo>
                  <a:lnTo>
                    <a:pt x="244" y="36"/>
                  </a:lnTo>
                  <a:lnTo>
                    <a:pt x="244" y="12"/>
                  </a:lnTo>
                  <a:lnTo>
                    <a:pt x="322" y="12"/>
                  </a:lnTo>
                  <a:lnTo>
                    <a:pt x="322" y="0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6" name="Freeform 93">
              <a:extLst>
                <a:ext uri="{FF2B5EF4-FFF2-40B4-BE49-F238E27FC236}">
                  <a16:creationId xmlns:a16="http://schemas.microsoft.com/office/drawing/2014/main" id="{2888ADA6-5139-875F-E495-0DA258F122F9}"/>
                </a:ext>
              </a:extLst>
            </p:cNvPr>
            <p:cNvSpPr>
              <a:spLocks/>
            </p:cNvSpPr>
            <p:nvPr/>
          </p:nvSpPr>
          <p:spPr bwMode="auto">
            <a:xfrm>
              <a:off x="-1565" y="2159"/>
              <a:ext cx="1071" cy="841"/>
            </a:xfrm>
            <a:custGeom>
              <a:avLst/>
              <a:gdLst>
                <a:gd name="T0" fmla="*/ 0 w 441"/>
                <a:gd name="T1" fmla="*/ 415 h 415"/>
                <a:gd name="T2" fmla="*/ 59 w 441"/>
                <a:gd name="T3" fmla="*/ 415 h 415"/>
                <a:gd name="T4" fmla="*/ 59 w 441"/>
                <a:gd name="T5" fmla="*/ 383 h 415"/>
                <a:gd name="T6" fmla="*/ 71 w 441"/>
                <a:gd name="T7" fmla="*/ 383 h 415"/>
                <a:gd name="T8" fmla="*/ 71 w 441"/>
                <a:gd name="T9" fmla="*/ 367 h 415"/>
                <a:gd name="T10" fmla="*/ 77 w 441"/>
                <a:gd name="T11" fmla="*/ 367 h 415"/>
                <a:gd name="T12" fmla="*/ 77 w 441"/>
                <a:gd name="T13" fmla="*/ 319 h 415"/>
                <a:gd name="T14" fmla="*/ 83 w 441"/>
                <a:gd name="T15" fmla="*/ 319 h 415"/>
                <a:gd name="T16" fmla="*/ 83 w 441"/>
                <a:gd name="T17" fmla="*/ 303 h 415"/>
                <a:gd name="T18" fmla="*/ 95 w 441"/>
                <a:gd name="T19" fmla="*/ 303 h 415"/>
                <a:gd name="T20" fmla="*/ 95 w 441"/>
                <a:gd name="T21" fmla="*/ 271 h 415"/>
                <a:gd name="T22" fmla="*/ 107 w 441"/>
                <a:gd name="T23" fmla="*/ 271 h 415"/>
                <a:gd name="T24" fmla="*/ 107 w 441"/>
                <a:gd name="T25" fmla="*/ 255 h 415"/>
                <a:gd name="T26" fmla="*/ 113 w 441"/>
                <a:gd name="T27" fmla="*/ 255 h 415"/>
                <a:gd name="T28" fmla="*/ 113 w 441"/>
                <a:gd name="T29" fmla="*/ 239 h 415"/>
                <a:gd name="T30" fmla="*/ 125 w 441"/>
                <a:gd name="T31" fmla="*/ 239 h 415"/>
                <a:gd name="T32" fmla="*/ 125 w 441"/>
                <a:gd name="T33" fmla="*/ 223 h 415"/>
                <a:gd name="T34" fmla="*/ 137 w 441"/>
                <a:gd name="T35" fmla="*/ 223 h 415"/>
                <a:gd name="T36" fmla="*/ 137 w 441"/>
                <a:gd name="T37" fmla="*/ 207 h 415"/>
                <a:gd name="T38" fmla="*/ 143 w 441"/>
                <a:gd name="T39" fmla="*/ 207 h 415"/>
                <a:gd name="T40" fmla="*/ 143 w 441"/>
                <a:gd name="T41" fmla="*/ 191 h 415"/>
                <a:gd name="T42" fmla="*/ 155 w 441"/>
                <a:gd name="T43" fmla="*/ 191 h 415"/>
                <a:gd name="T44" fmla="*/ 155 w 441"/>
                <a:gd name="T45" fmla="*/ 175 h 415"/>
                <a:gd name="T46" fmla="*/ 161 w 441"/>
                <a:gd name="T47" fmla="*/ 175 h 415"/>
                <a:gd name="T48" fmla="*/ 161 w 441"/>
                <a:gd name="T49" fmla="*/ 144 h 415"/>
                <a:gd name="T50" fmla="*/ 179 w 441"/>
                <a:gd name="T51" fmla="*/ 144 h 415"/>
                <a:gd name="T52" fmla="*/ 179 w 441"/>
                <a:gd name="T53" fmla="*/ 128 h 415"/>
                <a:gd name="T54" fmla="*/ 185 w 441"/>
                <a:gd name="T55" fmla="*/ 128 h 415"/>
                <a:gd name="T56" fmla="*/ 185 w 441"/>
                <a:gd name="T57" fmla="*/ 112 h 415"/>
                <a:gd name="T58" fmla="*/ 197 w 441"/>
                <a:gd name="T59" fmla="*/ 112 h 415"/>
                <a:gd name="T60" fmla="*/ 197 w 441"/>
                <a:gd name="T61" fmla="*/ 96 h 415"/>
                <a:gd name="T62" fmla="*/ 203 w 441"/>
                <a:gd name="T63" fmla="*/ 96 h 415"/>
                <a:gd name="T64" fmla="*/ 203 w 441"/>
                <a:gd name="T65" fmla="*/ 64 h 415"/>
                <a:gd name="T66" fmla="*/ 209 w 441"/>
                <a:gd name="T67" fmla="*/ 64 h 415"/>
                <a:gd name="T68" fmla="*/ 209 w 441"/>
                <a:gd name="T69" fmla="*/ 48 h 415"/>
                <a:gd name="T70" fmla="*/ 238 w 441"/>
                <a:gd name="T71" fmla="*/ 48 h 415"/>
                <a:gd name="T72" fmla="*/ 238 w 441"/>
                <a:gd name="T73" fmla="*/ 32 h 415"/>
                <a:gd name="T74" fmla="*/ 274 w 441"/>
                <a:gd name="T75" fmla="*/ 32 h 415"/>
                <a:gd name="T76" fmla="*/ 274 w 441"/>
                <a:gd name="T77" fmla="*/ 16 h 415"/>
                <a:gd name="T78" fmla="*/ 441 w 441"/>
                <a:gd name="T79" fmla="*/ 16 h 415"/>
                <a:gd name="T80" fmla="*/ 441 w 441"/>
                <a:gd name="T81" fmla="*/ 0 h 4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</a:cxnLst>
              <a:rect l="0" t="0" r="r" b="b"/>
              <a:pathLst>
                <a:path w="441" h="415">
                  <a:moveTo>
                    <a:pt x="0" y="415"/>
                  </a:moveTo>
                  <a:lnTo>
                    <a:pt x="59" y="415"/>
                  </a:lnTo>
                  <a:lnTo>
                    <a:pt x="59" y="383"/>
                  </a:lnTo>
                  <a:lnTo>
                    <a:pt x="71" y="383"/>
                  </a:lnTo>
                  <a:lnTo>
                    <a:pt x="71" y="367"/>
                  </a:lnTo>
                  <a:lnTo>
                    <a:pt x="77" y="367"/>
                  </a:lnTo>
                  <a:lnTo>
                    <a:pt x="77" y="319"/>
                  </a:lnTo>
                  <a:lnTo>
                    <a:pt x="83" y="319"/>
                  </a:lnTo>
                  <a:lnTo>
                    <a:pt x="83" y="303"/>
                  </a:lnTo>
                  <a:lnTo>
                    <a:pt x="95" y="303"/>
                  </a:lnTo>
                  <a:lnTo>
                    <a:pt x="95" y="271"/>
                  </a:lnTo>
                  <a:lnTo>
                    <a:pt x="107" y="271"/>
                  </a:lnTo>
                  <a:lnTo>
                    <a:pt x="107" y="255"/>
                  </a:lnTo>
                  <a:lnTo>
                    <a:pt x="113" y="255"/>
                  </a:lnTo>
                  <a:lnTo>
                    <a:pt x="113" y="239"/>
                  </a:lnTo>
                  <a:lnTo>
                    <a:pt x="125" y="239"/>
                  </a:lnTo>
                  <a:lnTo>
                    <a:pt x="125" y="223"/>
                  </a:lnTo>
                  <a:lnTo>
                    <a:pt x="137" y="223"/>
                  </a:lnTo>
                  <a:lnTo>
                    <a:pt x="137" y="207"/>
                  </a:lnTo>
                  <a:lnTo>
                    <a:pt x="143" y="207"/>
                  </a:lnTo>
                  <a:lnTo>
                    <a:pt x="143" y="191"/>
                  </a:lnTo>
                  <a:lnTo>
                    <a:pt x="155" y="191"/>
                  </a:lnTo>
                  <a:lnTo>
                    <a:pt x="155" y="175"/>
                  </a:lnTo>
                  <a:lnTo>
                    <a:pt x="161" y="175"/>
                  </a:lnTo>
                  <a:lnTo>
                    <a:pt x="161" y="144"/>
                  </a:lnTo>
                  <a:lnTo>
                    <a:pt x="179" y="144"/>
                  </a:lnTo>
                  <a:lnTo>
                    <a:pt x="179" y="128"/>
                  </a:lnTo>
                  <a:lnTo>
                    <a:pt x="185" y="128"/>
                  </a:lnTo>
                  <a:lnTo>
                    <a:pt x="185" y="112"/>
                  </a:lnTo>
                  <a:lnTo>
                    <a:pt x="197" y="112"/>
                  </a:lnTo>
                  <a:lnTo>
                    <a:pt x="197" y="96"/>
                  </a:lnTo>
                  <a:lnTo>
                    <a:pt x="203" y="96"/>
                  </a:lnTo>
                  <a:lnTo>
                    <a:pt x="203" y="64"/>
                  </a:lnTo>
                  <a:lnTo>
                    <a:pt x="209" y="64"/>
                  </a:lnTo>
                  <a:lnTo>
                    <a:pt x="209" y="48"/>
                  </a:lnTo>
                  <a:lnTo>
                    <a:pt x="238" y="48"/>
                  </a:lnTo>
                  <a:lnTo>
                    <a:pt x="238" y="32"/>
                  </a:lnTo>
                  <a:lnTo>
                    <a:pt x="274" y="32"/>
                  </a:lnTo>
                  <a:lnTo>
                    <a:pt x="274" y="16"/>
                  </a:lnTo>
                  <a:lnTo>
                    <a:pt x="441" y="16"/>
                  </a:lnTo>
                  <a:lnTo>
                    <a:pt x="441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675" name="Group 120">
            <a:extLst>
              <a:ext uri="{FF2B5EF4-FFF2-40B4-BE49-F238E27FC236}">
                <a16:creationId xmlns:a16="http://schemas.microsoft.com/office/drawing/2014/main" id="{6C18C150-D3F4-B209-8EE9-0BA9B549EF37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765154" y="275524"/>
            <a:ext cx="3240088" cy="2700337"/>
            <a:chOff x="4642" y="187"/>
            <a:chExt cx="2041" cy="1701"/>
          </a:xfrm>
        </p:grpSpPr>
        <p:sp>
          <p:nvSpPr>
            <p:cNvPr id="676" name="AutoShape 119">
              <a:extLst>
                <a:ext uri="{FF2B5EF4-FFF2-40B4-BE49-F238E27FC236}">
                  <a16:creationId xmlns:a16="http://schemas.microsoft.com/office/drawing/2014/main" id="{8F1946C2-3F40-07ED-F7F0-ECC5D188FB0A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4642" y="187"/>
              <a:ext cx="2041" cy="17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7" name="Line 121">
              <a:extLst>
                <a:ext uri="{FF2B5EF4-FFF2-40B4-BE49-F238E27FC236}">
                  <a16:creationId xmlns:a16="http://schemas.microsoft.com/office/drawing/2014/main" id="{FC3D2D43-98D1-3880-99C3-90A82B6086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73" y="1254"/>
              <a:ext cx="1159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8" name="Line 122">
              <a:extLst>
                <a:ext uri="{FF2B5EF4-FFF2-40B4-BE49-F238E27FC236}">
                  <a16:creationId xmlns:a16="http://schemas.microsoft.com/office/drawing/2014/main" id="{5C5BEEBE-69A5-E2A6-A7F1-4A78082FED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73" y="1254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9" name="Line 123">
              <a:extLst>
                <a:ext uri="{FF2B5EF4-FFF2-40B4-BE49-F238E27FC236}">
                  <a16:creationId xmlns:a16="http://schemas.microsoft.com/office/drawing/2014/main" id="{1E262523-04A6-0173-0401-BFDFB2E5E3B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62" y="1254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0" name="Line 124">
              <a:extLst>
                <a:ext uri="{FF2B5EF4-FFF2-40B4-BE49-F238E27FC236}">
                  <a16:creationId xmlns:a16="http://schemas.microsoft.com/office/drawing/2014/main" id="{1CA40952-4CE5-42C2-F777-943865B90F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51" y="1254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1" name="Line 125">
              <a:extLst>
                <a:ext uri="{FF2B5EF4-FFF2-40B4-BE49-F238E27FC236}">
                  <a16:creationId xmlns:a16="http://schemas.microsoft.com/office/drawing/2014/main" id="{71C8F91A-B30C-C712-306A-1DE7F1C6D1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42" y="1254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2" name="Line 126">
              <a:extLst>
                <a:ext uri="{FF2B5EF4-FFF2-40B4-BE49-F238E27FC236}">
                  <a16:creationId xmlns:a16="http://schemas.microsoft.com/office/drawing/2014/main" id="{2A506172-2D5D-5EDE-9C5F-CA57E961D0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32" y="1254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3" name="Line 132">
              <a:extLst>
                <a:ext uri="{FF2B5EF4-FFF2-40B4-BE49-F238E27FC236}">
                  <a16:creationId xmlns:a16="http://schemas.microsoft.com/office/drawing/2014/main" id="{BDB0C302-BE95-B576-0A49-6751E3A733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26" y="379"/>
              <a:ext cx="0" cy="84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4" name="Line 133">
              <a:extLst>
                <a:ext uri="{FF2B5EF4-FFF2-40B4-BE49-F238E27FC236}">
                  <a16:creationId xmlns:a16="http://schemas.microsoft.com/office/drawing/2014/main" id="{AB1FD657-D6D5-1018-D207-0173C05DFF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902" y="1220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5" name="Line 134">
              <a:extLst>
                <a:ext uri="{FF2B5EF4-FFF2-40B4-BE49-F238E27FC236}">
                  <a16:creationId xmlns:a16="http://schemas.microsoft.com/office/drawing/2014/main" id="{3F7F67AA-1DCC-9183-96AB-11BEA021AD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902" y="1052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6" name="Line 135">
              <a:extLst>
                <a:ext uri="{FF2B5EF4-FFF2-40B4-BE49-F238E27FC236}">
                  <a16:creationId xmlns:a16="http://schemas.microsoft.com/office/drawing/2014/main" id="{B57E10B7-72AD-CB5E-4B83-523CCACCC6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902" y="884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7" name="Line 136">
              <a:extLst>
                <a:ext uri="{FF2B5EF4-FFF2-40B4-BE49-F238E27FC236}">
                  <a16:creationId xmlns:a16="http://schemas.microsoft.com/office/drawing/2014/main" id="{A4DE92D3-306C-1497-66C7-E714529632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902" y="716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8" name="Line 137">
              <a:extLst>
                <a:ext uri="{FF2B5EF4-FFF2-40B4-BE49-F238E27FC236}">
                  <a16:creationId xmlns:a16="http://schemas.microsoft.com/office/drawing/2014/main" id="{6A90BCE9-0581-12A1-61EA-3FEE3C5A62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902" y="548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9" name="Line 138">
              <a:extLst>
                <a:ext uri="{FF2B5EF4-FFF2-40B4-BE49-F238E27FC236}">
                  <a16:creationId xmlns:a16="http://schemas.microsoft.com/office/drawing/2014/main" id="{49C3E20A-ABF8-13FD-DB04-BF85A5C1B7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902" y="379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90" name="Freeform 145">
              <a:extLst>
                <a:ext uri="{FF2B5EF4-FFF2-40B4-BE49-F238E27FC236}">
                  <a16:creationId xmlns:a16="http://schemas.microsoft.com/office/drawing/2014/main" id="{11C1CB54-5D00-F238-4CD5-2AE31C6A2A24}"/>
                </a:ext>
              </a:extLst>
            </p:cNvPr>
            <p:cNvSpPr>
              <a:spLocks/>
            </p:cNvSpPr>
            <p:nvPr/>
          </p:nvSpPr>
          <p:spPr bwMode="auto">
            <a:xfrm>
              <a:off x="4926" y="345"/>
              <a:ext cx="1252" cy="909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91" name="Freeform 148">
              <a:extLst>
                <a:ext uri="{FF2B5EF4-FFF2-40B4-BE49-F238E27FC236}">
                  <a16:creationId xmlns:a16="http://schemas.microsoft.com/office/drawing/2014/main" id="{5BA71EF8-749E-3D89-2F91-736A91D8386E}"/>
                </a:ext>
              </a:extLst>
            </p:cNvPr>
            <p:cNvSpPr>
              <a:spLocks/>
            </p:cNvSpPr>
            <p:nvPr/>
          </p:nvSpPr>
          <p:spPr bwMode="auto">
            <a:xfrm>
              <a:off x="4973" y="379"/>
              <a:ext cx="680" cy="841"/>
            </a:xfrm>
            <a:custGeom>
              <a:avLst/>
              <a:gdLst>
                <a:gd name="T0" fmla="*/ 0 w 280"/>
                <a:gd name="T1" fmla="*/ 415 h 415"/>
                <a:gd name="T2" fmla="*/ 77 w 280"/>
                <a:gd name="T3" fmla="*/ 415 h 415"/>
                <a:gd name="T4" fmla="*/ 77 w 280"/>
                <a:gd name="T5" fmla="*/ 403 h 415"/>
                <a:gd name="T6" fmla="*/ 83 w 280"/>
                <a:gd name="T7" fmla="*/ 403 h 415"/>
                <a:gd name="T8" fmla="*/ 83 w 280"/>
                <a:gd name="T9" fmla="*/ 391 h 415"/>
                <a:gd name="T10" fmla="*/ 89 w 280"/>
                <a:gd name="T11" fmla="*/ 391 h 415"/>
                <a:gd name="T12" fmla="*/ 89 w 280"/>
                <a:gd name="T13" fmla="*/ 378 h 415"/>
                <a:gd name="T14" fmla="*/ 95 w 280"/>
                <a:gd name="T15" fmla="*/ 378 h 415"/>
                <a:gd name="T16" fmla="*/ 95 w 280"/>
                <a:gd name="T17" fmla="*/ 366 h 415"/>
                <a:gd name="T18" fmla="*/ 101 w 280"/>
                <a:gd name="T19" fmla="*/ 366 h 415"/>
                <a:gd name="T20" fmla="*/ 101 w 280"/>
                <a:gd name="T21" fmla="*/ 354 h 415"/>
                <a:gd name="T22" fmla="*/ 107 w 280"/>
                <a:gd name="T23" fmla="*/ 354 h 415"/>
                <a:gd name="T24" fmla="*/ 107 w 280"/>
                <a:gd name="T25" fmla="*/ 305 h 415"/>
                <a:gd name="T26" fmla="*/ 113 w 280"/>
                <a:gd name="T27" fmla="*/ 305 h 415"/>
                <a:gd name="T28" fmla="*/ 113 w 280"/>
                <a:gd name="T29" fmla="*/ 281 h 415"/>
                <a:gd name="T30" fmla="*/ 119 w 280"/>
                <a:gd name="T31" fmla="*/ 281 h 415"/>
                <a:gd name="T32" fmla="*/ 119 w 280"/>
                <a:gd name="T33" fmla="*/ 268 h 415"/>
                <a:gd name="T34" fmla="*/ 125 w 280"/>
                <a:gd name="T35" fmla="*/ 268 h 415"/>
                <a:gd name="T36" fmla="*/ 125 w 280"/>
                <a:gd name="T37" fmla="*/ 232 h 415"/>
                <a:gd name="T38" fmla="*/ 131 w 280"/>
                <a:gd name="T39" fmla="*/ 232 h 415"/>
                <a:gd name="T40" fmla="*/ 131 w 280"/>
                <a:gd name="T41" fmla="*/ 220 h 415"/>
                <a:gd name="T42" fmla="*/ 143 w 280"/>
                <a:gd name="T43" fmla="*/ 220 h 415"/>
                <a:gd name="T44" fmla="*/ 143 w 280"/>
                <a:gd name="T45" fmla="*/ 207 h 415"/>
                <a:gd name="T46" fmla="*/ 149 w 280"/>
                <a:gd name="T47" fmla="*/ 207 h 415"/>
                <a:gd name="T48" fmla="*/ 149 w 280"/>
                <a:gd name="T49" fmla="*/ 171 h 415"/>
                <a:gd name="T50" fmla="*/ 155 w 280"/>
                <a:gd name="T51" fmla="*/ 171 h 415"/>
                <a:gd name="T52" fmla="*/ 155 w 280"/>
                <a:gd name="T53" fmla="*/ 159 h 415"/>
                <a:gd name="T54" fmla="*/ 173 w 280"/>
                <a:gd name="T55" fmla="*/ 159 h 415"/>
                <a:gd name="T56" fmla="*/ 173 w 280"/>
                <a:gd name="T57" fmla="*/ 134 h 415"/>
                <a:gd name="T58" fmla="*/ 185 w 280"/>
                <a:gd name="T59" fmla="*/ 134 h 415"/>
                <a:gd name="T60" fmla="*/ 185 w 280"/>
                <a:gd name="T61" fmla="*/ 122 h 415"/>
                <a:gd name="T62" fmla="*/ 191 w 280"/>
                <a:gd name="T63" fmla="*/ 122 h 415"/>
                <a:gd name="T64" fmla="*/ 191 w 280"/>
                <a:gd name="T65" fmla="*/ 110 h 415"/>
                <a:gd name="T66" fmla="*/ 203 w 280"/>
                <a:gd name="T67" fmla="*/ 110 h 415"/>
                <a:gd name="T68" fmla="*/ 203 w 280"/>
                <a:gd name="T69" fmla="*/ 98 h 415"/>
                <a:gd name="T70" fmla="*/ 209 w 280"/>
                <a:gd name="T71" fmla="*/ 98 h 415"/>
                <a:gd name="T72" fmla="*/ 209 w 280"/>
                <a:gd name="T73" fmla="*/ 85 h 415"/>
                <a:gd name="T74" fmla="*/ 215 w 280"/>
                <a:gd name="T75" fmla="*/ 85 h 415"/>
                <a:gd name="T76" fmla="*/ 215 w 280"/>
                <a:gd name="T77" fmla="*/ 73 h 415"/>
                <a:gd name="T78" fmla="*/ 220 w 280"/>
                <a:gd name="T79" fmla="*/ 73 h 415"/>
                <a:gd name="T80" fmla="*/ 220 w 280"/>
                <a:gd name="T81" fmla="*/ 49 h 415"/>
                <a:gd name="T82" fmla="*/ 238 w 280"/>
                <a:gd name="T83" fmla="*/ 49 h 415"/>
                <a:gd name="T84" fmla="*/ 238 w 280"/>
                <a:gd name="T85" fmla="*/ 36 h 415"/>
                <a:gd name="T86" fmla="*/ 250 w 280"/>
                <a:gd name="T87" fmla="*/ 36 h 415"/>
                <a:gd name="T88" fmla="*/ 250 w 280"/>
                <a:gd name="T89" fmla="*/ 24 h 415"/>
                <a:gd name="T90" fmla="*/ 268 w 280"/>
                <a:gd name="T91" fmla="*/ 24 h 415"/>
                <a:gd name="T92" fmla="*/ 268 w 280"/>
                <a:gd name="T93" fmla="*/ 12 h 415"/>
                <a:gd name="T94" fmla="*/ 280 w 280"/>
                <a:gd name="T95" fmla="*/ 12 h 415"/>
                <a:gd name="T96" fmla="*/ 280 w 280"/>
                <a:gd name="T97" fmla="*/ 0 h 4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</a:cxnLst>
              <a:rect l="0" t="0" r="r" b="b"/>
              <a:pathLst>
                <a:path w="280" h="415">
                  <a:moveTo>
                    <a:pt x="0" y="415"/>
                  </a:moveTo>
                  <a:lnTo>
                    <a:pt x="77" y="415"/>
                  </a:lnTo>
                  <a:lnTo>
                    <a:pt x="77" y="403"/>
                  </a:lnTo>
                  <a:lnTo>
                    <a:pt x="83" y="403"/>
                  </a:lnTo>
                  <a:lnTo>
                    <a:pt x="83" y="391"/>
                  </a:lnTo>
                  <a:lnTo>
                    <a:pt x="89" y="391"/>
                  </a:lnTo>
                  <a:lnTo>
                    <a:pt x="89" y="378"/>
                  </a:lnTo>
                  <a:lnTo>
                    <a:pt x="95" y="378"/>
                  </a:lnTo>
                  <a:lnTo>
                    <a:pt x="95" y="366"/>
                  </a:lnTo>
                  <a:lnTo>
                    <a:pt x="101" y="366"/>
                  </a:lnTo>
                  <a:lnTo>
                    <a:pt x="101" y="354"/>
                  </a:lnTo>
                  <a:lnTo>
                    <a:pt x="107" y="354"/>
                  </a:lnTo>
                  <a:lnTo>
                    <a:pt x="107" y="305"/>
                  </a:lnTo>
                  <a:lnTo>
                    <a:pt x="113" y="305"/>
                  </a:lnTo>
                  <a:lnTo>
                    <a:pt x="113" y="281"/>
                  </a:lnTo>
                  <a:lnTo>
                    <a:pt x="119" y="281"/>
                  </a:lnTo>
                  <a:lnTo>
                    <a:pt x="119" y="268"/>
                  </a:lnTo>
                  <a:lnTo>
                    <a:pt x="125" y="268"/>
                  </a:lnTo>
                  <a:lnTo>
                    <a:pt x="125" y="232"/>
                  </a:lnTo>
                  <a:lnTo>
                    <a:pt x="131" y="232"/>
                  </a:lnTo>
                  <a:lnTo>
                    <a:pt x="131" y="220"/>
                  </a:lnTo>
                  <a:lnTo>
                    <a:pt x="143" y="220"/>
                  </a:lnTo>
                  <a:lnTo>
                    <a:pt x="143" y="207"/>
                  </a:lnTo>
                  <a:lnTo>
                    <a:pt x="149" y="207"/>
                  </a:lnTo>
                  <a:lnTo>
                    <a:pt x="149" y="171"/>
                  </a:lnTo>
                  <a:lnTo>
                    <a:pt x="155" y="171"/>
                  </a:lnTo>
                  <a:lnTo>
                    <a:pt x="155" y="159"/>
                  </a:lnTo>
                  <a:lnTo>
                    <a:pt x="173" y="159"/>
                  </a:lnTo>
                  <a:lnTo>
                    <a:pt x="173" y="134"/>
                  </a:lnTo>
                  <a:lnTo>
                    <a:pt x="185" y="134"/>
                  </a:lnTo>
                  <a:lnTo>
                    <a:pt x="185" y="122"/>
                  </a:lnTo>
                  <a:lnTo>
                    <a:pt x="191" y="122"/>
                  </a:lnTo>
                  <a:lnTo>
                    <a:pt x="191" y="110"/>
                  </a:lnTo>
                  <a:lnTo>
                    <a:pt x="203" y="110"/>
                  </a:lnTo>
                  <a:lnTo>
                    <a:pt x="203" y="98"/>
                  </a:lnTo>
                  <a:lnTo>
                    <a:pt x="209" y="98"/>
                  </a:lnTo>
                  <a:lnTo>
                    <a:pt x="209" y="85"/>
                  </a:lnTo>
                  <a:lnTo>
                    <a:pt x="215" y="85"/>
                  </a:lnTo>
                  <a:lnTo>
                    <a:pt x="215" y="73"/>
                  </a:lnTo>
                  <a:lnTo>
                    <a:pt x="220" y="73"/>
                  </a:lnTo>
                  <a:lnTo>
                    <a:pt x="220" y="49"/>
                  </a:lnTo>
                  <a:lnTo>
                    <a:pt x="238" y="49"/>
                  </a:lnTo>
                  <a:lnTo>
                    <a:pt x="238" y="36"/>
                  </a:lnTo>
                  <a:lnTo>
                    <a:pt x="250" y="36"/>
                  </a:lnTo>
                  <a:lnTo>
                    <a:pt x="250" y="24"/>
                  </a:lnTo>
                  <a:lnTo>
                    <a:pt x="268" y="24"/>
                  </a:lnTo>
                  <a:lnTo>
                    <a:pt x="268" y="12"/>
                  </a:lnTo>
                  <a:lnTo>
                    <a:pt x="280" y="12"/>
                  </a:lnTo>
                  <a:lnTo>
                    <a:pt x="280" y="0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92" name="Freeform 149">
              <a:extLst>
                <a:ext uri="{FF2B5EF4-FFF2-40B4-BE49-F238E27FC236}">
                  <a16:creationId xmlns:a16="http://schemas.microsoft.com/office/drawing/2014/main" id="{92850654-BDCF-0522-CB2D-837F31F73A5E}"/>
                </a:ext>
              </a:extLst>
            </p:cNvPr>
            <p:cNvSpPr>
              <a:spLocks/>
            </p:cNvSpPr>
            <p:nvPr/>
          </p:nvSpPr>
          <p:spPr bwMode="auto">
            <a:xfrm>
              <a:off x="4973" y="379"/>
              <a:ext cx="1115" cy="841"/>
            </a:xfrm>
            <a:custGeom>
              <a:avLst/>
              <a:gdLst>
                <a:gd name="T0" fmla="*/ 0 w 459"/>
                <a:gd name="T1" fmla="*/ 415 h 415"/>
                <a:gd name="T2" fmla="*/ 36 w 459"/>
                <a:gd name="T3" fmla="*/ 415 h 415"/>
                <a:gd name="T4" fmla="*/ 36 w 459"/>
                <a:gd name="T5" fmla="*/ 399 h 415"/>
                <a:gd name="T6" fmla="*/ 59 w 459"/>
                <a:gd name="T7" fmla="*/ 399 h 415"/>
                <a:gd name="T8" fmla="*/ 59 w 459"/>
                <a:gd name="T9" fmla="*/ 383 h 415"/>
                <a:gd name="T10" fmla="*/ 71 w 459"/>
                <a:gd name="T11" fmla="*/ 383 h 415"/>
                <a:gd name="T12" fmla="*/ 71 w 459"/>
                <a:gd name="T13" fmla="*/ 367 h 415"/>
                <a:gd name="T14" fmla="*/ 77 w 459"/>
                <a:gd name="T15" fmla="*/ 367 h 415"/>
                <a:gd name="T16" fmla="*/ 77 w 459"/>
                <a:gd name="T17" fmla="*/ 351 h 415"/>
                <a:gd name="T18" fmla="*/ 83 w 459"/>
                <a:gd name="T19" fmla="*/ 351 h 415"/>
                <a:gd name="T20" fmla="*/ 83 w 459"/>
                <a:gd name="T21" fmla="*/ 319 h 415"/>
                <a:gd name="T22" fmla="*/ 101 w 459"/>
                <a:gd name="T23" fmla="*/ 319 h 415"/>
                <a:gd name="T24" fmla="*/ 101 w 459"/>
                <a:gd name="T25" fmla="*/ 303 h 415"/>
                <a:gd name="T26" fmla="*/ 107 w 459"/>
                <a:gd name="T27" fmla="*/ 303 h 415"/>
                <a:gd name="T28" fmla="*/ 107 w 459"/>
                <a:gd name="T29" fmla="*/ 287 h 415"/>
                <a:gd name="T30" fmla="*/ 119 w 459"/>
                <a:gd name="T31" fmla="*/ 287 h 415"/>
                <a:gd name="T32" fmla="*/ 119 w 459"/>
                <a:gd name="T33" fmla="*/ 271 h 415"/>
                <a:gd name="T34" fmla="*/ 137 w 459"/>
                <a:gd name="T35" fmla="*/ 271 h 415"/>
                <a:gd name="T36" fmla="*/ 137 w 459"/>
                <a:gd name="T37" fmla="*/ 239 h 415"/>
                <a:gd name="T38" fmla="*/ 149 w 459"/>
                <a:gd name="T39" fmla="*/ 239 h 415"/>
                <a:gd name="T40" fmla="*/ 149 w 459"/>
                <a:gd name="T41" fmla="*/ 223 h 415"/>
                <a:gd name="T42" fmla="*/ 155 w 459"/>
                <a:gd name="T43" fmla="*/ 223 h 415"/>
                <a:gd name="T44" fmla="*/ 155 w 459"/>
                <a:gd name="T45" fmla="*/ 207 h 415"/>
                <a:gd name="T46" fmla="*/ 173 w 459"/>
                <a:gd name="T47" fmla="*/ 207 h 415"/>
                <a:gd name="T48" fmla="*/ 173 w 459"/>
                <a:gd name="T49" fmla="*/ 191 h 415"/>
                <a:gd name="T50" fmla="*/ 179 w 459"/>
                <a:gd name="T51" fmla="*/ 191 h 415"/>
                <a:gd name="T52" fmla="*/ 179 w 459"/>
                <a:gd name="T53" fmla="*/ 159 h 415"/>
                <a:gd name="T54" fmla="*/ 185 w 459"/>
                <a:gd name="T55" fmla="*/ 159 h 415"/>
                <a:gd name="T56" fmla="*/ 185 w 459"/>
                <a:gd name="T57" fmla="*/ 128 h 415"/>
                <a:gd name="T58" fmla="*/ 191 w 459"/>
                <a:gd name="T59" fmla="*/ 128 h 415"/>
                <a:gd name="T60" fmla="*/ 191 w 459"/>
                <a:gd name="T61" fmla="*/ 112 h 415"/>
                <a:gd name="T62" fmla="*/ 197 w 459"/>
                <a:gd name="T63" fmla="*/ 112 h 415"/>
                <a:gd name="T64" fmla="*/ 197 w 459"/>
                <a:gd name="T65" fmla="*/ 96 h 415"/>
                <a:gd name="T66" fmla="*/ 232 w 459"/>
                <a:gd name="T67" fmla="*/ 96 h 415"/>
                <a:gd name="T68" fmla="*/ 232 w 459"/>
                <a:gd name="T69" fmla="*/ 80 h 415"/>
                <a:gd name="T70" fmla="*/ 268 w 459"/>
                <a:gd name="T71" fmla="*/ 80 h 415"/>
                <a:gd name="T72" fmla="*/ 268 w 459"/>
                <a:gd name="T73" fmla="*/ 64 h 415"/>
                <a:gd name="T74" fmla="*/ 328 w 459"/>
                <a:gd name="T75" fmla="*/ 64 h 415"/>
                <a:gd name="T76" fmla="*/ 328 w 459"/>
                <a:gd name="T77" fmla="*/ 48 h 415"/>
                <a:gd name="T78" fmla="*/ 394 w 459"/>
                <a:gd name="T79" fmla="*/ 48 h 415"/>
                <a:gd name="T80" fmla="*/ 394 w 459"/>
                <a:gd name="T81" fmla="*/ 32 h 415"/>
                <a:gd name="T82" fmla="*/ 429 w 459"/>
                <a:gd name="T83" fmla="*/ 32 h 415"/>
                <a:gd name="T84" fmla="*/ 429 w 459"/>
                <a:gd name="T85" fmla="*/ 16 h 415"/>
                <a:gd name="T86" fmla="*/ 459 w 459"/>
                <a:gd name="T87" fmla="*/ 16 h 415"/>
                <a:gd name="T88" fmla="*/ 459 w 459"/>
                <a:gd name="T89" fmla="*/ 0 h 4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</a:cxnLst>
              <a:rect l="0" t="0" r="r" b="b"/>
              <a:pathLst>
                <a:path w="459" h="415">
                  <a:moveTo>
                    <a:pt x="0" y="415"/>
                  </a:moveTo>
                  <a:lnTo>
                    <a:pt x="36" y="415"/>
                  </a:lnTo>
                  <a:lnTo>
                    <a:pt x="36" y="399"/>
                  </a:lnTo>
                  <a:lnTo>
                    <a:pt x="59" y="399"/>
                  </a:lnTo>
                  <a:lnTo>
                    <a:pt x="59" y="383"/>
                  </a:lnTo>
                  <a:lnTo>
                    <a:pt x="71" y="383"/>
                  </a:lnTo>
                  <a:lnTo>
                    <a:pt x="71" y="367"/>
                  </a:lnTo>
                  <a:lnTo>
                    <a:pt x="77" y="367"/>
                  </a:lnTo>
                  <a:lnTo>
                    <a:pt x="77" y="351"/>
                  </a:lnTo>
                  <a:lnTo>
                    <a:pt x="83" y="351"/>
                  </a:lnTo>
                  <a:lnTo>
                    <a:pt x="83" y="319"/>
                  </a:lnTo>
                  <a:lnTo>
                    <a:pt x="101" y="319"/>
                  </a:lnTo>
                  <a:lnTo>
                    <a:pt x="101" y="303"/>
                  </a:lnTo>
                  <a:lnTo>
                    <a:pt x="107" y="303"/>
                  </a:lnTo>
                  <a:lnTo>
                    <a:pt x="107" y="287"/>
                  </a:lnTo>
                  <a:lnTo>
                    <a:pt x="119" y="287"/>
                  </a:lnTo>
                  <a:lnTo>
                    <a:pt x="119" y="271"/>
                  </a:lnTo>
                  <a:lnTo>
                    <a:pt x="137" y="271"/>
                  </a:lnTo>
                  <a:lnTo>
                    <a:pt x="137" y="239"/>
                  </a:lnTo>
                  <a:lnTo>
                    <a:pt x="149" y="239"/>
                  </a:lnTo>
                  <a:lnTo>
                    <a:pt x="149" y="223"/>
                  </a:lnTo>
                  <a:lnTo>
                    <a:pt x="155" y="223"/>
                  </a:lnTo>
                  <a:lnTo>
                    <a:pt x="155" y="207"/>
                  </a:lnTo>
                  <a:lnTo>
                    <a:pt x="173" y="207"/>
                  </a:lnTo>
                  <a:lnTo>
                    <a:pt x="173" y="191"/>
                  </a:lnTo>
                  <a:lnTo>
                    <a:pt x="179" y="191"/>
                  </a:lnTo>
                  <a:lnTo>
                    <a:pt x="179" y="159"/>
                  </a:lnTo>
                  <a:lnTo>
                    <a:pt x="185" y="159"/>
                  </a:lnTo>
                  <a:lnTo>
                    <a:pt x="185" y="128"/>
                  </a:lnTo>
                  <a:lnTo>
                    <a:pt x="191" y="128"/>
                  </a:lnTo>
                  <a:lnTo>
                    <a:pt x="191" y="112"/>
                  </a:lnTo>
                  <a:lnTo>
                    <a:pt x="197" y="112"/>
                  </a:lnTo>
                  <a:lnTo>
                    <a:pt x="197" y="96"/>
                  </a:lnTo>
                  <a:lnTo>
                    <a:pt x="232" y="96"/>
                  </a:lnTo>
                  <a:lnTo>
                    <a:pt x="232" y="80"/>
                  </a:lnTo>
                  <a:lnTo>
                    <a:pt x="268" y="80"/>
                  </a:lnTo>
                  <a:lnTo>
                    <a:pt x="268" y="64"/>
                  </a:lnTo>
                  <a:lnTo>
                    <a:pt x="328" y="64"/>
                  </a:lnTo>
                  <a:lnTo>
                    <a:pt x="328" y="48"/>
                  </a:lnTo>
                  <a:lnTo>
                    <a:pt x="394" y="48"/>
                  </a:lnTo>
                  <a:lnTo>
                    <a:pt x="394" y="32"/>
                  </a:lnTo>
                  <a:lnTo>
                    <a:pt x="429" y="32"/>
                  </a:lnTo>
                  <a:lnTo>
                    <a:pt x="429" y="16"/>
                  </a:lnTo>
                  <a:lnTo>
                    <a:pt x="459" y="16"/>
                  </a:lnTo>
                  <a:lnTo>
                    <a:pt x="459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656" name="Group 4">
            <a:extLst>
              <a:ext uri="{FF2B5EF4-FFF2-40B4-BE49-F238E27FC236}">
                <a16:creationId xmlns:a16="http://schemas.microsoft.com/office/drawing/2014/main" id="{9E8F0FC6-B2DF-DEC4-9F92-8C590D8687D4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36952" y="276114"/>
            <a:ext cx="3240088" cy="2700337"/>
            <a:chOff x="-2010" y="159"/>
            <a:chExt cx="2041" cy="1701"/>
          </a:xfrm>
        </p:grpSpPr>
        <p:sp>
          <p:nvSpPr>
            <p:cNvPr id="657" name="AutoShape 3">
              <a:extLst>
                <a:ext uri="{FF2B5EF4-FFF2-40B4-BE49-F238E27FC236}">
                  <a16:creationId xmlns:a16="http://schemas.microsoft.com/office/drawing/2014/main" id="{9B95AB62-B677-6FB0-D8B8-81B113EEC66A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-2010" y="159"/>
              <a:ext cx="2041" cy="17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8" name="Line 5">
              <a:extLst>
                <a:ext uri="{FF2B5EF4-FFF2-40B4-BE49-F238E27FC236}">
                  <a16:creationId xmlns:a16="http://schemas.microsoft.com/office/drawing/2014/main" id="{0E3D0109-0CB8-E185-20E8-AD2B960631C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679" y="1226"/>
              <a:ext cx="1159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9" name="Line 6">
              <a:extLst>
                <a:ext uri="{FF2B5EF4-FFF2-40B4-BE49-F238E27FC236}">
                  <a16:creationId xmlns:a16="http://schemas.microsoft.com/office/drawing/2014/main" id="{270C45A6-2FC0-99EA-C58F-F5EA63A60B0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679" y="1226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0" name="Line 7">
              <a:extLst>
                <a:ext uri="{FF2B5EF4-FFF2-40B4-BE49-F238E27FC236}">
                  <a16:creationId xmlns:a16="http://schemas.microsoft.com/office/drawing/2014/main" id="{62FBB1F2-B94C-6D6D-EA6F-FFF8AF35D1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449" y="1226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1" name="Line 8">
              <a:extLst>
                <a:ext uri="{FF2B5EF4-FFF2-40B4-BE49-F238E27FC236}">
                  <a16:creationId xmlns:a16="http://schemas.microsoft.com/office/drawing/2014/main" id="{CE1F0A0F-4200-F3EC-17D5-7E5EC64E7BF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215" y="1226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2" name="Line 9">
              <a:extLst>
                <a:ext uri="{FF2B5EF4-FFF2-40B4-BE49-F238E27FC236}">
                  <a16:creationId xmlns:a16="http://schemas.microsoft.com/office/drawing/2014/main" id="{63F4CFA5-A484-3648-CF8C-05D2810A69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985" y="1226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3" name="Line 10">
              <a:extLst>
                <a:ext uri="{FF2B5EF4-FFF2-40B4-BE49-F238E27FC236}">
                  <a16:creationId xmlns:a16="http://schemas.microsoft.com/office/drawing/2014/main" id="{B29143B9-3157-B177-30ED-EAF41065297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751" y="1226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4" name="Line 11">
              <a:extLst>
                <a:ext uri="{FF2B5EF4-FFF2-40B4-BE49-F238E27FC236}">
                  <a16:creationId xmlns:a16="http://schemas.microsoft.com/office/drawing/2014/main" id="{4CF79AE1-901F-9877-8A74-81131C0C0B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520" y="1226"/>
              <a:ext cx="0" cy="1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5" name="Line 18">
              <a:extLst>
                <a:ext uri="{FF2B5EF4-FFF2-40B4-BE49-F238E27FC236}">
                  <a16:creationId xmlns:a16="http://schemas.microsoft.com/office/drawing/2014/main" id="{12B485DB-1522-13D7-69A1-4D7E3582E80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726" y="351"/>
              <a:ext cx="0" cy="841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6" name="Line 19">
              <a:extLst>
                <a:ext uri="{FF2B5EF4-FFF2-40B4-BE49-F238E27FC236}">
                  <a16:creationId xmlns:a16="http://schemas.microsoft.com/office/drawing/2014/main" id="{6A477E0D-F0FC-6521-CC8F-A7D57E2D36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750" y="1192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7" name="Line 20">
              <a:extLst>
                <a:ext uri="{FF2B5EF4-FFF2-40B4-BE49-F238E27FC236}">
                  <a16:creationId xmlns:a16="http://schemas.microsoft.com/office/drawing/2014/main" id="{E74D6607-A8A9-225B-D939-9AE53625B38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750" y="1024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8" name="Line 21">
              <a:extLst>
                <a:ext uri="{FF2B5EF4-FFF2-40B4-BE49-F238E27FC236}">
                  <a16:creationId xmlns:a16="http://schemas.microsoft.com/office/drawing/2014/main" id="{22895B66-116E-CAB9-9694-6D8B7694C1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750" y="856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9" name="Line 22">
              <a:extLst>
                <a:ext uri="{FF2B5EF4-FFF2-40B4-BE49-F238E27FC236}">
                  <a16:creationId xmlns:a16="http://schemas.microsoft.com/office/drawing/2014/main" id="{4B3FDF39-CFFD-1B4B-897B-21D16F0079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750" y="688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0" name="Line 23">
              <a:extLst>
                <a:ext uri="{FF2B5EF4-FFF2-40B4-BE49-F238E27FC236}">
                  <a16:creationId xmlns:a16="http://schemas.microsoft.com/office/drawing/2014/main" id="{D25B4AAC-A0DF-CA46-5D49-834972EE60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750" y="520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1" name="Line 24">
              <a:extLst>
                <a:ext uri="{FF2B5EF4-FFF2-40B4-BE49-F238E27FC236}">
                  <a16:creationId xmlns:a16="http://schemas.microsoft.com/office/drawing/2014/main" id="{750A0025-4E07-3848-3015-459E7FB0BBF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750" y="351"/>
              <a:ext cx="2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2" name="Freeform 31">
              <a:extLst>
                <a:ext uri="{FF2B5EF4-FFF2-40B4-BE49-F238E27FC236}">
                  <a16:creationId xmlns:a16="http://schemas.microsoft.com/office/drawing/2014/main" id="{9CC47F8E-7AA1-4B37-75C8-46F091EE8A14}"/>
                </a:ext>
              </a:extLst>
            </p:cNvPr>
            <p:cNvSpPr>
              <a:spLocks/>
            </p:cNvSpPr>
            <p:nvPr/>
          </p:nvSpPr>
          <p:spPr bwMode="auto">
            <a:xfrm>
              <a:off x="-1726" y="317"/>
              <a:ext cx="1252" cy="909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3" name="Freeform 34">
              <a:extLst>
                <a:ext uri="{FF2B5EF4-FFF2-40B4-BE49-F238E27FC236}">
                  <a16:creationId xmlns:a16="http://schemas.microsoft.com/office/drawing/2014/main" id="{C25BB3A7-6AA6-58D8-C2E2-5FDF4F365343}"/>
                </a:ext>
              </a:extLst>
            </p:cNvPr>
            <p:cNvSpPr>
              <a:spLocks/>
            </p:cNvSpPr>
            <p:nvPr/>
          </p:nvSpPr>
          <p:spPr bwMode="auto">
            <a:xfrm>
              <a:off x="-1679" y="351"/>
              <a:ext cx="741" cy="841"/>
            </a:xfrm>
            <a:custGeom>
              <a:avLst/>
              <a:gdLst>
                <a:gd name="T0" fmla="*/ 0 w 305"/>
                <a:gd name="T1" fmla="*/ 415 h 415"/>
                <a:gd name="T2" fmla="*/ 86 w 305"/>
                <a:gd name="T3" fmla="*/ 415 h 415"/>
                <a:gd name="T4" fmla="*/ 86 w 305"/>
                <a:gd name="T5" fmla="*/ 403 h 415"/>
                <a:gd name="T6" fmla="*/ 105 w 305"/>
                <a:gd name="T7" fmla="*/ 403 h 415"/>
                <a:gd name="T8" fmla="*/ 105 w 305"/>
                <a:gd name="T9" fmla="*/ 391 h 415"/>
                <a:gd name="T10" fmla="*/ 114 w 305"/>
                <a:gd name="T11" fmla="*/ 391 h 415"/>
                <a:gd name="T12" fmla="*/ 114 w 305"/>
                <a:gd name="T13" fmla="*/ 378 h 415"/>
                <a:gd name="T14" fmla="*/ 124 w 305"/>
                <a:gd name="T15" fmla="*/ 378 h 415"/>
                <a:gd name="T16" fmla="*/ 124 w 305"/>
                <a:gd name="T17" fmla="*/ 354 h 415"/>
                <a:gd name="T18" fmla="*/ 133 w 305"/>
                <a:gd name="T19" fmla="*/ 354 h 415"/>
                <a:gd name="T20" fmla="*/ 133 w 305"/>
                <a:gd name="T21" fmla="*/ 330 h 415"/>
                <a:gd name="T22" fmla="*/ 143 w 305"/>
                <a:gd name="T23" fmla="*/ 330 h 415"/>
                <a:gd name="T24" fmla="*/ 143 w 305"/>
                <a:gd name="T25" fmla="*/ 244 h 415"/>
                <a:gd name="T26" fmla="*/ 152 w 305"/>
                <a:gd name="T27" fmla="*/ 244 h 415"/>
                <a:gd name="T28" fmla="*/ 152 w 305"/>
                <a:gd name="T29" fmla="*/ 159 h 415"/>
                <a:gd name="T30" fmla="*/ 162 w 305"/>
                <a:gd name="T31" fmla="*/ 159 h 415"/>
                <a:gd name="T32" fmla="*/ 162 w 305"/>
                <a:gd name="T33" fmla="*/ 134 h 415"/>
                <a:gd name="T34" fmla="*/ 172 w 305"/>
                <a:gd name="T35" fmla="*/ 134 h 415"/>
                <a:gd name="T36" fmla="*/ 172 w 305"/>
                <a:gd name="T37" fmla="*/ 85 h 415"/>
                <a:gd name="T38" fmla="*/ 181 w 305"/>
                <a:gd name="T39" fmla="*/ 85 h 415"/>
                <a:gd name="T40" fmla="*/ 181 w 305"/>
                <a:gd name="T41" fmla="*/ 49 h 415"/>
                <a:gd name="T42" fmla="*/ 219 w 305"/>
                <a:gd name="T43" fmla="*/ 49 h 415"/>
                <a:gd name="T44" fmla="*/ 219 w 305"/>
                <a:gd name="T45" fmla="*/ 24 h 415"/>
                <a:gd name="T46" fmla="*/ 238 w 305"/>
                <a:gd name="T47" fmla="*/ 24 h 415"/>
                <a:gd name="T48" fmla="*/ 238 w 305"/>
                <a:gd name="T49" fmla="*/ 12 h 415"/>
                <a:gd name="T50" fmla="*/ 305 w 305"/>
                <a:gd name="T51" fmla="*/ 12 h 415"/>
                <a:gd name="T52" fmla="*/ 305 w 305"/>
                <a:gd name="T53" fmla="*/ 0 h 4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</a:cxnLst>
              <a:rect l="0" t="0" r="r" b="b"/>
              <a:pathLst>
                <a:path w="305" h="415">
                  <a:moveTo>
                    <a:pt x="0" y="415"/>
                  </a:moveTo>
                  <a:lnTo>
                    <a:pt x="86" y="415"/>
                  </a:lnTo>
                  <a:lnTo>
                    <a:pt x="86" y="403"/>
                  </a:lnTo>
                  <a:lnTo>
                    <a:pt x="105" y="403"/>
                  </a:lnTo>
                  <a:lnTo>
                    <a:pt x="105" y="391"/>
                  </a:lnTo>
                  <a:lnTo>
                    <a:pt x="114" y="391"/>
                  </a:lnTo>
                  <a:lnTo>
                    <a:pt x="114" y="378"/>
                  </a:lnTo>
                  <a:lnTo>
                    <a:pt x="124" y="378"/>
                  </a:lnTo>
                  <a:lnTo>
                    <a:pt x="124" y="354"/>
                  </a:lnTo>
                  <a:lnTo>
                    <a:pt x="133" y="354"/>
                  </a:lnTo>
                  <a:lnTo>
                    <a:pt x="133" y="330"/>
                  </a:lnTo>
                  <a:lnTo>
                    <a:pt x="143" y="330"/>
                  </a:lnTo>
                  <a:lnTo>
                    <a:pt x="143" y="244"/>
                  </a:lnTo>
                  <a:lnTo>
                    <a:pt x="152" y="244"/>
                  </a:lnTo>
                  <a:lnTo>
                    <a:pt x="152" y="159"/>
                  </a:lnTo>
                  <a:lnTo>
                    <a:pt x="162" y="159"/>
                  </a:lnTo>
                  <a:lnTo>
                    <a:pt x="162" y="134"/>
                  </a:lnTo>
                  <a:lnTo>
                    <a:pt x="172" y="134"/>
                  </a:lnTo>
                  <a:lnTo>
                    <a:pt x="172" y="85"/>
                  </a:lnTo>
                  <a:lnTo>
                    <a:pt x="181" y="85"/>
                  </a:lnTo>
                  <a:lnTo>
                    <a:pt x="181" y="49"/>
                  </a:lnTo>
                  <a:lnTo>
                    <a:pt x="219" y="49"/>
                  </a:lnTo>
                  <a:lnTo>
                    <a:pt x="219" y="24"/>
                  </a:lnTo>
                  <a:lnTo>
                    <a:pt x="238" y="24"/>
                  </a:lnTo>
                  <a:lnTo>
                    <a:pt x="238" y="12"/>
                  </a:lnTo>
                  <a:lnTo>
                    <a:pt x="305" y="12"/>
                  </a:lnTo>
                  <a:lnTo>
                    <a:pt x="305" y="0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4" name="Freeform 35">
              <a:extLst>
                <a:ext uri="{FF2B5EF4-FFF2-40B4-BE49-F238E27FC236}">
                  <a16:creationId xmlns:a16="http://schemas.microsoft.com/office/drawing/2014/main" id="{F27854F4-6DBB-237A-750C-BB28F73A4413}"/>
                </a:ext>
              </a:extLst>
            </p:cNvPr>
            <p:cNvSpPr>
              <a:spLocks/>
            </p:cNvSpPr>
            <p:nvPr/>
          </p:nvSpPr>
          <p:spPr bwMode="auto">
            <a:xfrm>
              <a:off x="-1679" y="351"/>
              <a:ext cx="974" cy="841"/>
            </a:xfrm>
            <a:custGeom>
              <a:avLst/>
              <a:gdLst>
                <a:gd name="T0" fmla="*/ 0 w 401"/>
                <a:gd name="T1" fmla="*/ 415 h 415"/>
                <a:gd name="T2" fmla="*/ 152 w 401"/>
                <a:gd name="T3" fmla="*/ 415 h 415"/>
                <a:gd name="T4" fmla="*/ 152 w 401"/>
                <a:gd name="T5" fmla="*/ 383 h 415"/>
                <a:gd name="T6" fmla="*/ 162 w 401"/>
                <a:gd name="T7" fmla="*/ 383 h 415"/>
                <a:gd name="T8" fmla="*/ 162 w 401"/>
                <a:gd name="T9" fmla="*/ 335 h 415"/>
                <a:gd name="T10" fmla="*/ 172 w 401"/>
                <a:gd name="T11" fmla="*/ 335 h 415"/>
                <a:gd name="T12" fmla="*/ 172 w 401"/>
                <a:gd name="T13" fmla="*/ 319 h 415"/>
                <a:gd name="T14" fmla="*/ 181 w 401"/>
                <a:gd name="T15" fmla="*/ 319 h 415"/>
                <a:gd name="T16" fmla="*/ 181 w 401"/>
                <a:gd name="T17" fmla="*/ 287 h 415"/>
                <a:gd name="T18" fmla="*/ 191 w 401"/>
                <a:gd name="T19" fmla="*/ 287 h 415"/>
                <a:gd name="T20" fmla="*/ 191 w 401"/>
                <a:gd name="T21" fmla="*/ 239 h 415"/>
                <a:gd name="T22" fmla="*/ 200 w 401"/>
                <a:gd name="T23" fmla="*/ 239 h 415"/>
                <a:gd name="T24" fmla="*/ 200 w 401"/>
                <a:gd name="T25" fmla="*/ 207 h 415"/>
                <a:gd name="T26" fmla="*/ 210 w 401"/>
                <a:gd name="T27" fmla="*/ 207 h 415"/>
                <a:gd name="T28" fmla="*/ 210 w 401"/>
                <a:gd name="T29" fmla="*/ 175 h 415"/>
                <a:gd name="T30" fmla="*/ 219 w 401"/>
                <a:gd name="T31" fmla="*/ 175 h 415"/>
                <a:gd name="T32" fmla="*/ 219 w 401"/>
                <a:gd name="T33" fmla="*/ 159 h 415"/>
                <a:gd name="T34" fmla="*/ 229 w 401"/>
                <a:gd name="T35" fmla="*/ 159 h 415"/>
                <a:gd name="T36" fmla="*/ 229 w 401"/>
                <a:gd name="T37" fmla="*/ 112 h 415"/>
                <a:gd name="T38" fmla="*/ 267 w 401"/>
                <a:gd name="T39" fmla="*/ 112 h 415"/>
                <a:gd name="T40" fmla="*/ 267 w 401"/>
                <a:gd name="T41" fmla="*/ 80 h 415"/>
                <a:gd name="T42" fmla="*/ 286 w 401"/>
                <a:gd name="T43" fmla="*/ 80 h 415"/>
                <a:gd name="T44" fmla="*/ 286 w 401"/>
                <a:gd name="T45" fmla="*/ 64 h 415"/>
                <a:gd name="T46" fmla="*/ 296 w 401"/>
                <a:gd name="T47" fmla="*/ 64 h 415"/>
                <a:gd name="T48" fmla="*/ 296 w 401"/>
                <a:gd name="T49" fmla="*/ 48 h 415"/>
                <a:gd name="T50" fmla="*/ 353 w 401"/>
                <a:gd name="T51" fmla="*/ 48 h 415"/>
                <a:gd name="T52" fmla="*/ 353 w 401"/>
                <a:gd name="T53" fmla="*/ 32 h 415"/>
                <a:gd name="T54" fmla="*/ 372 w 401"/>
                <a:gd name="T55" fmla="*/ 32 h 415"/>
                <a:gd name="T56" fmla="*/ 372 w 401"/>
                <a:gd name="T57" fmla="*/ 16 h 415"/>
                <a:gd name="T58" fmla="*/ 401 w 401"/>
                <a:gd name="T59" fmla="*/ 16 h 415"/>
                <a:gd name="T60" fmla="*/ 401 w 401"/>
                <a:gd name="T61" fmla="*/ 0 h 4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401" h="415">
                  <a:moveTo>
                    <a:pt x="0" y="415"/>
                  </a:moveTo>
                  <a:lnTo>
                    <a:pt x="152" y="415"/>
                  </a:lnTo>
                  <a:lnTo>
                    <a:pt x="152" y="383"/>
                  </a:lnTo>
                  <a:lnTo>
                    <a:pt x="162" y="383"/>
                  </a:lnTo>
                  <a:lnTo>
                    <a:pt x="162" y="335"/>
                  </a:lnTo>
                  <a:lnTo>
                    <a:pt x="172" y="335"/>
                  </a:lnTo>
                  <a:lnTo>
                    <a:pt x="172" y="319"/>
                  </a:lnTo>
                  <a:lnTo>
                    <a:pt x="181" y="319"/>
                  </a:lnTo>
                  <a:lnTo>
                    <a:pt x="181" y="287"/>
                  </a:lnTo>
                  <a:lnTo>
                    <a:pt x="191" y="287"/>
                  </a:lnTo>
                  <a:lnTo>
                    <a:pt x="191" y="239"/>
                  </a:lnTo>
                  <a:lnTo>
                    <a:pt x="200" y="239"/>
                  </a:lnTo>
                  <a:lnTo>
                    <a:pt x="200" y="207"/>
                  </a:lnTo>
                  <a:lnTo>
                    <a:pt x="210" y="207"/>
                  </a:lnTo>
                  <a:lnTo>
                    <a:pt x="210" y="175"/>
                  </a:lnTo>
                  <a:lnTo>
                    <a:pt x="219" y="175"/>
                  </a:lnTo>
                  <a:lnTo>
                    <a:pt x="219" y="159"/>
                  </a:lnTo>
                  <a:lnTo>
                    <a:pt x="229" y="159"/>
                  </a:lnTo>
                  <a:lnTo>
                    <a:pt x="229" y="112"/>
                  </a:lnTo>
                  <a:lnTo>
                    <a:pt x="267" y="112"/>
                  </a:lnTo>
                  <a:lnTo>
                    <a:pt x="267" y="80"/>
                  </a:lnTo>
                  <a:lnTo>
                    <a:pt x="286" y="80"/>
                  </a:lnTo>
                  <a:lnTo>
                    <a:pt x="286" y="64"/>
                  </a:lnTo>
                  <a:lnTo>
                    <a:pt x="296" y="64"/>
                  </a:lnTo>
                  <a:lnTo>
                    <a:pt x="296" y="48"/>
                  </a:lnTo>
                  <a:lnTo>
                    <a:pt x="353" y="48"/>
                  </a:lnTo>
                  <a:lnTo>
                    <a:pt x="353" y="32"/>
                  </a:lnTo>
                  <a:lnTo>
                    <a:pt x="372" y="32"/>
                  </a:lnTo>
                  <a:lnTo>
                    <a:pt x="372" y="16"/>
                  </a:lnTo>
                  <a:lnTo>
                    <a:pt x="401" y="16"/>
                  </a:lnTo>
                  <a:lnTo>
                    <a:pt x="401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3" name="AutoShape 3">
            <a:extLst>
              <a:ext uri="{FF2B5EF4-FFF2-40B4-BE49-F238E27FC236}">
                <a16:creationId xmlns:a16="http://schemas.microsoft.com/office/drawing/2014/main" id="{22B23E7B-2987-4969-80BD-305B6D9F2F26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757801" y="950911"/>
            <a:ext cx="2519362" cy="2519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21" name="テキスト ボックス 620">
            <a:extLst>
              <a:ext uri="{FF2B5EF4-FFF2-40B4-BE49-F238E27FC236}">
                <a16:creationId xmlns:a16="http://schemas.microsoft.com/office/drawing/2014/main" id="{4A44C355-83C2-A236-E901-49A13FDAD532}"/>
              </a:ext>
            </a:extLst>
          </p:cNvPr>
          <p:cNvSpPr txBox="1"/>
          <p:nvPr/>
        </p:nvSpPr>
        <p:spPr>
          <a:xfrm>
            <a:off x="434019" y="447205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2" name="テキスト ボックス 621">
            <a:extLst>
              <a:ext uri="{FF2B5EF4-FFF2-40B4-BE49-F238E27FC236}">
                <a16:creationId xmlns:a16="http://schemas.microsoft.com/office/drawing/2014/main" id="{B8FE24A9-884E-AD59-7004-1039A2E85E92}"/>
              </a:ext>
            </a:extLst>
          </p:cNvPr>
          <p:cNvSpPr txBox="1"/>
          <p:nvPr/>
        </p:nvSpPr>
        <p:spPr>
          <a:xfrm>
            <a:off x="434019" y="713428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3" name="テキスト ボックス 622">
            <a:extLst>
              <a:ext uri="{FF2B5EF4-FFF2-40B4-BE49-F238E27FC236}">
                <a16:creationId xmlns:a16="http://schemas.microsoft.com/office/drawing/2014/main" id="{D480E380-A81C-C7FC-474B-1435B5A2CDA5}"/>
              </a:ext>
            </a:extLst>
          </p:cNvPr>
          <p:cNvSpPr txBox="1"/>
          <p:nvPr/>
        </p:nvSpPr>
        <p:spPr>
          <a:xfrm>
            <a:off x="434019" y="979651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4" name="テキスト ボックス 623">
            <a:extLst>
              <a:ext uri="{FF2B5EF4-FFF2-40B4-BE49-F238E27FC236}">
                <a16:creationId xmlns:a16="http://schemas.microsoft.com/office/drawing/2014/main" id="{688B83A4-5A13-1983-747A-3EDAB72D0908}"/>
              </a:ext>
            </a:extLst>
          </p:cNvPr>
          <p:cNvSpPr txBox="1"/>
          <p:nvPr/>
        </p:nvSpPr>
        <p:spPr>
          <a:xfrm>
            <a:off x="434019" y="1245874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5" name="テキスト ボックス 624">
            <a:extLst>
              <a:ext uri="{FF2B5EF4-FFF2-40B4-BE49-F238E27FC236}">
                <a16:creationId xmlns:a16="http://schemas.microsoft.com/office/drawing/2014/main" id="{B52F40DC-D93A-0CAC-E5B0-8CF809882259}"/>
              </a:ext>
            </a:extLst>
          </p:cNvPr>
          <p:cNvSpPr txBox="1"/>
          <p:nvPr/>
        </p:nvSpPr>
        <p:spPr>
          <a:xfrm>
            <a:off x="434019" y="1512097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6" name="テキスト ボックス 625">
            <a:extLst>
              <a:ext uri="{FF2B5EF4-FFF2-40B4-BE49-F238E27FC236}">
                <a16:creationId xmlns:a16="http://schemas.microsoft.com/office/drawing/2014/main" id="{EDEC3681-6CDD-0020-8A72-42EEFD1579DA}"/>
              </a:ext>
            </a:extLst>
          </p:cNvPr>
          <p:cNvSpPr txBox="1"/>
          <p:nvPr/>
        </p:nvSpPr>
        <p:spPr>
          <a:xfrm>
            <a:off x="434019" y="1778320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7" name="Rectangle 151">
            <a:extLst>
              <a:ext uri="{FF2B5EF4-FFF2-40B4-BE49-F238E27FC236}">
                <a16:creationId xmlns:a16="http://schemas.microsoft.com/office/drawing/2014/main" id="{9310F056-F1B8-A9F0-C7AB-170FC57C825F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324045" y="1162883"/>
            <a:ext cx="145392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Neutrophil engraftment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628" name="Rectangle 339">
            <a:extLst>
              <a:ext uri="{FF2B5EF4-FFF2-40B4-BE49-F238E27FC236}">
                <a16:creationId xmlns:a16="http://schemas.microsoft.com/office/drawing/2014/main" id="{473CEF82-DF6F-2291-F868-739E250E3B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3156" y="2017180"/>
            <a:ext cx="7694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9" name="Rectangle 340">
            <a:extLst>
              <a:ext uri="{FF2B5EF4-FFF2-40B4-BE49-F238E27FC236}">
                <a16:creationId xmlns:a16="http://schemas.microsoft.com/office/drawing/2014/main" id="{6A1903DC-31C0-0B11-EE97-7902C21B75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0501" y="2017180"/>
            <a:ext cx="153888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0" name="Rectangle 341">
            <a:extLst>
              <a:ext uri="{FF2B5EF4-FFF2-40B4-BE49-F238E27FC236}">
                <a16:creationId xmlns:a16="http://schemas.microsoft.com/office/drawing/2014/main" id="{4F1EA448-2EB8-E936-56EE-2F8650F235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1614" y="2017180"/>
            <a:ext cx="153888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1" name="Rectangle 342">
            <a:extLst>
              <a:ext uri="{FF2B5EF4-FFF2-40B4-BE49-F238E27FC236}">
                <a16:creationId xmlns:a16="http://schemas.microsoft.com/office/drawing/2014/main" id="{7B919025-6D05-EB33-11D6-3245E578A2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90036" y="2017180"/>
            <a:ext cx="153888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2" name="Rectangle 343">
            <a:extLst>
              <a:ext uri="{FF2B5EF4-FFF2-40B4-BE49-F238E27FC236}">
                <a16:creationId xmlns:a16="http://schemas.microsoft.com/office/drawing/2014/main" id="{DA6BD939-632D-F692-1622-AA7FF7A148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59164" y="2017180"/>
            <a:ext cx="15388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3" name="Rectangle 344">
            <a:extLst>
              <a:ext uri="{FF2B5EF4-FFF2-40B4-BE49-F238E27FC236}">
                <a16:creationId xmlns:a16="http://schemas.microsoft.com/office/drawing/2014/main" id="{BF559F6C-5572-D379-6405-BFC0C34DD1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5912" y="2017180"/>
            <a:ext cx="15388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6" name="Rectangle 150">
            <a:extLst>
              <a:ext uri="{FF2B5EF4-FFF2-40B4-BE49-F238E27FC236}">
                <a16:creationId xmlns:a16="http://schemas.microsoft.com/office/drawing/2014/main" id="{3A66BFE9-D538-267A-87DD-EF6D197BAE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08431" y="2200233"/>
            <a:ext cx="135293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Day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s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after allo-HSCT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637" name="Rectangle 339">
            <a:extLst>
              <a:ext uri="{FF2B5EF4-FFF2-40B4-BE49-F238E27FC236}">
                <a16:creationId xmlns:a16="http://schemas.microsoft.com/office/drawing/2014/main" id="{119ACB62-4971-2B46-DD65-F13AE82526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3920" y="2523409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8" name="Rectangle 340">
            <a:extLst>
              <a:ext uri="{FF2B5EF4-FFF2-40B4-BE49-F238E27FC236}">
                <a16:creationId xmlns:a16="http://schemas.microsoft.com/office/drawing/2014/main" id="{613311D7-66BA-9F9D-0089-3A0AE465EF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69737" y="2523409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3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9" name="Rectangle 341">
            <a:extLst>
              <a:ext uri="{FF2B5EF4-FFF2-40B4-BE49-F238E27FC236}">
                <a16:creationId xmlns:a16="http://schemas.microsoft.com/office/drawing/2014/main" id="{A92D3523-8D6C-143F-0468-9CD66B781D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69704" y="2523409"/>
            <a:ext cx="57708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0" name="Rectangle 342">
            <a:extLst>
              <a:ext uri="{FF2B5EF4-FFF2-40B4-BE49-F238E27FC236}">
                <a16:creationId xmlns:a16="http://schemas.microsoft.com/office/drawing/2014/main" id="{B633BF39-4927-BC67-9F17-2CE6BB7D58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38126" y="2523409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1" name="Rectangle 343">
            <a:extLst>
              <a:ext uri="{FF2B5EF4-FFF2-40B4-BE49-F238E27FC236}">
                <a16:creationId xmlns:a16="http://schemas.microsoft.com/office/drawing/2014/main" id="{FDEB83E4-3D0E-1CD1-E15A-53721D89B6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07254" y="2523409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2" name="Rectangle 344">
            <a:extLst>
              <a:ext uri="{FF2B5EF4-FFF2-40B4-BE49-F238E27FC236}">
                <a16:creationId xmlns:a16="http://schemas.microsoft.com/office/drawing/2014/main" id="{C90D5469-0860-8AB9-90D5-6AE425218D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74002" y="2523409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6" name="Rectangle 339">
            <a:extLst>
              <a:ext uri="{FF2B5EF4-FFF2-40B4-BE49-F238E27FC236}">
                <a16:creationId xmlns:a16="http://schemas.microsoft.com/office/drawing/2014/main" id="{BE9BE048-A336-760D-939D-731A1C4E4D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0583" y="2383189"/>
            <a:ext cx="692497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5" name="Rectangle 339">
            <a:extLst>
              <a:ext uri="{FF2B5EF4-FFF2-40B4-BE49-F238E27FC236}">
                <a16:creationId xmlns:a16="http://schemas.microsoft.com/office/drawing/2014/main" id="{C03DF898-27B0-6090-DF78-28C667B04C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3920" y="2663389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6" name="Rectangle 340">
            <a:extLst>
              <a:ext uri="{FF2B5EF4-FFF2-40B4-BE49-F238E27FC236}">
                <a16:creationId xmlns:a16="http://schemas.microsoft.com/office/drawing/2014/main" id="{F42B75B4-2EAA-7BB9-77A9-620D3EF731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69737" y="2663389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7" name="Rectangle 341">
            <a:extLst>
              <a:ext uri="{FF2B5EF4-FFF2-40B4-BE49-F238E27FC236}">
                <a16:creationId xmlns:a16="http://schemas.microsoft.com/office/drawing/2014/main" id="{9E7B2FBC-5D57-1D6D-31A9-F81E8DDBD9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40850" y="2663389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8" name="Rectangle 342">
            <a:extLst>
              <a:ext uri="{FF2B5EF4-FFF2-40B4-BE49-F238E27FC236}">
                <a16:creationId xmlns:a16="http://schemas.microsoft.com/office/drawing/2014/main" id="{A59016FA-268A-E9BD-3B22-D242FFC90E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38126" y="2663389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9" name="Rectangle 343">
            <a:extLst>
              <a:ext uri="{FF2B5EF4-FFF2-40B4-BE49-F238E27FC236}">
                <a16:creationId xmlns:a16="http://schemas.microsoft.com/office/drawing/2014/main" id="{C9E25A0A-4C38-9B3F-C355-EB4F022076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07254" y="2663389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0" name="Rectangle 344">
            <a:extLst>
              <a:ext uri="{FF2B5EF4-FFF2-40B4-BE49-F238E27FC236}">
                <a16:creationId xmlns:a16="http://schemas.microsoft.com/office/drawing/2014/main" id="{7100AA0A-75D0-F4A6-E54B-8A0A37E01E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74002" y="2663389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0" name="Rectangle 339">
            <a:extLst>
              <a:ext uri="{FF2B5EF4-FFF2-40B4-BE49-F238E27FC236}">
                <a16:creationId xmlns:a16="http://schemas.microsoft.com/office/drawing/2014/main" id="{291B83ED-0F56-5C3B-74C4-097E3174F0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33987" y="2525790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1" name="Rectangle 340">
            <a:extLst>
              <a:ext uri="{FF2B5EF4-FFF2-40B4-BE49-F238E27FC236}">
                <a16:creationId xmlns:a16="http://schemas.microsoft.com/office/drawing/2014/main" id="{DF9A5616-5E56-CD1B-0A70-09635DDF1A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3067" y="2525790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3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2" name="Rectangle 341">
            <a:extLst>
              <a:ext uri="{FF2B5EF4-FFF2-40B4-BE49-F238E27FC236}">
                <a16:creationId xmlns:a16="http://schemas.microsoft.com/office/drawing/2014/main" id="{2A0B2BA4-825C-B30A-7AE2-A9FDEE3FCF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82164" y="2525790"/>
            <a:ext cx="57708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3" name="Rectangle 342">
            <a:extLst>
              <a:ext uri="{FF2B5EF4-FFF2-40B4-BE49-F238E27FC236}">
                <a16:creationId xmlns:a16="http://schemas.microsoft.com/office/drawing/2014/main" id="{C767CDC7-9AD1-4D48-6E73-9FF7DC1F86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42641" y="2525790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4" name="Rectangle 343">
            <a:extLst>
              <a:ext uri="{FF2B5EF4-FFF2-40B4-BE49-F238E27FC236}">
                <a16:creationId xmlns:a16="http://schemas.microsoft.com/office/drawing/2014/main" id="{324EFFF1-0668-0040-4E63-08674324BE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03117" y="2525790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6" name="Rectangle 339">
            <a:extLst>
              <a:ext uri="{FF2B5EF4-FFF2-40B4-BE49-F238E27FC236}">
                <a16:creationId xmlns:a16="http://schemas.microsoft.com/office/drawing/2014/main" id="{C4F7149C-D4D3-61E2-F036-F8AA5BD20F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43064" y="2383189"/>
            <a:ext cx="692497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7" name="Rectangle 339">
            <a:extLst>
              <a:ext uri="{FF2B5EF4-FFF2-40B4-BE49-F238E27FC236}">
                <a16:creationId xmlns:a16="http://schemas.microsoft.com/office/drawing/2014/main" id="{AF39313C-3722-D346-258F-0052059973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33987" y="2665770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8" name="Rectangle 340">
            <a:extLst>
              <a:ext uri="{FF2B5EF4-FFF2-40B4-BE49-F238E27FC236}">
                <a16:creationId xmlns:a16="http://schemas.microsoft.com/office/drawing/2014/main" id="{C7965EE8-86BF-6B99-E678-ED8B08291B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3067" y="2665770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9" name="Rectangle 341">
            <a:extLst>
              <a:ext uri="{FF2B5EF4-FFF2-40B4-BE49-F238E27FC236}">
                <a16:creationId xmlns:a16="http://schemas.microsoft.com/office/drawing/2014/main" id="{8E8F1DCC-2878-7E85-05E5-DD4AA74525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82164" y="2665770"/>
            <a:ext cx="57708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0" name="Rectangle 342">
            <a:extLst>
              <a:ext uri="{FF2B5EF4-FFF2-40B4-BE49-F238E27FC236}">
                <a16:creationId xmlns:a16="http://schemas.microsoft.com/office/drawing/2014/main" id="{ED3160B2-67DE-4778-FBCE-29247E39AA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42641" y="2665770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2" name="Rectangle 344">
            <a:extLst>
              <a:ext uri="{FF2B5EF4-FFF2-40B4-BE49-F238E27FC236}">
                <a16:creationId xmlns:a16="http://schemas.microsoft.com/office/drawing/2014/main" id="{C3379126-60FD-08DD-EB5D-16D2B8675C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03117" y="2665770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3" name="Rectangle 339">
            <a:extLst>
              <a:ext uri="{FF2B5EF4-FFF2-40B4-BE49-F238E27FC236}">
                <a16:creationId xmlns:a16="http://schemas.microsoft.com/office/drawing/2014/main" id="{4B42ADB2-7A5F-65D0-7391-C39F4D7A83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53223" y="2018041"/>
            <a:ext cx="7694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4" name="Rectangle 340">
            <a:extLst>
              <a:ext uri="{FF2B5EF4-FFF2-40B4-BE49-F238E27FC236}">
                <a16:creationId xmlns:a16="http://schemas.microsoft.com/office/drawing/2014/main" id="{679CEC10-51DA-323A-D891-8EB120CC21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73831" y="2018041"/>
            <a:ext cx="153888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5" name="Rectangle 341">
            <a:extLst>
              <a:ext uri="{FF2B5EF4-FFF2-40B4-BE49-F238E27FC236}">
                <a16:creationId xmlns:a16="http://schemas.microsoft.com/office/drawing/2014/main" id="{43D4DB34-9F6C-277C-B09F-0CDDCDA952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34074" y="2018041"/>
            <a:ext cx="153888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6" name="Rectangle 342">
            <a:extLst>
              <a:ext uri="{FF2B5EF4-FFF2-40B4-BE49-F238E27FC236}">
                <a16:creationId xmlns:a16="http://schemas.microsoft.com/office/drawing/2014/main" id="{30318C18-09F6-C4C1-76EC-1E45733B25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94551" y="2018041"/>
            <a:ext cx="153888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7" name="Rectangle 343">
            <a:extLst>
              <a:ext uri="{FF2B5EF4-FFF2-40B4-BE49-F238E27FC236}">
                <a16:creationId xmlns:a16="http://schemas.microsoft.com/office/drawing/2014/main" id="{F2ACEC43-9CCA-0BA8-CD8F-5C3427E1ED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55027" y="2018041"/>
            <a:ext cx="15388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8" name="テキスト ボックス 617">
            <a:extLst>
              <a:ext uri="{FF2B5EF4-FFF2-40B4-BE49-F238E27FC236}">
                <a16:creationId xmlns:a16="http://schemas.microsoft.com/office/drawing/2014/main" id="{4E986DCD-BDBE-E26E-6EFB-7AF59FDDDFE6}"/>
              </a:ext>
            </a:extLst>
          </p:cNvPr>
          <p:cNvSpPr txBox="1"/>
          <p:nvPr/>
        </p:nvSpPr>
        <p:spPr>
          <a:xfrm>
            <a:off x="3865962" y="442443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9" name="テキスト ボックス 618">
            <a:extLst>
              <a:ext uri="{FF2B5EF4-FFF2-40B4-BE49-F238E27FC236}">
                <a16:creationId xmlns:a16="http://schemas.microsoft.com/office/drawing/2014/main" id="{5781BCF9-839E-1190-2C08-B0AFC85B5ED1}"/>
              </a:ext>
            </a:extLst>
          </p:cNvPr>
          <p:cNvSpPr txBox="1"/>
          <p:nvPr/>
        </p:nvSpPr>
        <p:spPr>
          <a:xfrm>
            <a:off x="3865962" y="709618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0" name="テキスト ボックス 619">
            <a:extLst>
              <a:ext uri="{FF2B5EF4-FFF2-40B4-BE49-F238E27FC236}">
                <a16:creationId xmlns:a16="http://schemas.microsoft.com/office/drawing/2014/main" id="{E7A1B9C6-C3C4-2CE4-E987-B7CB0CDB5F10}"/>
              </a:ext>
            </a:extLst>
          </p:cNvPr>
          <p:cNvSpPr txBox="1"/>
          <p:nvPr/>
        </p:nvSpPr>
        <p:spPr>
          <a:xfrm>
            <a:off x="3865962" y="976793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4" name="テキスト ボックス 633">
            <a:extLst>
              <a:ext uri="{FF2B5EF4-FFF2-40B4-BE49-F238E27FC236}">
                <a16:creationId xmlns:a16="http://schemas.microsoft.com/office/drawing/2014/main" id="{B9D09F57-BC76-9F53-3D02-599845BC56ED}"/>
              </a:ext>
            </a:extLst>
          </p:cNvPr>
          <p:cNvSpPr txBox="1"/>
          <p:nvPr/>
        </p:nvSpPr>
        <p:spPr>
          <a:xfrm>
            <a:off x="3865962" y="1243968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5" name="テキスト ボックス 634">
            <a:extLst>
              <a:ext uri="{FF2B5EF4-FFF2-40B4-BE49-F238E27FC236}">
                <a16:creationId xmlns:a16="http://schemas.microsoft.com/office/drawing/2014/main" id="{D60690AA-042E-B126-E94C-BD8D1F36BF8A}"/>
              </a:ext>
            </a:extLst>
          </p:cNvPr>
          <p:cNvSpPr txBox="1"/>
          <p:nvPr/>
        </p:nvSpPr>
        <p:spPr>
          <a:xfrm>
            <a:off x="3865962" y="1511143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3" name="テキスト ボックス 642">
            <a:extLst>
              <a:ext uri="{FF2B5EF4-FFF2-40B4-BE49-F238E27FC236}">
                <a16:creationId xmlns:a16="http://schemas.microsoft.com/office/drawing/2014/main" id="{34AC00F1-AAC1-41B4-8C5A-BCF616A0C885}"/>
              </a:ext>
            </a:extLst>
          </p:cNvPr>
          <p:cNvSpPr txBox="1"/>
          <p:nvPr/>
        </p:nvSpPr>
        <p:spPr>
          <a:xfrm>
            <a:off x="3865962" y="1778320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4" name="Rectangle 151">
            <a:extLst>
              <a:ext uri="{FF2B5EF4-FFF2-40B4-BE49-F238E27FC236}">
                <a16:creationId xmlns:a16="http://schemas.microsoft.com/office/drawing/2014/main" id="{E8A7343F-2E07-763C-E092-2E3FA6FCCBCA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210226" y="1158887"/>
            <a:ext cx="1250343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P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latelet engraftment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645" name="Rectangle 150">
            <a:extLst>
              <a:ext uri="{FF2B5EF4-FFF2-40B4-BE49-F238E27FC236}">
                <a16:creationId xmlns:a16="http://schemas.microsoft.com/office/drawing/2014/main" id="{B813D2B8-811E-D29B-B07B-A4BA33E051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33849" y="2202608"/>
            <a:ext cx="135293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Day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s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after allo-HSCT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60" name="Line 153">
            <a:extLst>
              <a:ext uri="{FF2B5EF4-FFF2-40B4-BE49-F238E27FC236}">
                <a16:creationId xmlns:a16="http://schemas.microsoft.com/office/drawing/2014/main" id="{87CEC10C-39FB-78D8-3824-078ACD35B95F}"/>
              </a:ext>
            </a:extLst>
          </p:cNvPr>
          <p:cNvSpPr>
            <a:spLocks noChangeShapeType="1"/>
          </p:cNvSpPr>
          <p:nvPr/>
        </p:nvSpPr>
        <p:spPr bwMode="auto">
          <a:xfrm>
            <a:off x="1697797" y="1694650"/>
            <a:ext cx="180000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1" name="Line 154">
            <a:extLst>
              <a:ext uri="{FF2B5EF4-FFF2-40B4-BE49-F238E27FC236}">
                <a16:creationId xmlns:a16="http://schemas.microsoft.com/office/drawing/2014/main" id="{3B45E21C-F558-08CA-AF89-ED3AB49DE8CF}"/>
              </a:ext>
            </a:extLst>
          </p:cNvPr>
          <p:cNvSpPr>
            <a:spLocks noChangeShapeType="1"/>
          </p:cNvSpPr>
          <p:nvPr/>
        </p:nvSpPr>
        <p:spPr bwMode="auto">
          <a:xfrm>
            <a:off x="1697797" y="1828779"/>
            <a:ext cx="18000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5" name="Rectangle 339">
            <a:extLst>
              <a:ext uri="{FF2B5EF4-FFF2-40B4-BE49-F238E27FC236}">
                <a16:creationId xmlns:a16="http://schemas.microsoft.com/office/drawing/2014/main" id="{85C58F71-542C-AA69-E82D-3BC938F66D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43502" y="1624388"/>
            <a:ext cx="480901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ymphoid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7" name="Rectangle 339">
            <a:extLst>
              <a:ext uri="{FF2B5EF4-FFF2-40B4-BE49-F238E27FC236}">
                <a16:creationId xmlns:a16="http://schemas.microsoft.com/office/drawing/2014/main" id="{574571E1-352A-B222-6F7A-DFFA9D7A2D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43502" y="1762496"/>
            <a:ext cx="391133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eloid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9" name="Line 153">
            <a:extLst>
              <a:ext uri="{FF2B5EF4-FFF2-40B4-BE49-F238E27FC236}">
                <a16:creationId xmlns:a16="http://schemas.microsoft.com/office/drawing/2014/main" id="{26FFAE55-E098-B359-951F-D41AFC4BBDD2}"/>
              </a:ext>
            </a:extLst>
          </p:cNvPr>
          <p:cNvSpPr>
            <a:spLocks noChangeShapeType="1"/>
          </p:cNvSpPr>
          <p:nvPr/>
        </p:nvSpPr>
        <p:spPr bwMode="auto">
          <a:xfrm>
            <a:off x="5298641" y="1693026"/>
            <a:ext cx="180000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1" name="Line 154">
            <a:extLst>
              <a:ext uri="{FF2B5EF4-FFF2-40B4-BE49-F238E27FC236}">
                <a16:creationId xmlns:a16="http://schemas.microsoft.com/office/drawing/2014/main" id="{56569EE5-57DE-993D-4AF1-11E3ECD9BD11}"/>
              </a:ext>
            </a:extLst>
          </p:cNvPr>
          <p:cNvSpPr>
            <a:spLocks noChangeShapeType="1"/>
          </p:cNvSpPr>
          <p:nvPr/>
        </p:nvSpPr>
        <p:spPr bwMode="auto">
          <a:xfrm>
            <a:off x="5298641" y="1827155"/>
            <a:ext cx="18000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3" name="Rectangle 339">
            <a:extLst>
              <a:ext uri="{FF2B5EF4-FFF2-40B4-BE49-F238E27FC236}">
                <a16:creationId xmlns:a16="http://schemas.microsoft.com/office/drawing/2014/main" id="{870E5087-0AD1-64F8-F292-7E99F7C150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44346" y="1622764"/>
            <a:ext cx="480901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ymphoid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5" name="Rectangle 339">
            <a:extLst>
              <a:ext uri="{FF2B5EF4-FFF2-40B4-BE49-F238E27FC236}">
                <a16:creationId xmlns:a16="http://schemas.microsoft.com/office/drawing/2014/main" id="{24378BA0-6A19-2EFE-A40B-A3BA777BF6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44346" y="1760872"/>
            <a:ext cx="391133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eloid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3" name="テキスト ボックス 362"/>
          <p:cNvSpPr txBox="1">
            <a:spLocks noChangeAspect="1"/>
          </p:cNvSpPr>
          <p:nvPr/>
        </p:nvSpPr>
        <p:spPr>
          <a:xfrm>
            <a:off x="-1934" y="72862"/>
            <a:ext cx="360000" cy="360000"/>
          </a:xfrm>
          <a:prstGeom prst="rect">
            <a:avLst/>
          </a:prstGeom>
          <a:noFill/>
          <a:ln w="3175">
            <a:noFill/>
          </a:ln>
        </p:spPr>
        <p:txBody>
          <a:bodyPr wrap="none" lIns="54000" tIns="54000" rIns="54000" bIns="54000" rtlCol="0" anchor="ctr" anchorCtr="1">
            <a:no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5" name="テキスト ボックス 364"/>
          <p:cNvSpPr txBox="1">
            <a:spLocks noChangeAspect="1"/>
          </p:cNvSpPr>
          <p:nvPr/>
        </p:nvSpPr>
        <p:spPr>
          <a:xfrm>
            <a:off x="3430422" y="72862"/>
            <a:ext cx="360000" cy="360000"/>
          </a:xfrm>
          <a:prstGeom prst="rect">
            <a:avLst/>
          </a:prstGeom>
          <a:noFill/>
          <a:ln w="3175">
            <a:noFill/>
          </a:ln>
        </p:spPr>
        <p:txBody>
          <a:bodyPr wrap="none" lIns="54000" tIns="54000" rIns="54000" bIns="54000" rtlCol="0" anchor="ctr" anchorCtr="1">
            <a:no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2" name="テキスト ボックス 261">
            <a:extLst>
              <a:ext uri="{FF2B5EF4-FFF2-40B4-BE49-F238E27FC236}">
                <a16:creationId xmlns:a16="http://schemas.microsoft.com/office/drawing/2014/main" id="{F7E8E904-B5DA-49B6-AAC8-113ED2209214}"/>
              </a:ext>
            </a:extLst>
          </p:cNvPr>
          <p:cNvSpPr txBox="1">
            <a:spLocks noChangeAspect="1"/>
          </p:cNvSpPr>
          <p:nvPr/>
        </p:nvSpPr>
        <p:spPr>
          <a:xfrm>
            <a:off x="447" y="2952766"/>
            <a:ext cx="360000" cy="360000"/>
          </a:xfrm>
          <a:prstGeom prst="rect">
            <a:avLst/>
          </a:prstGeom>
          <a:noFill/>
          <a:ln w="3175">
            <a:noFill/>
          </a:ln>
        </p:spPr>
        <p:txBody>
          <a:bodyPr wrap="none" lIns="54000" tIns="54000" rIns="54000" bIns="54000" rtlCol="0" anchor="ctr" anchorCtr="1">
            <a:no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5" name="Rectangle 339">
            <a:extLst>
              <a:ext uri="{FF2B5EF4-FFF2-40B4-BE49-F238E27FC236}">
                <a16:creationId xmlns:a16="http://schemas.microsoft.com/office/drawing/2014/main" id="{8B3A577E-13B8-4750-F8EC-AD873E3C7B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2797" y="5411345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8" name="Rectangle 340">
            <a:extLst>
              <a:ext uri="{FF2B5EF4-FFF2-40B4-BE49-F238E27FC236}">
                <a16:creationId xmlns:a16="http://schemas.microsoft.com/office/drawing/2014/main" id="{3653013D-FEC4-90BB-E51C-DE3C70E77C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71278" y="5411345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1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0" name="Rectangle 341">
            <a:extLst>
              <a:ext uri="{FF2B5EF4-FFF2-40B4-BE49-F238E27FC236}">
                <a16:creationId xmlns:a16="http://schemas.microsoft.com/office/drawing/2014/main" id="{1376E866-D9A6-BA70-3FC0-9F7DC7507D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57179" y="5411345"/>
            <a:ext cx="57708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2" name="Rectangle 342">
            <a:extLst>
              <a:ext uri="{FF2B5EF4-FFF2-40B4-BE49-F238E27FC236}">
                <a16:creationId xmlns:a16="http://schemas.microsoft.com/office/drawing/2014/main" id="{AD89E5A1-292E-6DDE-D69C-514813D161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21369" y="5411345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4" name="Rectangle 343">
            <a:extLst>
              <a:ext uri="{FF2B5EF4-FFF2-40B4-BE49-F238E27FC236}">
                <a16:creationId xmlns:a16="http://schemas.microsoft.com/office/drawing/2014/main" id="{AFE6B93D-6A17-6F64-48FE-A4D3DDD1B2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84335" y="5411345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6" name="Rectangle 339">
            <a:extLst>
              <a:ext uri="{FF2B5EF4-FFF2-40B4-BE49-F238E27FC236}">
                <a16:creationId xmlns:a16="http://schemas.microsoft.com/office/drawing/2014/main" id="{8CC9A5B4-2D8F-F86E-606D-8F443D68EE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0583" y="5259220"/>
            <a:ext cx="692497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7" name="Rectangle 339">
            <a:extLst>
              <a:ext uri="{FF2B5EF4-FFF2-40B4-BE49-F238E27FC236}">
                <a16:creationId xmlns:a16="http://schemas.microsoft.com/office/drawing/2014/main" id="{2BA3BDA0-0FB0-F5A5-A027-801E810D85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2797" y="5551324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8" name="Rectangle 340">
            <a:extLst>
              <a:ext uri="{FF2B5EF4-FFF2-40B4-BE49-F238E27FC236}">
                <a16:creationId xmlns:a16="http://schemas.microsoft.com/office/drawing/2014/main" id="{BAE382BD-82D4-051E-648D-126DD014E9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71278" y="5551324"/>
            <a:ext cx="115416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9" name="Rectangle 341">
            <a:extLst>
              <a:ext uri="{FF2B5EF4-FFF2-40B4-BE49-F238E27FC236}">
                <a16:creationId xmlns:a16="http://schemas.microsoft.com/office/drawing/2014/main" id="{CD73EEC5-12E9-1E78-2F0F-C093B06540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57179" y="5551324"/>
            <a:ext cx="57708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0" name="Rectangle 342">
            <a:extLst>
              <a:ext uri="{FF2B5EF4-FFF2-40B4-BE49-F238E27FC236}">
                <a16:creationId xmlns:a16="http://schemas.microsoft.com/office/drawing/2014/main" id="{369C7EA5-0093-C66A-4909-CC6B55B815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21369" y="5551324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1" name="Rectangle 343">
            <a:extLst>
              <a:ext uri="{FF2B5EF4-FFF2-40B4-BE49-F238E27FC236}">
                <a16:creationId xmlns:a16="http://schemas.microsoft.com/office/drawing/2014/main" id="{29334D04-B92E-B408-F544-CE9D045EF0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84335" y="5551324"/>
            <a:ext cx="5770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3" name="Rectangle 339">
            <a:extLst>
              <a:ext uri="{FF2B5EF4-FFF2-40B4-BE49-F238E27FC236}">
                <a16:creationId xmlns:a16="http://schemas.microsoft.com/office/drawing/2014/main" id="{F75EB1C0-E718-1E05-AC6A-A549F07E3F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2033" y="4892242"/>
            <a:ext cx="7694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4" name="Rectangle 340">
            <a:extLst>
              <a:ext uri="{FF2B5EF4-FFF2-40B4-BE49-F238E27FC236}">
                <a16:creationId xmlns:a16="http://schemas.microsoft.com/office/drawing/2014/main" id="{7F37077D-7C37-EAAF-6A26-95D5683AF8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52042" y="4892242"/>
            <a:ext cx="153888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5" name="Rectangle 341">
            <a:extLst>
              <a:ext uri="{FF2B5EF4-FFF2-40B4-BE49-F238E27FC236}">
                <a16:creationId xmlns:a16="http://schemas.microsoft.com/office/drawing/2014/main" id="{5A64F672-3282-5C07-3E38-51CC4DCC92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09089" y="4892242"/>
            <a:ext cx="153888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6" name="Rectangle 342">
            <a:extLst>
              <a:ext uri="{FF2B5EF4-FFF2-40B4-BE49-F238E27FC236}">
                <a16:creationId xmlns:a16="http://schemas.microsoft.com/office/drawing/2014/main" id="{A5C96608-E931-55A8-AEDD-E07AF92682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73279" y="4892242"/>
            <a:ext cx="153888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7" name="Rectangle 343">
            <a:extLst>
              <a:ext uri="{FF2B5EF4-FFF2-40B4-BE49-F238E27FC236}">
                <a16:creationId xmlns:a16="http://schemas.microsoft.com/office/drawing/2014/main" id="{76F65607-BB8E-C569-35C5-945A5CBA20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36245" y="4892242"/>
            <a:ext cx="15388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8" name="テキスト ボックス 307">
            <a:extLst>
              <a:ext uri="{FF2B5EF4-FFF2-40B4-BE49-F238E27FC236}">
                <a16:creationId xmlns:a16="http://schemas.microsoft.com/office/drawing/2014/main" id="{50EE19F1-47F5-CEF8-CF40-49367AECC769}"/>
              </a:ext>
            </a:extLst>
          </p:cNvPr>
          <p:cNvSpPr txBox="1"/>
          <p:nvPr/>
        </p:nvSpPr>
        <p:spPr>
          <a:xfrm>
            <a:off x="447977" y="3321576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9" name="テキスト ボックス 308">
            <a:extLst>
              <a:ext uri="{FF2B5EF4-FFF2-40B4-BE49-F238E27FC236}">
                <a16:creationId xmlns:a16="http://schemas.microsoft.com/office/drawing/2014/main" id="{EA8655D3-B4BD-111E-1ADA-ADE227BEC7C7}"/>
              </a:ext>
            </a:extLst>
          </p:cNvPr>
          <p:cNvSpPr txBox="1"/>
          <p:nvPr/>
        </p:nvSpPr>
        <p:spPr>
          <a:xfrm>
            <a:off x="447977" y="3588133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0" name="テキスト ボックス 309">
            <a:extLst>
              <a:ext uri="{FF2B5EF4-FFF2-40B4-BE49-F238E27FC236}">
                <a16:creationId xmlns:a16="http://schemas.microsoft.com/office/drawing/2014/main" id="{383510A6-0CC7-F52B-49E6-854FF0E363D0}"/>
              </a:ext>
            </a:extLst>
          </p:cNvPr>
          <p:cNvSpPr txBox="1"/>
          <p:nvPr/>
        </p:nvSpPr>
        <p:spPr>
          <a:xfrm>
            <a:off x="447977" y="3854690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1" name="テキスト ボックス 310">
            <a:extLst>
              <a:ext uri="{FF2B5EF4-FFF2-40B4-BE49-F238E27FC236}">
                <a16:creationId xmlns:a16="http://schemas.microsoft.com/office/drawing/2014/main" id="{50F78DB6-C4CE-EB46-63D8-E8EECD740211}"/>
              </a:ext>
            </a:extLst>
          </p:cNvPr>
          <p:cNvSpPr txBox="1"/>
          <p:nvPr/>
        </p:nvSpPr>
        <p:spPr>
          <a:xfrm>
            <a:off x="447977" y="4121247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2" name="テキスト ボックス 311">
            <a:extLst>
              <a:ext uri="{FF2B5EF4-FFF2-40B4-BE49-F238E27FC236}">
                <a16:creationId xmlns:a16="http://schemas.microsoft.com/office/drawing/2014/main" id="{7D42BA3E-F96F-FE6C-C81A-CBB1E6C8CECE}"/>
              </a:ext>
            </a:extLst>
          </p:cNvPr>
          <p:cNvSpPr txBox="1"/>
          <p:nvPr/>
        </p:nvSpPr>
        <p:spPr>
          <a:xfrm>
            <a:off x="447977" y="4387804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3" name="テキスト ボックス 312">
            <a:extLst>
              <a:ext uri="{FF2B5EF4-FFF2-40B4-BE49-F238E27FC236}">
                <a16:creationId xmlns:a16="http://schemas.microsoft.com/office/drawing/2014/main" id="{D4232182-BB2F-20D9-FE30-E6337DC13090}"/>
              </a:ext>
            </a:extLst>
          </p:cNvPr>
          <p:cNvSpPr txBox="1"/>
          <p:nvPr/>
        </p:nvSpPr>
        <p:spPr>
          <a:xfrm>
            <a:off x="447977" y="4654363"/>
            <a:ext cx="377026" cy="276999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4" name="Rectangle 151">
            <a:extLst>
              <a:ext uri="{FF2B5EF4-FFF2-40B4-BE49-F238E27FC236}">
                <a16:creationId xmlns:a16="http://schemas.microsoft.com/office/drawing/2014/main" id="{DA2E4602-B16C-538E-6E25-4687DE9B6908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128890" y="4036144"/>
            <a:ext cx="1093248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RBC engraftment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16" name="Rectangle 150">
            <a:extLst>
              <a:ext uri="{FF2B5EF4-FFF2-40B4-BE49-F238E27FC236}">
                <a16:creationId xmlns:a16="http://schemas.microsoft.com/office/drawing/2014/main" id="{C0A685D8-D019-97C8-192A-335F67270E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09396" y="5076201"/>
            <a:ext cx="1352934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Day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s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after allo-HSCT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17" name="Line 153">
            <a:extLst>
              <a:ext uri="{FF2B5EF4-FFF2-40B4-BE49-F238E27FC236}">
                <a16:creationId xmlns:a16="http://schemas.microsoft.com/office/drawing/2014/main" id="{5E12C99B-5F4A-3F83-EA0F-A7EF76F9AE96}"/>
              </a:ext>
            </a:extLst>
          </p:cNvPr>
          <p:cNvSpPr>
            <a:spLocks noChangeShapeType="1"/>
          </p:cNvSpPr>
          <p:nvPr/>
        </p:nvSpPr>
        <p:spPr bwMode="auto">
          <a:xfrm>
            <a:off x="1707753" y="4568290"/>
            <a:ext cx="180000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8" name="Line 154">
            <a:extLst>
              <a:ext uri="{FF2B5EF4-FFF2-40B4-BE49-F238E27FC236}">
                <a16:creationId xmlns:a16="http://schemas.microsoft.com/office/drawing/2014/main" id="{C0DC6C52-EA4A-CE6E-7DA0-7F8184B332A8}"/>
              </a:ext>
            </a:extLst>
          </p:cNvPr>
          <p:cNvSpPr>
            <a:spLocks noChangeShapeType="1"/>
          </p:cNvSpPr>
          <p:nvPr/>
        </p:nvSpPr>
        <p:spPr bwMode="auto">
          <a:xfrm>
            <a:off x="1707753" y="4702419"/>
            <a:ext cx="18000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9" name="Rectangle 339">
            <a:extLst>
              <a:ext uri="{FF2B5EF4-FFF2-40B4-BE49-F238E27FC236}">
                <a16:creationId xmlns:a16="http://schemas.microsoft.com/office/drawing/2014/main" id="{4DA53278-0253-0B86-AC6C-A03862ED65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3458" y="4498028"/>
            <a:ext cx="480901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ymphoid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0" name="Rectangle 339">
            <a:extLst>
              <a:ext uri="{FF2B5EF4-FFF2-40B4-BE49-F238E27FC236}">
                <a16:creationId xmlns:a16="http://schemas.microsoft.com/office/drawing/2014/main" id="{19053ECA-A928-C6D2-9297-E734CBC268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3458" y="4636136"/>
            <a:ext cx="391133" cy="138499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eloid</a:t>
            </a:r>
            <a:endParaRPr kumimoji="0" lang="ja-JP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50">
            <a:extLst>
              <a:ext uri="{FF2B5EF4-FFF2-40B4-BE49-F238E27FC236}">
                <a16:creationId xmlns:a16="http://schemas.microsoft.com/office/drawing/2014/main" id="{4F00DE15-A863-109E-DF4C-953D9ADCD3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48053" y="278437"/>
            <a:ext cx="668453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Neutrophil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" name="Rectangle 150">
            <a:extLst>
              <a:ext uri="{FF2B5EF4-FFF2-40B4-BE49-F238E27FC236}">
                <a16:creationId xmlns:a16="http://schemas.microsoft.com/office/drawing/2014/main" id="{72EA4A0A-C9ED-DE63-8805-2786F30BC7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77741" y="278437"/>
            <a:ext cx="464871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Platelet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" name="Rectangle 150">
            <a:extLst>
              <a:ext uri="{FF2B5EF4-FFF2-40B4-BE49-F238E27FC236}">
                <a16:creationId xmlns:a16="http://schemas.microsoft.com/office/drawing/2014/main" id="{FFDC9B0B-6C8E-51C1-4C77-17159027D4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29859" y="3155600"/>
            <a:ext cx="900889" cy="184666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Red</a:t>
            </a:r>
            <a:r>
              <a:rPr kumimoji="0" lang="ja-JP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blood</a:t>
            </a:r>
            <a:r>
              <a:rPr kumimoji="0" lang="ja-JP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cell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915" name="Line 153">
            <a:extLst>
              <a:ext uri="{FF2B5EF4-FFF2-40B4-BE49-F238E27FC236}">
                <a16:creationId xmlns:a16="http://schemas.microsoft.com/office/drawing/2014/main" id="{582AE5D1-EB68-05B4-F3AA-252C41E608B8}"/>
              </a:ext>
            </a:extLst>
          </p:cNvPr>
          <p:cNvSpPr>
            <a:spLocks noChangeShapeType="1"/>
          </p:cNvSpPr>
          <p:nvPr/>
        </p:nvSpPr>
        <p:spPr bwMode="auto">
          <a:xfrm>
            <a:off x="510067" y="2595124"/>
            <a:ext cx="180000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6" name="Line 154">
            <a:extLst>
              <a:ext uri="{FF2B5EF4-FFF2-40B4-BE49-F238E27FC236}">
                <a16:creationId xmlns:a16="http://schemas.microsoft.com/office/drawing/2014/main" id="{9ABDDA06-4380-DC10-1CD0-BCDFAC494EE2}"/>
              </a:ext>
            </a:extLst>
          </p:cNvPr>
          <p:cNvSpPr>
            <a:spLocks noChangeShapeType="1"/>
          </p:cNvSpPr>
          <p:nvPr/>
        </p:nvSpPr>
        <p:spPr bwMode="auto">
          <a:xfrm>
            <a:off x="510067" y="2729253"/>
            <a:ext cx="18000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8" name="Line 153">
            <a:extLst>
              <a:ext uri="{FF2B5EF4-FFF2-40B4-BE49-F238E27FC236}">
                <a16:creationId xmlns:a16="http://schemas.microsoft.com/office/drawing/2014/main" id="{8FC2C1C5-8099-76DA-5E71-6DB8019348AD}"/>
              </a:ext>
            </a:extLst>
          </p:cNvPr>
          <p:cNvSpPr>
            <a:spLocks noChangeShapeType="1"/>
          </p:cNvSpPr>
          <p:nvPr/>
        </p:nvSpPr>
        <p:spPr bwMode="auto">
          <a:xfrm>
            <a:off x="3927731" y="2595124"/>
            <a:ext cx="180000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9" name="Line 154">
            <a:extLst>
              <a:ext uri="{FF2B5EF4-FFF2-40B4-BE49-F238E27FC236}">
                <a16:creationId xmlns:a16="http://schemas.microsoft.com/office/drawing/2014/main" id="{8E71C735-6174-01E6-6494-E3E35D276901}"/>
              </a:ext>
            </a:extLst>
          </p:cNvPr>
          <p:cNvSpPr>
            <a:spLocks noChangeShapeType="1"/>
          </p:cNvSpPr>
          <p:nvPr/>
        </p:nvSpPr>
        <p:spPr bwMode="auto">
          <a:xfrm>
            <a:off x="3927731" y="2729253"/>
            <a:ext cx="18000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2" name="Line 153">
            <a:extLst>
              <a:ext uri="{FF2B5EF4-FFF2-40B4-BE49-F238E27FC236}">
                <a16:creationId xmlns:a16="http://schemas.microsoft.com/office/drawing/2014/main" id="{C35FA7C8-55EA-9475-BEA1-B77FA6AB4A71}"/>
              </a:ext>
            </a:extLst>
          </p:cNvPr>
          <p:cNvSpPr>
            <a:spLocks noChangeShapeType="1"/>
          </p:cNvSpPr>
          <p:nvPr/>
        </p:nvSpPr>
        <p:spPr bwMode="auto">
          <a:xfrm>
            <a:off x="510067" y="5480204"/>
            <a:ext cx="180000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3" name="Line 154">
            <a:extLst>
              <a:ext uri="{FF2B5EF4-FFF2-40B4-BE49-F238E27FC236}">
                <a16:creationId xmlns:a16="http://schemas.microsoft.com/office/drawing/2014/main" id="{32C9D350-C867-D5F3-E952-2EF0BF19311B}"/>
              </a:ext>
            </a:extLst>
          </p:cNvPr>
          <p:cNvSpPr>
            <a:spLocks noChangeShapeType="1"/>
          </p:cNvSpPr>
          <p:nvPr/>
        </p:nvSpPr>
        <p:spPr bwMode="auto">
          <a:xfrm>
            <a:off x="510067" y="5614333"/>
            <a:ext cx="180000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CAF2700-A88D-8A4E-1B8E-221A5C077FE3}"/>
              </a:ext>
            </a:extLst>
          </p:cNvPr>
          <p:cNvSpPr txBox="1"/>
          <p:nvPr/>
        </p:nvSpPr>
        <p:spPr>
          <a:xfrm>
            <a:off x="556715" y="6734260"/>
            <a:ext cx="57457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l figure 2. The cumulative incidences of neutrophil (a), platelet (b), and red blood cell (c) engraftment according to primary disease.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07935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85</TotalTime>
  <Words>367</Words>
  <Application>Microsoft Office PowerPoint</Application>
  <PresentationFormat>レター サイズ 8.5x11 インチ</PresentationFormat>
  <Paragraphs>240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rabayashi Koichi</dc:creator>
  <cp:lastModifiedBy>Koichi Hirabayashi</cp:lastModifiedBy>
  <cp:revision>515</cp:revision>
  <cp:lastPrinted>2023-06-29T02:22:11Z</cp:lastPrinted>
  <dcterms:created xsi:type="dcterms:W3CDTF">2020-05-31T13:53:24Z</dcterms:created>
  <dcterms:modified xsi:type="dcterms:W3CDTF">2024-12-09T23:46:36Z</dcterms:modified>
</cp:coreProperties>
</file>